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6" d="100"/>
          <a:sy n="86" d="100"/>
        </p:scale>
        <p:origin x="47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0002;&#22522;&#21270;--NSFC&#38738;&#22522;zj\&#30002;&#22522;&#21270;&#21457;&#34920;paper-zj\Figures%20and%20data\&#22270;2c-&#21151;&#33021;&#20803;&#20214;&#30002;&#22522;&#21270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GG-gene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gg_Gene!$A$2</c:f>
              <c:strCache>
                <c:ptCount val="1"/>
                <c:pt idx="0">
                  <c:v>E20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gg_Gene!$B$1:$CW$1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gg_Gene!$B$2:$CW$2</c:f>
              <c:numCache>
                <c:formatCode>General</c:formatCode>
                <c:ptCount val="100"/>
                <c:pt idx="0">
                  <c:v>973.17</c:v>
                </c:pt>
                <c:pt idx="1">
                  <c:v>1485.35</c:v>
                </c:pt>
                <c:pt idx="2">
                  <c:v>1350.74</c:v>
                </c:pt>
                <c:pt idx="3">
                  <c:v>1218.55</c:v>
                </c:pt>
                <c:pt idx="4">
                  <c:v>1657.23</c:v>
                </c:pt>
                <c:pt idx="5">
                  <c:v>1323.41</c:v>
                </c:pt>
                <c:pt idx="6">
                  <c:v>1467.16</c:v>
                </c:pt>
                <c:pt idx="7">
                  <c:v>1569.58</c:v>
                </c:pt>
                <c:pt idx="8">
                  <c:v>1200.71</c:v>
                </c:pt>
                <c:pt idx="9">
                  <c:v>1817.07</c:v>
                </c:pt>
                <c:pt idx="10">
                  <c:v>1736.81</c:v>
                </c:pt>
                <c:pt idx="11">
                  <c:v>1644.6</c:v>
                </c:pt>
                <c:pt idx="12">
                  <c:v>2217.42</c:v>
                </c:pt>
                <c:pt idx="13">
                  <c:v>1743.8</c:v>
                </c:pt>
                <c:pt idx="14">
                  <c:v>2023.54</c:v>
                </c:pt>
                <c:pt idx="15">
                  <c:v>1967.8</c:v>
                </c:pt>
                <c:pt idx="16">
                  <c:v>2153.33</c:v>
                </c:pt>
                <c:pt idx="17">
                  <c:v>2049.9</c:v>
                </c:pt>
                <c:pt idx="18">
                  <c:v>2293.9699999999998</c:v>
                </c:pt>
                <c:pt idx="19">
                  <c:v>2317.6999999999998</c:v>
                </c:pt>
                <c:pt idx="20">
                  <c:v>2021.54</c:v>
                </c:pt>
                <c:pt idx="21">
                  <c:v>2339.79</c:v>
                </c:pt>
                <c:pt idx="22">
                  <c:v>2633.34</c:v>
                </c:pt>
                <c:pt idx="23">
                  <c:v>2450.9299999999998</c:v>
                </c:pt>
                <c:pt idx="24">
                  <c:v>2178.14</c:v>
                </c:pt>
                <c:pt idx="25">
                  <c:v>2216.08</c:v>
                </c:pt>
                <c:pt idx="26">
                  <c:v>2291.44</c:v>
                </c:pt>
                <c:pt idx="27">
                  <c:v>2301.96</c:v>
                </c:pt>
                <c:pt idx="28">
                  <c:v>2149.7800000000002</c:v>
                </c:pt>
                <c:pt idx="29">
                  <c:v>4240.22</c:v>
                </c:pt>
                <c:pt idx="30">
                  <c:v>2769.69</c:v>
                </c:pt>
                <c:pt idx="31">
                  <c:v>2327.5</c:v>
                </c:pt>
                <c:pt idx="32">
                  <c:v>2541.0700000000002</c:v>
                </c:pt>
                <c:pt idx="33">
                  <c:v>3086.99</c:v>
                </c:pt>
                <c:pt idx="34">
                  <c:v>2970.59</c:v>
                </c:pt>
                <c:pt idx="35">
                  <c:v>2711.82</c:v>
                </c:pt>
                <c:pt idx="36">
                  <c:v>2196.1</c:v>
                </c:pt>
                <c:pt idx="37">
                  <c:v>2782.97</c:v>
                </c:pt>
                <c:pt idx="38">
                  <c:v>2868.64</c:v>
                </c:pt>
                <c:pt idx="39">
                  <c:v>2738.81</c:v>
                </c:pt>
                <c:pt idx="40">
                  <c:v>2748.62</c:v>
                </c:pt>
                <c:pt idx="41">
                  <c:v>2394.9299999999998</c:v>
                </c:pt>
                <c:pt idx="42">
                  <c:v>2337.04</c:v>
                </c:pt>
                <c:pt idx="43">
                  <c:v>2654.32</c:v>
                </c:pt>
                <c:pt idx="44">
                  <c:v>2386.0500000000002</c:v>
                </c:pt>
                <c:pt idx="45">
                  <c:v>2920.85</c:v>
                </c:pt>
                <c:pt idx="46">
                  <c:v>3231.41</c:v>
                </c:pt>
                <c:pt idx="47">
                  <c:v>2825.15</c:v>
                </c:pt>
                <c:pt idx="48">
                  <c:v>2673.74</c:v>
                </c:pt>
                <c:pt idx="49">
                  <c:v>2637.12</c:v>
                </c:pt>
                <c:pt idx="50">
                  <c:v>2611.17</c:v>
                </c:pt>
                <c:pt idx="51">
                  <c:v>2720.69</c:v>
                </c:pt>
                <c:pt idx="52">
                  <c:v>3012.01</c:v>
                </c:pt>
                <c:pt idx="53">
                  <c:v>2979.74</c:v>
                </c:pt>
                <c:pt idx="54">
                  <c:v>2571.9299999999998</c:v>
                </c:pt>
                <c:pt idx="55">
                  <c:v>3124.22</c:v>
                </c:pt>
                <c:pt idx="56">
                  <c:v>2557.58</c:v>
                </c:pt>
                <c:pt idx="57">
                  <c:v>2477.3000000000002</c:v>
                </c:pt>
                <c:pt idx="58">
                  <c:v>2837.3</c:v>
                </c:pt>
                <c:pt idx="59">
                  <c:v>2545.61</c:v>
                </c:pt>
                <c:pt idx="60">
                  <c:v>2963.88</c:v>
                </c:pt>
                <c:pt idx="61">
                  <c:v>2938.62</c:v>
                </c:pt>
                <c:pt idx="62">
                  <c:v>2925.32</c:v>
                </c:pt>
                <c:pt idx="63">
                  <c:v>3282.28</c:v>
                </c:pt>
                <c:pt idx="64">
                  <c:v>2464.6799999999998</c:v>
                </c:pt>
                <c:pt idx="65">
                  <c:v>3031.89</c:v>
                </c:pt>
                <c:pt idx="66">
                  <c:v>2642.04</c:v>
                </c:pt>
                <c:pt idx="67">
                  <c:v>3080.28</c:v>
                </c:pt>
                <c:pt idx="68">
                  <c:v>3065.59</c:v>
                </c:pt>
                <c:pt idx="69">
                  <c:v>2907.87</c:v>
                </c:pt>
                <c:pt idx="70">
                  <c:v>3092.88</c:v>
                </c:pt>
                <c:pt idx="71">
                  <c:v>2780.12</c:v>
                </c:pt>
                <c:pt idx="72">
                  <c:v>2671.79</c:v>
                </c:pt>
                <c:pt idx="73">
                  <c:v>3301.51</c:v>
                </c:pt>
                <c:pt idx="74">
                  <c:v>2968.8</c:v>
                </c:pt>
                <c:pt idx="75">
                  <c:v>3253.42</c:v>
                </c:pt>
                <c:pt idx="76">
                  <c:v>3416.52</c:v>
                </c:pt>
                <c:pt idx="77">
                  <c:v>3028.76</c:v>
                </c:pt>
                <c:pt idx="78">
                  <c:v>3468.77</c:v>
                </c:pt>
                <c:pt idx="79">
                  <c:v>2842.87</c:v>
                </c:pt>
                <c:pt idx="80">
                  <c:v>3115.67</c:v>
                </c:pt>
                <c:pt idx="81">
                  <c:v>3457.22</c:v>
                </c:pt>
                <c:pt idx="82">
                  <c:v>3137.13</c:v>
                </c:pt>
                <c:pt idx="83">
                  <c:v>3048.49</c:v>
                </c:pt>
                <c:pt idx="84">
                  <c:v>3195.31</c:v>
                </c:pt>
                <c:pt idx="85">
                  <c:v>2988.72</c:v>
                </c:pt>
                <c:pt idx="86">
                  <c:v>2995.0599999999899</c:v>
                </c:pt>
                <c:pt idx="87">
                  <c:v>2560.35</c:v>
                </c:pt>
                <c:pt idx="88">
                  <c:v>3097.85</c:v>
                </c:pt>
                <c:pt idx="89">
                  <c:v>3035.06</c:v>
                </c:pt>
                <c:pt idx="90">
                  <c:v>3171.49</c:v>
                </c:pt>
                <c:pt idx="91">
                  <c:v>3277.96</c:v>
                </c:pt>
                <c:pt idx="92">
                  <c:v>2911.98</c:v>
                </c:pt>
                <c:pt idx="93">
                  <c:v>2573.9699999999998</c:v>
                </c:pt>
                <c:pt idx="94">
                  <c:v>2626.96</c:v>
                </c:pt>
                <c:pt idx="95">
                  <c:v>2271.0300000000002</c:v>
                </c:pt>
                <c:pt idx="96">
                  <c:v>2043.14</c:v>
                </c:pt>
                <c:pt idx="97">
                  <c:v>1681.06</c:v>
                </c:pt>
                <c:pt idx="98">
                  <c:v>1609.18</c:v>
                </c:pt>
                <c:pt idx="99">
                  <c:v>1369.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94D-4444-A83D-04D598A2A5A3}"/>
            </c:ext>
          </c:extLst>
        </c:ser>
        <c:ser>
          <c:idx val="1"/>
          <c:order val="1"/>
          <c:tx>
            <c:strRef>
              <c:f>ccgg_Gene!$A$3</c:f>
              <c:strCache>
                <c:ptCount val="1"/>
                <c:pt idx="0">
                  <c:v>E20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gg_Gene!$B$1:$CW$1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gg_Gene!$B$3:$CW$3</c:f>
              <c:numCache>
                <c:formatCode>General</c:formatCode>
                <c:ptCount val="100"/>
                <c:pt idx="0">
                  <c:v>908.75</c:v>
                </c:pt>
                <c:pt idx="1">
                  <c:v>1510.83</c:v>
                </c:pt>
                <c:pt idx="2">
                  <c:v>1277.04</c:v>
                </c:pt>
                <c:pt idx="3">
                  <c:v>1131.8399999999999</c:v>
                </c:pt>
                <c:pt idx="4">
                  <c:v>1667.97</c:v>
                </c:pt>
                <c:pt idx="5">
                  <c:v>1298.51</c:v>
                </c:pt>
                <c:pt idx="6">
                  <c:v>1482.32</c:v>
                </c:pt>
                <c:pt idx="7">
                  <c:v>1607.61</c:v>
                </c:pt>
                <c:pt idx="8">
                  <c:v>1174.77</c:v>
                </c:pt>
                <c:pt idx="9">
                  <c:v>1631.62</c:v>
                </c:pt>
                <c:pt idx="10">
                  <c:v>1675.42</c:v>
                </c:pt>
                <c:pt idx="11">
                  <c:v>1572.3</c:v>
                </c:pt>
                <c:pt idx="12">
                  <c:v>2130.42</c:v>
                </c:pt>
                <c:pt idx="13">
                  <c:v>1602.01</c:v>
                </c:pt>
                <c:pt idx="14">
                  <c:v>1941.74</c:v>
                </c:pt>
                <c:pt idx="15">
                  <c:v>1813.2</c:v>
                </c:pt>
                <c:pt idx="16">
                  <c:v>2128.19</c:v>
                </c:pt>
                <c:pt idx="17">
                  <c:v>2014.35</c:v>
                </c:pt>
                <c:pt idx="18">
                  <c:v>2165.54</c:v>
                </c:pt>
                <c:pt idx="19">
                  <c:v>2255.21</c:v>
                </c:pt>
                <c:pt idx="20">
                  <c:v>1963.71</c:v>
                </c:pt>
                <c:pt idx="21">
                  <c:v>2224.89</c:v>
                </c:pt>
                <c:pt idx="22">
                  <c:v>2547.9899999999998</c:v>
                </c:pt>
                <c:pt idx="23">
                  <c:v>2335.5699999999902</c:v>
                </c:pt>
                <c:pt idx="24">
                  <c:v>2027.38</c:v>
                </c:pt>
                <c:pt idx="25">
                  <c:v>2257.79</c:v>
                </c:pt>
                <c:pt idx="26">
                  <c:v>2306.41</c:v>
                </c:pt>
                <c:pt idx="27">
                  <c:v>2226.66</c:v>
                </c:pt>
                <c:pt idx="28">
                  <c:v>2024.06</c:v>
                </c:pt>
                <c:pt idx="29">
                  <c:v>3687.9899999999898</c:v>
                </c:pt>
                <c:pt idx="30">
                  <c:v>2576.45999999999</c:v>
                </c:pt>
                <c:pt idx="31">
                  <c:v>2245.96</c:v>
                </c:pt>
                <c:pt idx="32">
                  <c:v>2396.42</c:v>
                </c:pt>
                <c:pt idx="33">
                  <c:v>2975.49999999999</c:v>
                </c:pt>
                <c:pt idx="34">
                  <c:v>2941.8499999999899</c:v>
                </c:pt>
                <c:pt idx="35">
                  <c:v>2611.2800000000002</c:v>
                </c:pt>
                <c:pt idx="36">
                  <c:v>2198.5700000000002</c:v>
                </c:pt>
                <c:pt idx="37">
                  <c:v>2713.89</c:v>
                </c:pt>
                <c:pt idx="38">
                  <c:v>2808.0099999999902</c:v>
                </c:pt>
                <c:pt idx="39">
                  <c:v>2588.74999999999</c:v>
                </c:pt>
                <c:pt idx="40">
                  <c:v>2714.23</c:v>
                </c:pt>
                <c:pt idx="41">
                  <c:v>2466.8099999999899</c:v>
                </c:pt>
                <c:pt idx="42">
                  <c:v>2347.4299999999998</c:v>
                </c:pt>
                <c:pt idx="43">
                  <c:v>2549.09</c:v>
                </c:pt>
                <c:pt idx="44">
                  <c:v>2204.7399999999998</c:v>
                </c:pt>
                <c:pt idx="45">
                  <c:v>2704.28</c:v>
                </c:pt>
                <c:pt idx="46">
                  <c:v>3225.23</c:v>
                </c:pt>
                <c:pt idx="47">
                  <c:v>2813.94</c:v>
                </c:pt>
                <c:pt idx="48">
                  <c:v>2571.62</c:v>
                </c:pt>
                <c:pt idx="49">
                  <c:v>2561.8899999999899</c:v>
                </c:pt>
                <c:pt idx="50">
                  <c:v>2450.0999999999899</c:v>
                </c:pt>
                <c:pt idx="51">
                  <c:v>2552.6999999999998</c:v>
                </c:pt>
                <c:pt idx="52">
                  <c:v>2871.87</c:v>
                </c:pt>
                <c:pt idx="53">
                  <c:v>2801.72</c:v>
                </c:pt>
                <c:pt idx="54">
                  <c:v>2330.09</c:v>
                </c:pt>
                <c:pt idx="55">
                  <c:v>2848.0999999999899</c:v>
                </c:pt>
                <c:pt idx="56">
                  <c:v>2458.98</c:v>
                </c:pt>
                <c:pt idx="57">
                  <c:v>2361.95999999999</c:v>
                </c:pt>
                <c:pt idx="58">
                  <c:v>2672.04</c:v>
                </c:pt>
                <c:pt idx="59">
                  <c:v>2583.8599999999901</c:v>
                </c:pt>
                <c:pt idx="60">
                  <c:v>2973.99999999999</c:v>
                </c:pt>
                <c:pt idx="61">
                  <c:v>2949</c:v>
                </c:pt>
                <c:pt idx="62">
                  <c:v>2719.87</c:v>
                </c:pt>
                <c:pt idx="63">
                  <c:v>3198.8899999999899</c:v>
                </c:pt>
                <c:pt idx="64">
                  <c:v>2300.83</c:v>
                </c:pt>
                <c:pt idx="65">
                  <c:v>2973.26</c:v>
                </c:pt>
                <c:pt idx="66">
                  <c:v>2487.16</c:v>
                </c:pt>
                <c:pt idx="67">
                  <c:v>3151.13</c:v>
                </c:pt>
                <c:pt idx="68">
                  <c:v>3049.64</c:v>
                </c:pt>
                <c:pt idx="69">
                  <c:v>2888.78</c:v>
                </c:pt>
                <c:pt idx="70">
                  <c:v>2877.95</c:v>
                </c:pt>
                <c:pt idx="71">
                  <c:v>2595.35</c:v>
                </c:pt>
                <c:pt idx="72">
                  <c:v>2617.6599999999899</c:v>
                </c:pt>
                <c:pt idx="73">
                  <c:v>3496.7799999999902</c:v>
                </c:pt>
                <c:pt idx="74">
                  <c:v>2789.1699999999901</c:v>
                </c:pt>
                <c:pt idx="75">
                  <c:v>3068.71</c:v>
                </c:pt>
                <c:pt idx="76">
                  <c:v>3442.28999999999</c:v>
                </c:pt>
                <c:pt idx="77">
                  <c:v>2943.6799999999898</c:v>
                </c:pt>
                <c:pt idx="78">
                  <c:v>3278.97999999999</c:v>
                </c:pt>
                <c:pt idx="79">
                  <c:v>2697.53999999999</c:v>
                </c:pt>
                <c:pt idx="80">
                  <c:v>3012.9699999999898</c:v>
                </c:pt>
                <c:pt idx="81">
                  <c:v>3486.0799999999899</c:v>
                </c:pt>
                <c:pt idx="82">
                  <c:v>3150.68</c:v>
                </c:pt>
                <c:pt idx="83">
                  <c:v>2847.2999999999902</c:v>
                </c:pt>
                <c:pt idx="84">
                  <c:v>2955.15</c:v>
                </c:pt>
                <c:pt idx="85">
                  <c:v>2755.0699999999902</c:v>
                </c:pt>
                <c:pt idx="86">
                  <c:v>2911.76999999999</c:v>
                </c:pt>
                <c:pt idx="87">
                  <c:v>2430.7600000000002</c:v>
                </c:pt>
                <c:pt idx="88">
                  <c:v>3065.4499999999898</c:v>
                </c:pt>
                <c:pt idx="89">
                  <c:v>2853.5799999999899</c:v>
                </c:pt>
                <c:pt idx="90">
                  <c:v>3142.26</c:v>
                </c:pt>
                <c:pt idx="91">
                  <c:v>3152.59</c:v>
                </c:pt>
                <c:pt idx="92">
                  <c:v>2723.61</c:v>
                </c:pt>
                <c:pt idx="93">
                  <c:v>2427.4699999999998</c:v>
                </c:pt>
                <c:pt idx="94">
                  <c:v>2598.2999999999902</c:v>
                </c:pt>
                <c:pt idx="95">
                  <c:v>2327.7599999999902</c:v>
                </c:pt>
                <c:pt idx="96">
                  <c:v>1942.46</c:v>
                </c:pt>
                <c:pt idx="97">
                  <c:v>1561.99</c:v>
                </c:pt>
                <c:pt idx="98">
                  <c:v>1535.63</c:v>
                </c:pt>
                <c:pt idx="99">
                  <c:v>1271.85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94D-4444-A83D-04D598A2A5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41205576"/>
        <c:axId val="541209512"/>
      </c:lineChart>
      <c:catAx>
        <c:axId val="541205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41209512"/>
        <c:crosses val="autoZero"/>
        <c:auto val="1"/>
        <c:lblAlgn val="ctr"/>
        <c:lblOffset val="100"/>
        <c:tickMarkSkip val="1"/>
        <c:noMultiLvlLbl val="0"/>
      </c:catAx>
      <c:valAx>
        <c:axId val="541209512"/>
        <c:scaling>
          <c:orientation val="minMax"/>
          <c:max val="7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41205576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r"/>
      <c:layout>
        <c:manualLayout>
          <c:xMode val="edge"/>
          <c:yMode val="edge"/>
          <c:x val="0.54551187198833784"/>
          <c:y val="0.19033413087926176"/>
          <c:w val="0.40912181502003608"/>
          <c:h val="9.1128161693276574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WGG-TSS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wgg_TSS!$A$5</c:f>
              <c:strCache>
                <c:ptCount val="1"/>
                <c:pt idx="0">
                  <c:v>E26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wgg_TSS!$B$4:$CW$4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SS!$B$5:$CW$5</c:f>
              <c:numCache>
                <c:formatCode>General</c:formatCode>
                <c:ptCount val="100"/>
                <c:pt idx="0">
                  <c:v>579.17999999999995</c:v>
                </c:pt>
                <c:pt idx="1">
                  <c:v>1344.24</c:v>
                </c:pt>
                <c:pt idx="2">
                  <c:v>1293.82</c:v>
                </c:pt>
                <c:pt idx="3">
                  <c:v>1292.06</c:v>
                </c:pt>
                <c:pt idx="4">
                  <c:v>1161.75</c:v>
                </c:pt>
                <c:pt idx="5">
                  <c:v>1614.49</c:v>
                </c:pt>
                <c:pt idx="6">
                  <c:v>1289.0999999999999</c:v>
                </c:pt>
                <c:pt idx="7">
                  <c:v>1240.82</c:v>
                </c:pt>
                <c:pt idx="8">
                  <c:v>1347.59</c:v>
                </c:pt>
                <c:pt idx="9">
                  <c:v>1192.01</c:v>
                </c:pt>
                <c:pt idx="10">
                  <c:v>1274.06</c:v>
                </c:pt>
                <c:pt idx="11">
                  <c:v>1861.22</c:v>
                </c:pt>
                <c:pt idx="12">
                  <c:v>1244.58</c:v>
                </c:pt>
                <c:pt idx="13">
                  <c:v>1180.73</c:v>
                </c:pt>
                <c:pt idx="14">
                  <c:v>908.68999999999903</c:v>
                </c:pt>
                <c:pt idx="15">
                  <c:v>1395.92</c:v>
                </c:pt>
                <c:pt idx="16">
                  <c:v>1141.1600000000001</c:v>
                </c:pt>
                <c:pt idx="17">
                  <c:v>1141.5999999999999</c:v>
                </c:pt>
                <c:pt idx="18">
                  <c:v>1381.63</c:v>
                </c:pt>
                <c:pt idx="19">
                  <c:v>1203.3699999999999</c:v>
                </c:pt>
                <c:pt idx="20">
                  <c:v>1126.03</c:v>
                </c:pt>
                <c:pt idx="21">
                  <c:v>1173.8900000000001</c:v>
                </c:pt>
                <c:pt idx="22">
                  <c:v>988.16999999999905</c:v>
                </c:pt>
                <c:pt idx="23">
                  <c:v>1255.1300000000001</c:v>
                </c:pt>
                <c:pt idx="24">
                  <c:v>1455.66</c:v>
                </c:pt>
                <c:pt idx="25">
                  <c:v>1242.05</c:v>
                </c:pt>
                <c:pt idx="26">
                  <c:v>1518.34</c:v>
                </c:pt>
                <c:pt idx="27">
                  <c:v>1117.6099999999999</c:v>
                </c:pt>
                <c:pt idx="28">
                  <c:v>1213.8800000000001</c:v>
                </c:pt>
                <c:pt idx="29">
                  <c:v>1139.0899999999999</c:v>
                </c:pt>
                <c:pt idx="30">
                  <c:v>1458.06</c:v>
                </c:pt>
                <c:pt idx="31">
                  <c:v>1312.68</c:v>
                </c:pt>
                <c:pt idx="32">
                  <c:v>1243.74</c:v>
                </c:pt>
                <c:pt idx="33">
                  <c:v>1336.27</c:v>
                </c:pt>
                <c:pt idx="34">
                  <c:v>1230.7</c:v>
                </c:pt>
                <c:pt idx="35">
                  <c:v>1128.96</c:v>
                </c:pt>
                <c:pt idx="36">
                  <c:v>1145.3699999999999</c:v>
                </c:pt>
                <c:pt idx="37">
                  <c:v>1369.87</c:v>
                </c:pt>
                <c:pt idx="38">
                  <c:v>1306.33</c:v>
                </c:pt>
                <c:pt idx="39">
                  <c:v>1276.04</c:v>
                </c:pt>
                <c:pt idx="40">
                  <c:v>1231.0999999999999</c:v>
                </c:pt>
                <c:pt idx="41">
                  <c:v>868.36</c:v>
                </c:pt>
                <c:pt idx="42">
                  <c:v>1484.62</c:v>
                </c:pt>
                <c:pt idx="43">
                  <c:v>1185.72</c:v>
                </c:pt>
                <c:pt idx="44">
                  <c:v>1574.11</c:v>
                </c:pt>
                <c:pt idx="45">
                  <c:v>1284.1099999999999</c:v>
                </c:pt>
                <c:pt idx="46">
                  <c:v>1396.28</c:v>
                </c:pt>
                <c:pt idx="47">
                  <c:v>1314.75</c:v>
                </c:pt>
                <c:pt idx="48">
                  <c:v>1281.1400000000001</c:v>
                </c:pt>
                <c:pt idx="49">
                  <c:v>1222.3399999999999</c:v>
                </c:pt>
                <c:pt idx="50">
                  <c:v>1705.71</c:v>
                </c:pt>
                <c:pt idx="51">
                  <c:v>2432.08</c:v>
                </c:pt>
                <c:pt idx="52">
                  <c:v>2385.79</c:v>
                </c:pt>
                <c:pt idx="53">
                  <c:v>2084.81</c:v>
                </c:pt>
                <c:pt idx="54">
                  <c:v>2063.77</c:v>
                </c:pt>
                <c:pt idx="55">
                  <c:v>1830.93</c:v>
                </c:pt>
                <c:pt idx="56">
                  <c:v>1751.54</c:v>
                </c:pt>
                <c:pt idx="57">
                  <c:v>1446.31</c:v>
                </c:pt>
                <c:pt idx="58">
                  <c:v>1930.17</c:v>
                </c:pt>
                <c:pt idx="59">
                  <c:v>1904.07</c:v>
                </c:pt>
                <c:pt idx="60">
                  <c:v>1936.45</c:v>
                </c:pt>
                <c:pt idx="61">
                  <c:v>1389.14</c:v>
                </c:pt>
                <c:pt idx="62">
                  <c:v>1483.73</c:v>
                </c:pt>
                <c:pt idx="63">
                  <c:v>1346.32</c:v>
                </c:pt>
                <c:pt idx="64">
                  <c:v>1492.96</c:v>
                </c:pt>
                <c:pt idx="65">
                  <c:v>1636.32</c:v>
                </c:pt>
                <c:pt idx="66">
                  <c:v>1693.91</c:v>
                </c:pt>
                <c:pt idx="67">
                  <c:v>1519.04</c:v>
                </c:pt>
                <c:pt idx="68">
                  <c:v>1587.15</c:v>
                </c:pt>
                <c:pt idx="69">
                  <c:v>1338.74</c:v>
                </c:pt>
                <c:pt idx="70">
                  <c:v>1730.5</c:v>
                </c:pt>
                <c:pt idx="71">
                  <c:v>1519.11</c:v>
                </c:pt>
                <c:pt idx="72">
                  <c:v>1714.09</c:v>
                </c:pt>
                <c:pt idx="73">
                  <c:v>1407.68</c:v>
                </c:pt>
                <c:pt idx="74">
                  <c:v>1593.81</c:v>
                </c:pt>
                <c:pt idx="75">
                  <c:v>1216.8</c:v>
                </c:pt>
                <c:pt idx="76">
                  <c:v>1509.83</c:v>
                </c:pt>
                <c:pt idx="77">
                  <c:v>1427.77</c:v>
                </c:pt>
                <c:pt idx="78">
                  <c:v>1282.4000000000001</c:v>
                </c:pt>
                <c:pt idx="79">
                  <c:v>1663.59</c:v>
                </c:pt>
                <c:pt idx="80">
                  <c:v>1615.27</c:v>
                </c:pt>
                <c:pt idx="81">
                  <c:v>1284.05</c:v>
                </c:pt>
                <c:pt idx="82">
                  <c:v>1851.91</c:v>
                </c:pt>
                <c:pt idx="83">
                  <c:v>1576.2</c:v>
                </c:pt>
                <c:pt idx="84">
                  <c:v>1451.36</c:v>
                </c:pt>
                <c:pt idx="85">
                  <c:v>1171.45</c:v>
                </c:pt>
                <c:pt idx="86">
                  <c:v>1432.01</c:v>
                </c:pt>
                <c:pt idx="87">
                  <c:v>1280.6500000000001</c:v>
                </c:pt>
                <c:pt idx="88">
                  <c:v>1260.06</c:v>
                </c:pt>
                <c:pt idx="89">
                  <c:v>1363.07</c:v>
                </c:pt>
                <c:pt idx="90">
                  <c:v>1434.6</c:v>
                </c:pt>
                <c:pt idx="91">
                  <c:v>1248.74</c:v>
                </c:pt>
                <c:pt idx="92">
                  <c:v>1530.32</c:v>
                </c:pt>
                <c:pt idx="93">
                  <c:v>1367.73</c:v>
                </c:pt>
                <c:pt idx="94">
                  <c:v>1458.96</c:v>
                </c:pt>
                <c:pt idx="95">
                  <c:v>1517.8</c:v>
                </c:pt>
                <c:pt idx="96">
                  <c:v>1181.94</c:v>
                </c:pt>
                <c:pt idx="97">
                  <c:v>1526.63</c:v>
                </c:pt>
                <c:pt idx="98">
                  <c:v>1067.6099999999999</c:v>
                </c:pt>
                <c:pt idx="99">
                  <c:v>1679.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71E-41B5-9FCF-500F5DEBF0B7}"/>
            </c:ext>
          </c:extLst>
        </c:ser>
        <c:ser>
          <c:idx val="1"/>
          <c:order val="1"/>
          <c:tx>
            <c:strRef>
              <c:f>ccwgg_TSS!$A$6</c:f>
              <c:strCache>
                <c:ptCount val="1"/>
                <c:pt idx="0">
                  <c:v>E26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wgg_TSS!$B$4:$CW$4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SS!$B$6:$CW$6</c:f>
              <c:numCache>
                <c:formatCode>General</c:formatCode>
                <c:ptCount val="100"/>
                <c:pt idx="0">
                  <c:v>527.32000000000005</c:v>
                </c:pt>
                <c:pt idx="1">
                  <c:v>1300.3</c:v>
                </c:pt>
                <c:pt idx="2">
                  <c:v>1291.0999999999999</c:v>
                </c:pt>
                <c:pt idx="3">
                  <c:v>1371.58</c:v>
                </c:pt>
                <c:pt idx="4">
                  <c:v>1117.95</c:v>
                </c:pt>
                <c:pt idx="5">
                  <c:v>1716.97</c:v>
                </c:pt>
                <c:pt idx="6">
                  <c:v>1285.28</c:v>
                </c:pt>
                <c:pt idx="7">
                  <c:v>1315.71</c:v>
                </c:pt>
                <c:pt idx="8">
                  <c:v>1292.77</c:v>
                </c:pt>
                <c:pt idx="9">
                  <c:v>1255.6600000000001</c:v>
                </c:pt>
                <c:pt idx="10">
                  <c:v>1214.3399999999999</c:v>
                </c:pt>
                <c:pt idx="11">
                  <c:v>1801.71</c:v>
                </c:pt>
                <c:pt idx="12">
                  <c:v>1252.71</c:v>
                </c:pt>
                <c:pt idx="13">
                  <c:v>1173.8399999999999</c:v>
                </c:pt>
                <c:pt idx="14">
                  <c:v>903.08999999999901</c:v>
                </c:pt>
                <c:pt idx="15">
                  <c:v>1398.33</c:v>
                </c:pt>
                <c:pt idx="16">
                  <c:v>1224.3800000000001</c:v>
                </c:pt>
                <c:pt idx="17">
                  <c:v>1105.8399999999999</c:v>
                </c:pt>
                <c:pt idx="18">
                  <c:v>1419.17</c:v>
                </c:pt>
                <c:pt idx="19">
                  <c:v>1159.27</c:v>
                </c:pt>
                <c:pt idx="20">
                  <c:v>1130.48</c:v>
                </c:pt>
                <c:pt idx="21">
                  <c:v>1151.7</c:v>
                </c:pt>
                <c:pt idx="22">
                  <c:v>986.95</c:v>
                </c:pt>
                <c:pt idx="23">
                  <c:v>1228.02</c:v>
                </c:pt>
                <c:pt idx="24">
                  <c:v>1384.56</c:v>
                </c:pt>
                <c:pt idx="25">
                  <c:v>1211.48</c:v>
                </c:pt>
                <c:pt idx="26">
                  <c:v>1539.68</c:v>
                </c:pt>
                <c:pt idx="27">
                  <c:v>1082.06</c:v>
                </c:pt>
                <c:pt idx="28">
                  <c:v>1228.93</c:v>
                </c:pt>
                <c:pt idx="29">
                  <c:v>1137.97</c:v>
                </c:pt>
                <c:pt idx="30">
                  <c:v>1445.88</c:v>
                </c:pt>
                <c:pt idx="31">
                  <c:v>1251.3900000000001</c:v>
                </c:pt>
                <c:pt idx="32">
                  <c:v>1192.17</c:v>
                </c:pt>
                <c:pt idx="33">
                  <c:v>1288.99</c:v>
                </c:pt>
                <c:pt idx="34">
                  <c:v>1203.92</c:v>
                </c:pt>
                <c:pt idx="35">
                  <c:v>1108.3399999999999</c:v>
                </c:pt>
                <c:pt idx="36">
                  <c:v>1091.6600000000001</c:v>
                </c:pt>
                <c:pt idx="37">
                  <c:v>1318.58</c:v>
                </c:pt>
                <c:pt idx="38">
                  <c:v>1251.42</c:v>
                </c:pt>
                <c:pt idx="39">
                  <c:v>1339.1</c:v>
                </c:pt>
                <c:pt idx="40">
                  <c:v>1208.9100000000001</c:v>
                </c:pt>
                <c:pt idx="41">
                  <c:v>911.9</c:v>
                </c:pt>
                <c:pt idx="42">
                  <c:v>1483.79</c:v>
                </c:pt>
                <c:pt idx="43">
                  <c:v>1180.97</c:v>
                </c:pt>
                <c:pt idx="44">
                  <c:v>1561</c:v>
                </c:pt>
                <c:pt idx="45">
                  <c:v>1248.1199999999999</c:v>
                </c:pt>
                <c:pt idx="46">
                  <c:v>1374.89</c:v>
                </c:pt>
                <c:pt idx="47">
                  <c:v>1290.67</c:v>
                </c:pt>
                <c:pt idx="48">
                  <c:v>1292.71</c:v>
                </c:pt>
                <c:pt idx="49">
                  <c:v>1187.67</c:v>
                </c:pt>
                <c:pt idx="50">
                  <c:v>1737.83</c:v>
                </c:pt>
                <c:pt idx="51">
                  <c:v>2509.66</c:v>
                </c:pt>
                <c:pt idx="52">
                  <c:v>2381.13</c:v>
                </c:pt>
                <c:pt idx="53">
                  <c:v>2203</c:v>
                </c:pt>
                <c:pt idx="54">
                  <c:v>2039.95</c:v>
                </c:pt>
                <c:pt idx="55">
                  <c:v>1835.43</c:v>
                </c:pt>
                <c:pt idx="56">
                  <c:v>1598.59</c:v>
                </c:pt>
                <c:pt idx="57">
                  <c:v>1474.69</c:v>
                </c:pt>
                <c:pt idx="58">
                  <c:v>1887.23</c:v>
                </c:pt>
                <c:pt idx="59">
                  <c:v>1868.09</c:v>
                </c:pt>
                <c:pt idx="60">
                  <c:v>1937.23</c:v>
                </c:pt>
                <c:pt idx="61">
                  <c:v>1359.15</c:v>
                </c:pt>
                <c:pt idx="62">
                  <c:v>1487.2</c:v>
                </c:pt>
                <c:pt idx="63">
                  <c:v>1326.58</c:v>
                </c:pt>
                <c:pt idx="64">
                  <c:v>1505.57</c:v>
                </c:pt>
                <c:pt idx="65">
                  <c:v>1679.94</c:v>
                </c:pt>
                <c:pt idx="66">
                  <c:v>1665.65</c:v>
                </c:pt>
                <c:pt idx="67">
                  <c:v>1565.14</c:v>
                </c:pt>
                <c:pt idx="68">
                  <c:v>1651.58</c:v>
                </c:pt>
                <c:pt idx="69">
                  <c:v>1280.28</c:v>
                </c:pt>
                <c:pt idx="70">
                  <c:v>1666.59</c:v>
                </c:pt>
                <c:pt idx="71">
                  <c:v>1441.21</c:v>
                </c:pt>
                <c:pt idx="72">
                  <c:v>1623.18</c:v>
                </c:pt>
                <c:pt idx="73">
                  <c:v>1466.32</c:v>
                </c:pt>
                <c:pt idx="74">
                  <c:v>1574.82</c:v>
                </c:pt>
                <c:pt idx="75">
                  <c:v>1170.54</c:v>
                </c:pt>
                <c:pt idx="76">
                  <c:v>1486.72</c:v>
                </c:pt>
                <c:pt idx="77">
                  <c:v>1385.77</c:v>
                </c:pt>
                <c:pt idx="78">
                  <c:v>1313.62</c:v>
                </c:pt>
                <c:pt idx="79">
                  <c:v>1719.46</c:v>
                </c:pt>
                <c:pt idx="80">
                  <c:v>1588.57</c:v>
                </c:pt>
                <c:pt idx="81">
                  <c:v>1229.8</c:v>
                </c:pt>
                <c:pt idx="82">
                  <c:v>1857.55</c:v>
                </c:pt>
                <c:pt idx="83">
                  <c:v>1534.73</c:v>
                </c:pt>
                <c:pt idx="84">
                  <c:v>1402.89</c:v>
                </c:pt>
                <c:pt idx="85">
                  <c:v>1145.94</c:v>
                </c:pt>
                <c:pt idx="86">
                  <c:v>1470.94</c:v>
                </c:pt>
                <c:pt idx="87">
                  <c:v>1186.83</c:v>
                </c:pt>
                <c:pt idx="88">
                  <c:v>1301.1199999999999</c:v>
                </c:pt>
                <c:pt idx="89">
                  <c:v>1428.33</c:v>
                </c:pt>
                <c:pt idx="90">
                  <c:v>1413.35</c:v>
                </c:pt>
                <c:pt idx="91">
                  <c:v>1240.6500000000001</c:v>
                </c:pt>
                <c:pt idx="92">
                  <c:v>1521.78</c:v>
                </c:pt>
                <c:pt idx="93">
                  <c:v>1385.38</c:v>
                </c:pt>
                <c:pt idx="94">
                  <c:v>1457.96</c:v>
                </c:pt>
                <c:pt idx="95">
                  <c:v>1429.93</c:v>
                </c:pt>
                <c:pt idx="96">
                  <c:v>1214.71</c:v>
                </c:pt>
                <c:pt idx="97">
                  <c:v>1560.25</c:v>
                </c:pt>
                <c:pt idx="98">
                  <c:v>1098.8599999999999</c:v>
                </c:pt>
                <c:pt idx="99">
                  <c:v>1646.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71E-41B5-9FCF-500F5DEBF0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82725064"/>
        <c:axId val="682728672"/>
      </c:lineChart>
      <c:catAx>
        <c:axId val="682725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82728672"/>
        <c:crosses val="autoZero"/>
        <c:auto val="1"/>
        <c:lblAlgn val="ctr"/>
        <c:lblOffset val="100"/>
        <c:noMultiLvlLbl val="0"/>
      </c:catAx>
      <c:valAx>
        <c:axId val="6827286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82725064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35428989942456102"/>
          <c:y val="0.74115740740740732"/>
          <c:w val="0.33218764321126526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WGG-gene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wgg_Gene!$A$5</c:f>
              <c:strCache>
                <c:ptCount val="1"/>
                <c:pt idx="0">
                  <c:v>E26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wgg_Gene!$B$4:$CW$4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wgg_Gene!$B$5:$CW$5</c:f>
              <c:numCache>
                <c:formatCode>General</c:formatCode>
                <c:ptCount val="100"/>
                <c:pt idx="0">
                  <c:v>954.16</c:v>
                </c:pt>
                <c:pt idx="1">
                  <c:v>1395.54</c:v>
                </c:pt>
                <c:pt idx="2">
                  <c:v>1045.79</c:v>
                </c:pt>
                <c:pt idx="3">
                  <c:v>908.7</c:v>
                </c:pt>
                <c:pt idx="4">
                  <c:v>867.13999999999896</c:v>
                </c:pt>
                <c:pt idx="5">
                  <c:v>1146.24</c:v>
                </c:pt>
                <c:pt idx="6">
                  <c:v>1132.3800000000001</c:v>
                </c:pt>
                <c:pt idx="7">
                  <c:v>1157.57</c:v>
                </c:pt>
                <c:pt idx="8">
                  <c:v>1002.04</c:v>
                </c:pt>
                <c:pt idx="9">
                  <c:v>951.56999999999903</c:v>
                </c:pt>
                <c:pt idx="10">
                  <c:v>950.33</c:v>
                </c:pt>
                <c:pt idx="11">
                  <c:v>876.35</c:v>
                </c:pt>
                <c:pt idx="12">
                  <c:v>848.16999999999905</c:v>
                </c:pt>
                <c:pt idx="13">
                  <c:v>761.18</c:v>
                </c:pt>
                <c:pt idx="14">
                  <c:v>915.099999999999</c:v>
                </c:pt>
                <c:pt idx="15">
                  <c:v>989.02</c:v>
                </c:pt>
                <c:pt idx="16">
                  <c:v>938.53999999999905</c:v>
                </c:pt>
                <c:pt idx="17">
                  <c:v>831.38</c:v>
                </c:pt>
                <c:pt idx="18">
                  <c:v>1198.77</c:v>
                </c:pt>
                <c:pt idx="19">
                  <c:v>828.42999999999904</c:v>
                </c:pt>
                <c:pt idx="20">
                  <c:v>821.7</c:v>
                </c:pt>
                <c:pt idx="21">
                  <c:v>785.52999999999895</c:v>
                </c:pt>
                <c:pt idx="22">
                  <c:v>965.06999999999903</c:v>
                </c:pt>
                <c:pt idx="23">
                  <c:v>748.98999999999899</c:v>
                </c:pt>
                <c:pt idx="24">
                  <c:v>791.43</c:v>
                </c:pt>
                <c:pt idx="25">
                  <c:v>1011.7</c:v>
                </c:pt>
                <c:pt idx="26">
                  <c:v>804.43999999999903</c:v>
                </c:pt>
                <c:pt idx="27">
                  <c:v>908.69999999999902</c:v>
                </c:pt>
                <c:pt idx="28">
                  <c:v>1031.51</c:v>
                </c:pt>
                <c:pt idx="29">
                  <c:v>1075.6400000000001</c:v>
                </c:pt>
                <c:pt idx="30">
                  <c:v>1076.47</c:v>
                </c:pt>
                <c:pt idx="31">
                  <c:v>796.43</c:v>
                </c:pt>
                <c:pt idx="32">
                  <c:v>835.099999999999</c:v>
                </c:pt>
                <c:pt idx="33">
                  <c:v>765.8</c:v>
                </c:pt>
                <c:pt idx="34">
                  <c:v>937.33999999999901</c:v>
                </c:pt>
                <c:pt idx="35">
                  <c:v>825.09</c:v>
                </c:pt>
                <c:pt idx="36">
                  <c:v>1202.94</c:v>
                </c:pt>
                <c:pt idx="37">
                  <c:v>1090.32</c:v>
                </c:pt>
                <c:pt idx="38">
                  <c:v>797.35</c:v>
                </c:pt>
                <c:pt idx="39">
                  <c:v>928.44</c:v>
                </c:pt>
                <c:pt idx="40">
                  <c:v>791.86</c:v>
                </c:pt>
                <c:pt idx="41">
                  <c:v>962.07999999999902</c:v>
                </c:pt>
                <c:pt idx="42">
                  <c:v>809.91</c:v>
                </c:pt>
                <c:pt idx="43">
                  <c:v>1007.12</c:v>
                </c:pt>
                <c:pt idx="44">
                  <c:v>1078.97</c:v>
                </c:pt>
                <c:pt idx="45">
                  <c:v>863.76999999999896</c:v>
                </c:pt>
                <c:pt idx="46">
                  <c:v>873.82</c:v>
                </c:pt>
                <c:pt idx="47">
                  <c:v>1023.93</c:v>
                </c:pt>
                <c:pt idx="48">
                  <c:v>870.85999999999899</c:v>
                </c:pt>
                <c:pt idx="49">
                  <c:v>1068.02</c:v>
                </c:pt>
                <c:pt idx="50">
                  <c:v>825.02</c:v>
                </c:pt>
                <c:pt idx="51">
                  <c:v>1020.91</c:v>
                </c:pt>
                <c:pt idx="52">
                  <c:v>864.6</c:v>
                </c:pt>
                <c:pt idx="53">
                  <c:v>1022.67</c:v>
                </c:pt>
                <c:pt idx="54">
                  <c:v>875.86999999999898</c:v>
                </c:pt>
                <c:pt idx="55">
                  <c:v>870</c:v>
                </c:pt>
                <c:pt idx="56">
                  <c:v>820.00999999999897</c:v>
                </c:pt>
                <c:pt idx="57">
                  <c:v>1257.2</c:v>
                </c:pt>
                <c:pt idx="58">
                  <c:v>916.68999999999903</c:v>
                </c:pt>
                <c:pt idx="59">
                  <c:v>1078.94</c:v>
                </c:pt>
                <c:pt idx="60">
                  <c:v>931.4</c:v>
                </c:pt>
                <c:pt idx="61">
                  <c:v>1003.29</c:v>
                </c:pt>
                <c:pt idx="62">
                  <c:v>959.98</c:v>
                </c:pt>
                <c:pt idx="63">
                  <c:v>992.75999999999897</c:v>
                </c:pt>
                <c:pt idx="64">
                  <c:v>1013.74</c:v>
                </c:pt>
                <c:pt idx="65">
                  <c:v>1060.46</c:v>
                </c:pt>
                <c:pt idx="66">
                  <c:v>1021.79</c:v>
                </c:pt>
                <c:pt idx="67">
                  <c:v>833.05999999999904</c:v>
                </c:pt>
                <c:pt idx="68">
                  <c:v>937.36</c:v>
                </c:pt>
                <c:pt idx="69">
                  <c:v>869.219999999999</c:v>
                </c:pt>
                <c:pt idx="70">
                  <c:v>1045.8</c:v>
                </c:pt>
                <c:pt idx="71">
                  <c:v>859.55999999999904</c:v>
                </c:pt>
                <c:pt idx="72">
                  <c:v>962.07999999999902</c:v>
                </c:pt>
                <c:pt idx="73">
                  <c:v>848.61</c:v>
                </c:pt>
                <c:pt idx="74">
                  <c:v>792.25</c:v>
                </c:pt>
                <c:pt idx="75">
                  <c:v>981.02</c:v>
                </c:pt>
                <c:pt idx="76">
                  <c:v>1212.6500000000001</c:v>
                </c:pt>
                <c:pt idx="77">
                  <c:v>1050.3800000000001</c:v>
                </c:pt>
                <c:pt idx="78">
                  <c:v>1033.6300000000001</c:v>
                </c:pt>
                <c:pt idx="79">
                  <c:v>1157.19</c:v>
                </c:pt>
                <c:pt idx="80">
                  <c:v>1113.42</c:v>
                </c:pt>
                <c:pt idx="81">
                  <c:v>940.66999999999905</c:v>
                </c:pt>
                <c:pt idx="82">
                  <c:v>944.86</c:v>
                </c:pt>
                <c:pt idx="83">
                  <c:v>810.76999999999896</c:v>
                </c:pt>
                <c:pt idx="84">
                  <c:v>945.28</c:v>
                </c:pt>
                <c:pt idx="85">
                  <c:v>1165.1199999999999</c:v>
                </c:pt>
                <c:pt idx="86">
                  <c:v>949.93</c:v>
                </c:pt>
                <c:pt idx="87">
                  <c:v>1242.43</c:v>
                </c:pt>
                <c:pt idx="88">
                  <c:v>1413.54</c:v>
                </c:pt>
                <c:pt idx="89">
                  <c:v>1033.9100000000001</c:v>
                </c:pt>
                <c:pt idx="90">
                  <c:v>1354.67</c:v>
                </c:pt>
                <c:pt idx="91">
                  <c:v>978.02</c:v>
                </c:pt>
                <c:pt idx="92">
                  <c:v>812.88</c:v>
                </c:pt>
                <c:pt idx="93">
                  <c:v>1322.73</c:v>
                </c:pt>
                <c:pt idx="94">
                  <c:v>1264.33</c:v>
                </c:pt>
                <c:pt idx="95">
                  <c:v>1248.32</c:v>
                </c:pt>
                <c:pt idx="96">
                  <c:v>1109.17</c:v>
                </c:pt>
                <c:pt idx="97">
                  <c:v>1377.04</c:v>
                </c:pt>
                <c:pt idx="98">
                  <c:v>1105.08</c:v>
                </c:pt>
                <c:pt idx="99">
                  <c:v>1286.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9E1-4E7E-A4DD-9177747B6274}"/>
            </c:ext>
          </c:extLst>
        </c:ser>
        <c:ser>
          <c:idx val="1"/>
          <c:order val="1"/>
          <c:tx>
            <c:strRef>
              <c:f>ccwgg_Gene!$A$6</c:f>
              <c:strCache>
                <c:ptCount val="1"/>
                <c:pt idx="0">
                  <c:v>E26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wgg_Gene!$B$4:$CW$4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wgg_Gene!$B$6:$CW$6</c:f>
              <c:numCache>
                <c:formatCode>General</c:formatCode>
                <c:ptCount val="100"/>
                <c:pt idx="0">
                  <c:v>929.00999999999897</c:v>
                </c:pt>
                <c:pt idx="1">
                  <c:v>1425.84</c:v>
                </c:pt>
                <c:pt idx="2">
                  <c:v>1100.8499999999999</c:v>
                </c:pt>
                <c:pt idx="3">
                  <c:v>900.59</c:v>
                </c:pt>
                <c:pt idx="4">
                  <c:v>878.07</c:v>
                </c:pt>
                <c:pt idx="5">
                  <c:v>1107.95</c:v>
                </c:pt>
                <c:pt idx="6">
                  <c:v>1159.26</c:v>
                </c:pt>
                <c:pt idx="7">
                  <c:v>1143.01</c:v>
                </c:pt>
                <c:pt idx="8">
                  <c:v>951.99</c:v>
                </c:pt>
                <c:pt idx="9">
                  <c:v>1012.04</c:v>
                </c:pt>
                <c:pt idx="10">
                  <c:v>999.85999999999899</c:v>
                </c:pt>
                <c:pt idx="11">
                  <c:v>821.38999999999896</c:v>
                </c:pt>
                <c:pt idx="12">
                  <c:v>866.45</c:v>
                </c:pt>
                <c:pt idx="13">
                  <c:v>818.05</c:v>
                </c:pt>
                <c:pt idx="14">
                  <c:v>911.1</c:v>
                </c:pt>
                <c:pt idx="15">
                  <c:v>861.42999999999904</c:v>
                </c:pt>
                <c:pt idx="16">
                  <c:v>948.66999999999905</c:v>
                </c:pt>
                <c:pt idx="17">
                  <c:v>861.91999999999905</c:v>
                </c:pt>
                <c:pt idx="18">
                  <c:v>1183.9100000000001</c:v>
                </c:pt>
                <c:pt idx="19">
                  <c:v>794.25</c:v>
                </c:pt>
                <c:pt idx="20">
                  <c:v>805.51999999999896</c:v>
                </c:pt>
                <c:pt idx="21">
                  <c:v>771.35999999999899</c:v>
                </c:pt>
                <c:pt idx="22">
                  <c:v>934.39</c:v>
                </c:pt>
                <c:pt idx="23">
                  <c:v>775.97</c:v>
                </c:pt>
                <c:pt idx="24">
                  <c:v>788.90999999999894</c:v>
                </c:pt>
                <c:pt idx="25">
                  <c:v>1078.74</c:v>
                </c:pt>
                <c:pt idx="26">
                  <c:v>808.01999999999896</c:v>
                </c:pt>
                <c:pt idx="27">
                  <c:v>831.83999999999901</c:v>
                </c:pt>
                <c:pt idx="28">
                  <c:v>1063.3599999999999</c:v>
                </c:pt>
                <c:pt idx="29">
                  <c:v>1077.92</c:v>
                </c:pt>
                <c:pt idx="30">
                  <c:v>1128.8599999999999</c:v>
                </c:pt>
                <c:pt idx="31">
                  <c:v>798.09</c:v>
                </c:pt>
                <c:pt idx="32">
                  <c:v>813.1</c:v>
                </c:pt>
                <c:pt idx="33">
                  <c:v>778.08999999999901</c:v>
                </c:pt>
                <c:pt idx="34">
                  <c:v>942.79999999999905</c:v>
                </c:pt>
                <c:pt idx="35">
                  <c:v>812.21</c:v>
                </c:pt>
                <c:pt idx="36">
                  <c:v>1179.3399999999999</c:v>
                </c:pt>
                <c:pt idx="37">
                  <c:v>1127.0899999999999</c:v>
                </c:pt>
                <c:pt idx="38">
                  <c:v>829.28</c:v>
                </c:pt>
                <c:pt idx="39">
                  <c:v>911.88999999999896</c:v>
                </c:pt>
                <c:pt idx="40">
                  <c:v>789.66</c:v>
                </c:pt>
                <c:pt idx="41">
                  <c:v>1052.1099999999999</c:v>
                </c:pt>
                <c:pt idx="42">
                  <c:v>764.31</c:v>
                </c:pt>
                <c:pt idx="43">
                  <c:v>1013.72</c:v>
                </c:pt>
                <c:pt idx="44">
                  <c:v>1074.1600000000001</c:v>
                </c:pt>
                <c:pt idx="45">
                  <c:v>856.01999999999896</c:v>
                </c:pt>
                <c:pt idx="46">
                  <c:v>879.40999999999894</c:v>
                </c:pt>
                <c:pt idx="47">
                  <c:v>1008.71</c:v>
                </c:pt>
                <c:pt idx="48">
                  <c:v>847.25999999999897</c:v>
                </c:pt>
                <c:pt idx="49">
                  <c:v>1111.3</c:v>
                </c:pt>
                <c:pt idx="50">
                  <c:v>777.18999999999903</c:v>
                </c:pt>
                <c:pt idx="51">
                  <c:v>962.42999999999904</c:v>
                </c:pt>
                <c:pt idx="52">
                  <c:v>812.67</c:v>
                </c:pt>
                <c:pt idx="53">
                  <c:v>1014.09</c:v>
                </c:pt>
                <c:pt idx="54">
                  <c:v>909.03999999999905</c:v>
                </c:pt>
                <c:pt idx="55">
                  <c:v>862.729999999999</c:v>
                </c:pt>
                <c:pt idx="56">
                  <c:v>793.479999999999</c:v>
                </c:pt>
                <c:pt idx="57">
                  <c:v>1223.54</c:v>
                </c:pt>
                <c:pt idx="58">
                  <c:v>888.09</c:v>
                </c:pt>
                <c:pt idx="59">
                  <c:v>1069.99</c:v>
                </c:pt>
                <c:pt idx="60">
                  <c:v>947.36999999999898</c:v>
                </c:pt>
                <c:pt idx="61">
                  <c:v>965.28999999999905</c:v>
                </c:pt>
                <c:pt idx="62">
                  <c:v>957.38</c:v>
                </c:pt>
                <c:pt idx="63">
                  <c:v>966.18999999999903</c:v>
                </c:pt>
                <c:pt idx="64">
                  <c:v>1058.73</c:v>
                </c:pt>
                <c:pt idx="65">
                  <c:v>1051.7</c:v>
                </c:pt>
                <c:pt idx="66">
                  <c:v>985.67999999999904</c:v>
                </c:pt>
                <c:pt idx="67">
                  <c:v>801.8</c:v>
                </c:pt>
                <c:pt idx="68">
                  <c:v>981.17999999999904</c:v>
                </c:pt>
                <c:pt idx="69">
                  <c:v>881.40999999999894</c:v>
                </c:pt>
                <c:pt idx="70">
                  <c:v>1027.9000000000001</c:v>
                </c:pt>
                <c:pt idx="71">
                  <c:v>843.10999999999899</c:v>
                </c:pt>
                <c:pt idx="72">
                  <c:v>959.45999999999901</c:v>
                </c:pt>
                <c:pt idx="73">
                  <c:v>894.83</c:v>
                </c:pt>
                <c:pt idx="74">
                  <c:v>803.86</c:v>
                </c:pt>
                <c:pt idx="75">
                  <c:v>951.12999999999897</c:v>
                </c:pt>
                <c:pt idx="76">
                  <c:v>1160.17</c:v>
                </c:pt>
                <c:pt idx="77">
                  <c:v>1016.15</c:v>
                </c:pt>
                <c:pt idx="78">
                  <c:v>1064.57</c:v>
                </c:pt>
                <c:pt idx="79">
                  <c:v>1151.3499999999999</c:v>
                </c:pt>
                <c:pt idx="80">
                  <c:v>1062.05</c:v>
                </c:pt>
                <c:pt idx="81">
                  <c:v>949.86999999999898</c:v>
                </c:pt>
                <c:pt idx="82">
                  <c:v>847.69999999999902</c:v>
                </c:pt>
                <c:pt idx="83">
                  <c:v>765</c:v>
                </c:pt>
                <c:pt idx="84">
                  <c:v>963.22</c:v>
                </c:pt>
                <c:pt idx="85">
                  <c:v>1256.07</c:v>
                </c:pt>
                <c:pt idx="86">
                  <c:v>1032.08</c:v>
                </c:pt>
                <c:pt idx="87">
                  <c:v>1246.03</c:v>
                </c:pt>
                <c:pt idx="88">
                  <c:v>1366.19</c:v>
                </c:pt>
                <c:pt idx="89">
                  <c:v>1034.1199999999999</c:v>
                </c:pt>
                <c:pt idx="90">
                  <c:v>1316.49</c:v>
                </c:pt>
                <c:pt idx="91">
                  <c:v>956.61</c:v>
                </c:pt>
                <c:pt idx="92">
                  <c:v>842.24999999999898</c:v>
                </c:pt>
                <c:pt idx="93">
                  <c:v>1394.95</c:v>
                </c:pt>
                <c:pt idx="94">
                  <c:v>1218.56</c:v>
                </c:pt>
                <c:pt idx="95">
                  <c:v>1195.0999999999999</c:v>
                </c:pt>
                <c:pt idx="96">
                  <c:v>1105.0999999999999</c:v>
                </c:pt>
                <c:pt idx="97">
                  <c:v>1379.54</c:v>
                </c:pt>
                <c:pt idx="98">
                  <c:v>1112.1199999999999</c:v>
                </c:pt>
                <c:pt idx="99">
                  <c:v>1374.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9E1-4E7E-A4DD-9177747B62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59377368"/>
        <c:axId val="659379664"/>
      </c:lineChart>
      <c:catAx>
        <c:axId val="659377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9379664"/>
        <c:crosses val="autoZero"/>
        <c:auto val="1"/>
        <c:lblAlgn val="ctr"/>
        <c:lblOffset val="100"/>
        <c:noMultiLvlLbl val="0"/>
      </c:catAx>
      <c:valAx>
        <c:axId val="659379664"/>
        <c:scaling>
          <c:orientation val="minMax"/>
          <c:max val="2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9377368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35154286269771834"/>
          <c:y val="0.77819444444444441"/>
          <c:w val="0.33218764321126526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WGG-TTS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wgg_TTS!$A$5</c:f>
              <c:strCache>
                <c:ptCount val="1"/>
                <c:pt idx="0">
                  <c:v>E26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wgg_TTS!$B$4:$CW$4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TS!$B$5:$CW$5</c:f>
              <c:numCache>
                <c:formatCode>General</c:formatCode>
                <c:ptCount val="100"/>
                <c:pt idx="0">
                  <c:v>548.95000000000005</c:v>
                </c:pt>
                <c:pt idx="1">
                  <c:v>1224.3800000000001</c:v>
                </c:pt>
                <c:pt idx="2">
                  <c:v>1265.1500000000001</c:v>
                </c:pt>
                <c:pt idx="3">
                  <c:v>1140.28</c:v>
                </c:pt>
                <c:pt idx="4">
                  <c:v>1079.79</c:v>
                </c:pt>
                <c:pt idx="5">
                  <c:v>1344.15</c:v>
                </c:pt>
                <c:pt idx="6">
                  <c:v>1713.24</c:v>
                </c:pt>
                <c:pt idx="7">
                  <c:v>1550.97</c:v>
                </c:pt>
                <c:pt idx="8">
                  <c:v>1342.97</c:v>
                </c:pt>
                <c:pt idx="9">
                  <c:v>1490.49</c:v>
                </c:pt>
                <c:pt idx="10">
                  <c:v>1361.02</c:v>
                </c:pt>
                <c:pt idx="11">
                  <c:v>1873.91</c:v>
                </c:pt>
                <c:pt idx="12">
                  <c:v>1667.78</c:v>
                </c:pt>
                <c:pt idx="13">
                  <c:v>1283.6600000000001</c:v>
                </c:pt>
                <c:pt idx="14">
                  <c:v>1457.66</c:v>
                </c:pt>
                <c:pt idx="15">
                  <c:v>1712.01</c:v>
                </c:pt>
                <c:pt idx="16">
                  <c:v>1492.58</c:v>
                </c:pt>
                <c:pt idx="17">
                  <c:v>1548.02</c:v>
                </c:pt>
                <c:pt idx="18">
                  <c:v>1385.02</c:v>
                </c:pt>
                <c:pt idx="19">
                  <c:v>1358.88</c:v>
                </c:pt>
                <c:pt idx="20">
                  <c:v>1284.98</c:v>
                </c:pt>
                <c:pt idx="21">
                  <c:v>1308.43</c:v>
                </c:pt>
                <c:pt idx="22">
                  <c:v>1207.57</c:v>
                </c:pt>
                <c:pt idx="23">
                  <c:v>1098.7</c:v>
                </c:pt>
                <c:pt idx="24">
                  <c:v>1323.12</c:v>
                </c:pt>
                <c:pt idx="25">
                  <c:v>1153.79</c:v>
                </c:pt>
                <c:pt idx="26">
                  <c:v>1158.02</c:v>
                </c:pt>
                <c:pt idx="27">
                  <c:v>1670.8</c:v>
                </c:pt>
                <c:pt idx="28">
                  <c:v>1698.5</c:v>
                </c:pt>
                <c:pt idx="29">
                  <c:v>1251.74</c:v>
                </c:pt>
                <c:pt idx="30">
                  <c:v>1573.22</c:v>
                </c:pt>
                <c:pt idx="31">
                  <c:v>1720.77</c:v>
                </c:pt>
                <c:pt idx="32">
                  <c:v>1572.37</c:v>
                </c:pt>
                <c:pt idx="33">
                  <c:v>1842.28</c:v>
                </c:pt>
                <c:pt idx="34">
                  <c:v>1781.26</c:v>
                </c:pt>
                <c:pt idx="35">
                  <c:v>1983.12</c:v>
                </c:pt>
                <c:pt idx="36">
                  <c:v>1980.96</c:v>
                </c:pt>
                <c:pt idx="37">
                  <c:v>2062.56</c:v>
                </c:pt>
                <c:pt idx="38">
                  <c:v>1663.56</c:v>
                </c:pt>
                <c:pt idx="39">
                  <c:v>1907.89</c:v>
                </c:pt>
                <c:pt idx="40">
                  <c:v>1735.09</c:v>
                </c:pt>
                <c:pt idx="41">
                  <c:v>1894.01</c:v>
                </c:pt>
                <c:pt idx="42">
                  <c:v>2120.52</c:v>
                </c:pt>
                <c:pt idx="43">
                  <c:v>2370.6799999999998</c:v>
                </c:pt>
                <c:pt idx="44">
                  <c:v>2506.39</c:v>
                </c:pt>
                <c:pt idx="45">
                  <c:v>2202.12</c:v>
                </c:pt>
                <c:pt idx="46">
                  <c:v>2049.9</c:v>
                </c:pt>
                <c:pt idx="47">
                  <c:v>1979.32</c:v>
                </c:pt>
                <c:pt idx="48">
                  <c:v>2537.56</c:v>
                </c:pt>
                <c:pt idx="49">
                  <c:v>2388.3000000000002</c:v>
                </c:pt>
                <c:pt idx="50">
                  <c:v>1849.44</c:v>
                </c:pt>
                <c:pt idx="51">
                  <c:v>1545.94</c:v>
                </c:pt>
                <c:pt idx="52">
                  <c:v>1149.56</c:v>
                </c:pt>
                <c:pt idx="53">
                  <c:v>1169.3599999999999</c:v>
                </c:pt>
                <c:pt idx="54">
                  <c:v>1142.92</c:v>
                </c:pt>
                <c:pt idx="55">
                  <c:v>1224.79</c:v>
                </c:pt>
                <c:pt idx="56">
                  <c:v>1063.3900000000001</c:v>
                </c:pt>
                <c:pt idx="57">
                  <c:v>1198.31</c:v>
                </c:pt>
                <c:pt idx="58">
                  <c:v>1297.1099999999999</c:v>
                </c:pt>
                <c:pt idx="59">
                  <c:v>1083.19</c:v>
                </c:pt>
                <c:pt idx="60">
                  <c:v>1446.35</c:v>
                </c:pt>
                <c:pt idx="61">
                  <c:v>926.78</c:v>
                </c:pt>
                <c:pt idx="62">
                  <c:v>1182.75</c:v>
                </c:pt>
                <c:pt idx="63">
                  <c:v>1553.54</c:v>
                </c:pt>
                <c:pt idx="64">
                  <c:v>1295.47</c:v>
                </c:pt>
                <c:pt idx="65">
                  <c:v>1083.1300000000001</c:v>
                </c:pt>
                <c:pt idx="66">
                  <c:v>809.45999999999901</c:v>
                </c:pt>
                <c:pt idx="67">
                  <c:v>1167.74</c:v>
                </c:pt>
                <c:pt idx="68">
                  <c:v>1107.5</c:v>
                </c:pt>
                <c:pt idx="69">
                  <c:v>1220.2</c:v>
                </c:pt>
                <c:pt idx="70">
                  <c:v>1266.04</c:v>
                </c:pt>
                <c:pt idx="71">
                  <c:v>1213.8699999999999</c:v>
                </c:pt>
                <c:pt idx="72">
                  <c:v>1483.75</c:v>
                </c:pt>
                <c:pt idx="73">
                  <c:v>1439.66</c:v>
                </c:pt>
                <c:pt idx="74">
                  <c:v>1276.97</c:v>
                </c:pt>
                <c:pt idx="75">
                  <c:v>1562.34</c:v>
                </c:pt>
                <c:pt idx="76">
                  <c:v>1238.3399999999999</c:v>
                </c:pt>
                <c:pt idx="77">
                  <c:v>1356.8</c:v>
                </c:pt>
                <c:pt idx="78">
                  <c:v>1212.68</c:v>
                </c:pt>
                <c:pt idx="79">
                  <c:v>1283.6300000000001</c:v>
                </c:pt>
                <c:pt idx="80">
                  <c:v>1139.1099999999999</c:v>
                </c:pt>
                <c:pt idx="81">
                  <c:v>1222.29</c:v>
                </c:pt>
                <c:pt idx="82">
                  <c:v>1418.98</c:v>
                </c:pt>
                <c:pt idx="83">
                  <c:v>1147.06</c:v>
                </c:pt>
                <c:pt idx="84">
                  <c:v>1163.9100000000001</c:v>
                </c:pt>
                <c:pt idx="85">
                  <c:v>1350.57</c:v>
                </c:pt>
                <c:pt idx="86">
                  <c:v>1254.69</c:v>
                </c:pt>
                <c:pt idx="87">
                  <c:v>1195.82</c:v>
                </c:pt>
                <c:pt idx="88">
                  <c:v>1019.26</c:v>
                </c:pt>
                <c:pt idx="89">
                  <c:v>1244.99</c:v>
                </c:pt>
                <c:pt idx="90">
                  <c:v>935.229999999999</c:v>
                </c:pt>
                <c:pt idx="91">
                  <c:v>1408.54</c:v>
                </c:pt>
                <c:pt idx="92">
                  <c:v>1375.71</c:v>
                </c:pt>
                <c:pt idx="93">
                  <c:v>1247.0999999999999</c:v>
                </c:pt>
                <c:pt idx="94">
                  <c:v>1503.92</c:v>
                </c:pt>
                <c:pt idx="95">
                  <c:v>1432.03</c:v>
                </c:pt>
                <c:pt idx="96">
                  <c:v>1142.42</c:v>
                </c:pt>
                <c:pt idx="97">
                  <c:v>1119.32</c:v>
                </c:pt>
                <c:pt idx="98">
                  <c:v>1533.76</c:v>
                </c:pt>
                <c:pt idx="99">
                  <c:v>1285.38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472-47DD-B000-3B5DB5711B95}"/>
            </c:ext>
          </c:extLst>
        </c:ser>
        <c:ser>
          <c:idx val="1"/>
          <c:order val="1"/>
          <c:tx>
            <c:strRef>
              <c:f>ccwgg_TTS!$A$6</c:f>
              <c:strCache>
                <c:ptCount val="1"/>
                <c:pt idx="0">
                  <c:v>E26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wgg_TTS!$B$4:$CW$4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TS!$B$6:$CW$6</c:f>
              <c:numCache>
                <c:formatCode>General</c:formatCode>
                <c:ptCount val="100"/>
                <c:pt idx="0">
                  <c:v>560.26</c:v>
                </c:pt>
                <c:pt idx="1">
                  <c:v>1148.82</c:v>
                </c:pt>
                <c:pt idx="2">
                  <c:v>1198.94</c:v>
                </c:pt>
                <c:pt idx="3">
                  <c:v>1130.46</c:v>
                </c:pt>
                <c:pt idx="4">
                  <c:v>1092.6400000000001</c:v>
                </c:pt>
                <c:pt idx="5">
                  <c:v>1326.54</c:v>
                </c:pt>
                <c:pt idx="6">
                  <c:v>1790.46</c:v>
                </c:pt>
                <c:pt idx="7">
                  <c:v>1551.45</c:v>
                </c:pt>
                <c:pt idx="8">
                  <c:v>1484.65</c:v>
                </c:pt>
                <c:pt idx="9">
                  <c:v>1468.4</c:v>
                </c:pt>
                <c:pt idx="10">
                  <c:v>1346.64</c:v>
                </c:pt>
                <c:pt idx="11">
                  <c:v>1863.9</c:v>
                </c:pt>
                <c:pt idx="12">
                  <c:v>1712</c:v>
                </c:pt>
                <c:pt idx="13">
                  <c:v>1319.01</c:v>
                </c:pt>
                <c:pt idx="14">
                  <c:v>1527.59</c:v>
                </c:pt>
                <c:pt idx="15">
                  <c:v>1606.87</c:v>
                </c:pt>
                <c:pt idx="16">
                  <c:v>1457.11</c:v>
                </c:pt>
                <c:pt idx="17">
                  <c:v>1543.55</c:v>
                </c:pt>
                <c:pt idx="18">
                  <c:v>1354.87</c:v>
                </c:pt>
                <c:pt idx="19">
                  <c:v>1348.24</c:v>
                </c:pt>
                <c:pt idx="20">
                  <c:v>1283.18</c:v>
                </c:pt>
                <c:pt idx="21">
                  <c:v>1302.33</c:v>
                </c:pt>
                <c:pt idx="22">
                  <c:v>1242.3</c:v>
                </c:pt>
                <c:pt idx="23">
                  <c:v>1059.5999999999999</c:v>
                </c:pt>
                <c:pt idx="24">
                  <c:v>1414.95</c:v>
                </c:pt>
                <c:pt idx="25">
                  <c:v>1068.7</c:v>
                </c:pt>
                <c:pt idx="26">
                  <c:v>1185.99</c:v>
                </c:pt>
                <c:pt idx="27">
                  <c:v>1599.37</c:v>
                </c:pt>
                <c:pt idx="28">
                  <c:v>1750.4</c:v>
                </c:pt>
                <c:pt idx="29">
                  <c:v>1256.07</c:v>
                </c:pt>
                <c:pt idx="30">
                  <c:v>1477.5</c:v>
                </c:pt>
                <c:pt idx="31">
                  <c:v>1751.2</c:v>
                </c:pt>
                <c:pt idx="32">
                  <c:v>1503.45</c:v>
                </c:pt>
                <c:pt idx="33">
                  <c:v>1839.61</c:v>
                </c:pt>
                <c:pt idx="34">
                  <c:v>1680.77</c:v>
                </c:pt>
                <c:pt idx="35">
                  <c:v>1959.02</c:v>
                </c:pt>
                <c:pt idx="36">
                  <c:v>2009.14</c:v>
                </c:pt>
                <c:pt idx="37">
                  <c:v>2083.7600000000002</c:v>
                </c:pt>
                <c:pt idx="38">
                  <c:v>1715.77</c:v>
                </c:pt>
                <c:pt idx="39">
                  <c:v>1860.48</c:v>
                </c:pt>
                <c:pt idx="40">
                  <c:v>1722.01</c:v>
                </c:pt>
                <c:pt idx="41">
                  <c:v>1900.58</c:v>
                </c:pt>
                <c:pt idx="42">
                  <c:v>2024.45</c:v>
                </c:pt>
                <c:pt idx="43">
                  <c:v>2428.5500000000002</c:v>
                </c:pt>
                <c:pt idx="44">
                  <c:v>2614.64</c:v>
                </c:pt>
                <c:pt idx="45">
                  <c:v>2147.9</c:v>
                </c:pt>
                <c:pt idx="46">
                  <c:v>2004.89</c:v>
                </c:pt>
                <c:pt idx="47">
                  <c:v>2019.01</c:v>
                </c:pt>
                <c:pt idx="48">
                  <c:v>2511.6999999999998</c:v>
                </c:pt>
                <c:pt idx="49">
                  <c:v>2431.2199999999998</c:v>
                </c:pt>
                <c:pt idx="50">
                  <c:v>1870.01</c:v>
                </c:pt>
                <c:pt idx="51">
                  <c:v>1494.31</c:v>
                </c:pt>
                <c:pt idx="52">
                  <c:v>1135.0999999999999</c:v>
                </c:pt>
                <c:pt idx="53">
                  <c:v>1122.1199999999999</c:v>
                </c:pt>
                <c:pt idx="54">
                  <c:v>1082.93</c:v>
                </c:pt>
                <c:pt idx="55">
                  <c:v>1229.3699999999999</c:v>
                </c:pt>
                <c:pt idx="56">
                  <c:v>1059.1300000000001</c:v>
                </c:pt>
                <c:pt idx="57">
                  <c:v>1226.53</c:v>
                </c:pt>
                <c:pt idx="58">
                  <c:v>1328.61</c:v>
                </c:pt>
                <c:pt idx="59">
                  <c:v>1092.18</c:v>
                </c:pt>
                <c:pt idx="60">
                  <c:v>1488.4</c:v>
                </c:pt>
                <c:pt idx="61">
                  <c:v>944.39999999999895</c:v>
                </c:pt>
                <c:pt idx="62">
                  <c:v>1147.67</c:v>
                </c:pt>
                <c:pt idx="63">
                  <c:v>1427.07</c:v>
                </c:pt>
                <c:pt idx="64">
                  <c:v>1245.23</c:v>
                </c:pt>
                <c:pt idx="65">
                  <c:v>1046.2</c:v>
                </c:pt>
                <c:pt idx="66">
                  <c:v>807.60999999999899</c:v>
                </c:pt>
                <c:pt idx="67">
                  <c:v>1104.1600000000001</c:v>
                </c:pt>
                <c:pt idx="68">
                  <c:v>1101.73</c:v>
                </c:pt>
                <c:pt idx="69">
                  <c:v>1186.8</c:v>
                </c:pt>
                <c:pt idx="70">
                  <c:v>1296.8399999999999</c:v>
                </c:pt>
                <c:pt idx="71">
                  <c:v>1238.97</c:v>
                </c:pt>
                <c:pt idx="72">
                  <c:v>1492.09</c:v>
                </c:pt>
                <c:pt idx="73">
                  <c:v>1500.87</c:v>
                </c:pt>
                <c:pt idx="74">
                  <c:v>1223.04</c:v>
                </c:pt>
                <c:pt idx="75">
                  <c:v>1569.76</c:v>
                </c:pt>
                <c:pt idx="76">
                  <c:v>1154.6500000000001</c:v>
                </c:pt>
                <c:pt idx="77">
                  <c:v>1419.15</c:v>
                </c:pt>
                <c:pt idx="78">
                  <c:v>1228.49</c:v>
                </c:pt>
                <c:pt idx="79">
                  <c:v>1245.2</c:v>
                </c:pt>
                <c:pt idx="80">
                  <c:v>1119.23</c:v>
                </c:pt>
                <c:pt idx="81">
                  <c:v>1238.55</c:v>
                </c:pt>
                <c:pt idx="82">
                  <c:v>1341.97</c:v>
                </c:pt>
                <c:pt idx="83">
                  <c:v>1227.68</c:v>
                </c:pt>
                <c:pt idx="84">
                  <c:v>1130.06</c:v>
                </c:pt>
                <c:pt idx="85">
                  <c:v>1326.55</c:v>
                </c:pt>
                <c:pt idx="86">
                  <c:v>1209.71</c:v>
                </c:pt>
                <c:pt idx="87">
                  <c:v>1195.52</c:v>
                </c:pt>
                <c:pt idx="88">
                  <c:v>961.15999999999894</c:v>
                </c:pt>
                <c:pt idx="89">
                  <c:v>1259</c:v>
                </c:pt>
                <c:pt idx="90">
                  <c:v>969.04999999999905</c:v>
                </c:pt>
                <c:pt idx="91">
                  <c:v>1442.17</c:v>
                </c:pt>
                <c:pt idx="92">
                  <c:v>1320.3</c:v>
                </c:pt>
                <c:pt idx="93">
                  <c:v>1269.83</c:v>
                </c:pt>
                <c:pt idx="94">
                  <c:v>1411.66</c:v>
                </c:pt>
                <c:pt idx="95">
                  <c:v>1464.99</c:v>
                </c:pt>
                <c:pt idx="96">
                  <c:v>1125.06</c:v>
                </c:pt>
                <c:pt idx="97">
                  <c:v>1141.72</c:v>
                </c:pt>
                <c:pt idx="98">
                  <c:v>1360.34</c:v>
                </c:pt>
                <c:pt idx="99">
                  <c:v>1307.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472-47DD-B000-3B5DB5711B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59398360"/>
        <c:axId val="659399672"/>
      </c:lineChart>
      <c:catAx>
        <c:axId val="659398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9399672"/>
        <c:crosses val="autoZero"/>
        <c:auto val="1"/>
        <c:lblAlgn val="ctr"/>
        <c:lblOffset val="100"/>
        <c:noMultiLvlLbl val="0"/>
      </c:catAx>
      <c:valAx>
        <c:axId val="6593996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9398360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36060702832067254"/>
          <c:y val="0.74578703703703708"/>
          <c:w val="0.3316028058112454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GG-gene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9.4378782734293731E-2"/>
          <c:y val="0.18039370078740158"/>
          <c:w val="0.88934151454887445"/>
          <c:h val="0.69203667249927092"/>
        </c:manualLayout>
      </c:layout>
      <c:lineChart>
        <c:grouping val="standard"/>
        <c:varyColors val="0"/>
        <c:ser>
          <c:idx val="0"/>
          <c:order val="0"/>
          <c:tx>
            <c:strRef>
              <c:f>ccgg_Gene!$A$8</c:f>
              <c:strCache>
                <c:ptCount val="1"/>
                <c:pt idx="0">
                  <c:v>E108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gg_Gene!$B$7:$CW$7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gg_Gene!$B$8:$CW$8</c:f>
              <c:numCache>
                <c:formatCode>General</c:formatCode>
                <c:ptCount val="100"/>
                <c:pt idx="0">
                  <c:v>1104.6099999999999</c:v>
                </c:pt>
                <c:pt idx="1">
                  <c:v>1408.62</c:v>
                </c:pt>
                <c:pt idx="2">
                  <c:v>1236.33</c:v>
                </c:pt>
                <c:pt idx="3">
                  <c:v>1240.17</c:v>
                </c:pt>
                <c:pt idx="4">
                  <c:v>1582.34</c:v>
                </c:pt>
                <c:pt idx="5">
                  <c:v>1314.5</c:v>
                </c:pt>
                <c:pt idx="6">
                  <c:v>1460.03</c:v>
                </c:pt>
                <c:pt idx="7">
                  <c:v>1519.5</c:v>
                </c:pt>
                <c:pt idx="8">
                  <c:v>1284.3499999999999</c:v>
                </c:pt>
                <c:pt idx="9">
                  <c:v>1917.33</c:v>
                </c:pt>
                <c:pt idx="10">
                  <c:v>1759.96</c:v>
                </c:pt>
                <c:pt idx="11">
                  <c:v>1698.61</c:v>
                </c:pt>
                <c:pt idx="12">
                  <c:v>2141.69</c:v>
                </c:pt>
                <c:pt idx="13">
                  <c:v>1961.15</c:v>
                </c:pt>
                <c:pt idx="14">
                  <c:v>2131.79</c:v>
                </c:pt>
                <c:pt idx="15">
                  <c:v>2249.09</c:v>
                </c:pt>
                <c:pt idx="16">
                  <c:v>2216.8200000000002</c:v>
                </c:pt>
                <c:pt idx="17">
                  <c:v>2368.8000000000002</c:v>
                </c:pt>
                <c:pt idx="18">
                  <c:v>2441.09</c:v>
                </c:pt>
                <c:pt idx="19">
                  <c:v>2368.48</c:v>
                </c:pt>
                <c:pt idx="20">
                  <c:v>1808.29</c:v>
                </c:pt>
                <c:pt idx="21">
                  <c:v>2479.73</c:v>
                </c:pt>
                <c:pt idx="22">
                  <c:v>2819.42</c:v>
                </c:pt>
                <c:pt idx="23">
                  <c:v>2605.08</c:v>
                </c:pt>
                <c:pt idx="24">
                  <c:v>2409.14</c:v>
                </c:pt>
                <c:pt idx="25">
                  <c:v>2187.38</c:v>
                </c:pt>
                <c:pt idx="26">
                  <c:v>2504.8000000000002</c:v>
                </c:pt>
                <c:pt idx="27">
                  <c:v>2319.23</c:v>
                </c:pt>
                <c:pt idx="28">
                  <c:v>2356.2800000000002</c:v>
                </c:pt>
                <c:pt idx="29">
                  <c:v>6438.6800000000203</c:v>
                </c:pt>
                <c:pt idx="30">
                  <c:v>3140.05</c:v>
                </c:pt>
                <c:pt idx="31">
                  <c:v>2556.91</c:v>
                </c:pt>
                <c:pt idx="32">
                  <c:v>2642.42</c:v>
                </c:pt>
                <c:pt idx="33">
                  <c:v>3150.7</c:v>
                </c:pt>
                <c:pt idx="34">
                  <c:v>2965.03</c:v>
                </c:pt>
                <c:pt idx="35">
                  <c:v>2952.92</c:v>
                </c:pt>
                <c:pt idx="36">
                  <c:v>2173.29</c:v>
                </c:pt>
                <c:pt idx="37">
                  <c:v>2831.76</c:v>
                </c:pt>
                <c:pt idx="38">
                  <c:v>2920.55</c:v>
                </c:pt>
                <c:pt idx="39">
                  <c:v>2772.27</c:v>
                </c:pt>
                <c:pt idx="40">
                  <c:v>2902.26</c:v>
                </c:pt>
                <c:pt idx="41">
                  <c:v>2476.34</c:v>
                </c:pt>
                <c:pt idx="42">
                  <c:v>2565.4400000000101</c:v>
                </c:pt>
                <c:pt idx="43">
                  <c:v>2567.73</c:v>
                </c:pt>
                <c:pt idx="44">
                  <c:v>2547.5100000000002</c:v>
                </c:pt>
                <c:pt idx="45">
                  <c:v>3038.27</c:v>
                </c:pt>
                <c:pt idx="46">
                  <c:v>3092.05</c:v>
                </c:pt>
                <c:pt idx="47">
                  <c:v>2832.45</c:v>
                </c:pt>
                <c:pt idx="48">
                  <c:v>2789.83</c:v>
                </c:pt>
                <c:pt idx="49">
                  <c:v>2822.31</c:v>
                </c:pt>
                <c:pt idx="50">
                  <c:v>2726.59</c:v>
                </c:pt>
                <c:pt idx="51">
                  <c:v>2835.18</c:v>
                </c:pt>
                <c:pt idx="52">
                  <c:v>3241.8</c:v>
                </c:pt>
                <c:pt idx="53">
                  <c:v>3149.1</c:v>
                </c:pt>
                <c:pt idx="54">
                  <c:v>2600.86</c:v>
                </c:pt>
                <c:pt idx="55">
                  <c:v>3199.85</c:v>
                </c:pt>
                <c:pt idx="56">
                  <c:v>2739.93</c:v>
                </c:pt>
                <c:pt idx="57">
                  <c:v>2654.52</c:v>
                </c:pt>
                <c:pt idx="58">
                  <c:v>2983.8</c:v>
                </c:pt>
                <c:pt idx="59">
                  <c:v>2996.76</c:v>
                </c:pt>
                <c:pt idx="60">
                  <c:v>2953.71</c:v>
                </c:pt>
                <c:pt idx="61">
                  <c:v>3158.69</c:v>
                </c:pt>
                <c:pt idx="62">
                  <c:v>3103.76</c:v>
                </c:pt>
                <c:pt idx="63">
                  <c:v>3337.73</c:v>
                </c:pt>
                <c:pt idx="64">
                  <c:v>2666.82</c:v>
                </c:pt>
                <c:pt idx="65">
                  <c:v>3418.4400000000101</c:v>
                </c:pt>
                <c:pt idx="66">
                  <c:v>2951.09</c:v>
                </c:pt>
                <c:pt idx="67">
                  <c:v>3122.4</c:v>
                </c:pt>
                <c:pt idx="68">
                  <c:v>3217.74</c:v>
                </c:pt>
                <c:pt idx="69">
                  <c:v>2922.08</c:v>
                </c:pt>
                <c:pt idx="70">
                  <c:v>3381.24</c:v>
                </c:pt>
                <c:pt idx="71">
                  <c:v>3020.04</c:v>
                </c:pt>
                <c:pt idx="72">
                  <c:v>2929.71</c:v>
                </c:pt>
                <c:pt idx="73">
                  <c:v>3401.82</c:v>
                </c:pt>
                <c:pt idx="74">
                  <c:v>3219.71</c:v>
                </c:pt>
                <c:pt idx="75">
                  <c:v>3340.77</c:v>
                </c:pt>
                <c:pt idx="76">
                  <c:v>3525.58</c:v>
                </c:pt>
                <c:pt idx="77">
                  <c:v>3293.95</c:v>
                </c:pt>
                <c:pt idx="78">
                  <c:v>3657.01</c:v>
                </c:pt>
                <c:pt idx="79">
                  <c:v>3110.7000000000098</c:v>
                </c:pt>
                <c:pt idx="80">
                  <c:v>3247.91</c:v>
                </c:pt>
                <c:pt idx="81">
                  <c:v>3480.65</c:v>
                </c:pt>
                <c:pt idx="82">
                  <c:v>3204.33</c:v>
                </c:pt>
                <c:pt idx="83">
                  <c:v>3271.93</c:v>
                </c:pt>
                <c:pt idx="84">
                  <c:v>3180.37</c:v>
                </c:pt>
                <c:pt idx="85">
                  <c:v>2997.16</c:v>
                </c:pt>
                <c:pt idx="86">
                  <c:v>3272.23</c:v>
                </c:pt>
                <c:pt idx="87">
                  <c:v>2721.57</c:v>
                </c:pt>
                <c:pt idx="88">
                  <c:v>3006.94</c:v>
                </c:pt>
                <c:pt idx="89">
                  <c:v>3449.42</c:v>
                </c:pt>
                <c:pt idx="90">
                  <c:v>4385.62</c:v>
                </c:pt>
                <c:pt idx="91">
                  <c:v>3516.13</c:v>
                </c:pt>
                <c:pt idx="92">
                  <c:v>2917.88</c:v>
                </c:pt>
                <c:pt idx="93">
                  <c:v>2795.87</c:v>
                </c:pt>
                <c:pt idx="94">
                  <c:v>2688.88</c:v>
                </c:pt>
                <c:pt idx="95">
                  <c:v>2697.34</c:v>
                </c:pt>
                <c:pt idx="96">
                  <c:v>2049.94</c:v>
                </c:pt>
                <c:pt idx="97">
                  <c:v>1741.26</c:v>
                </c:pt>
                <c:pt idx="98">
                  <c:v>1783.08</c:v>
                </c:pt>
                <c:pt idx="99">
                  <c:v>1355.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72C-4668-B7E4-0D37F435941B}"/>
            </c:ext>
          </c:extLst>
        </c:ser>
        <c:ser>
          <c:idx val="1"/>
          <c:order val="1"/>
          <c:tx>
            <c:strRef>
              <c:f>ccgg_Gene!$A$9</c:f>
              <c:strCache>
                <c:ptCount val="1"/>
                <c:pt idx="0">
                  <c:v>E108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gg_Gene!$B$7:$CW$7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gg_Gene!$B$9:$CW$9</c:f>
              <c:numCache>
                <c:formatCode>General</c:formatCode>
                <c:ptCount val="100"/>
                <c:pt idx="0">
                  <c:v>1020.05</c:v>
                </c:pt>
                <c:pt idx="1">
                  <c:v>1441.56</c:v>
                </c:pt>
                <c:pt idx="2">
                  <c:v>1199.1400000000001</c:v>
                </c:pt>
                <c:pt idx="3">
                  <c:v>1440.21</c:v>
                </c:pt>
                <c:pt idx="4">
                  <c:v>1642.8</c:v>
                </c:pt>
                <c:pt idx="5">
                  <c:v>1339.59</c:v>
                </c:pt>
                <c:pt idx="6">
                  <c:v>1386.24</c:v>
                </c:pt>
                <c:pt idx="7">
                  <c:v>1623.97</c:v>
                </c:pt>
                <c:pt idx="8">
                  <c:v>1284.92</c:v>
                </c:pt>
                <c:pt idx="9">
                  <c:v>1843.49</c:v>
                </c:pt>
                <c:pt idx="10">
                  <c:v>1676.58</c:v>
                </c:pt>
                <c:pt idx="11">
                  <c:v>1667.11</c:v>
                </c:pt>
                <c:pt idx="12">
                  <c:v>2453.94</c:v>
                </c:pt>
                <c:pt idx="13">
                  <c:v>1979.13</c:v>
                </c:pt>
                <c:pt idx="14">
                  <c:v>2085.91</c:v>
                </c:pt>
                <c:pt idx="15">
                  <c:v>2154.91</c:v>
                </c:pt>
                <c:pt idx="16">
                  <c:v>2219.56</c:v>
                </c:pt>
                <c:pt idx="17">
                  <c:v>2249.5</c:v>
                </c:pt>
                <c:pt idx="18">
                  <c:v>2338.27</c:v>
                </c:pt>
                <c:pt idx="19">
                  <c:v>2520.9</c:v>
                </c:pt>
                <c:pt idx="20">
                  <c:v>1874.56</c:v>
                </c:pt>
                <c:pt idx="21">
                  <c:v>2487.8000000000002</c:v>
                </c:pt>
                <c:pt idx="22">
                  <c:v>2841.09</c:v>
                </c:pt>
                <c:pt idx="23">
                  <c:v>2568.21</c:v>
                </c:pt>
                <c:pt idx="24">
                  <c:v>2299.4</c:v>
                </c:pt>
                <c:pt idx="25">
                  <c:v>2087.3000000000002</c:v>
                </c:pt>
                <c:pt idx="26">
                  <c:v>2622.99</c:v>
                </c:pt>
                <c:pt idx="27">
                  <c:v>2211.5100000000002</c:v>
                </c:pt>
                <c:pt idx="28">
                  <c:v>2300.71</c:v>
                </c:pt>
                <c:pt idx="29">
                  <c:v>4916.01</c:v>
                </c:pt>
                <c:pt idx="30">
                  <c:v>2801.94</c:v>
                </c:pt>
                <c:pt idx="31">
                  <c:v>2221.6999999999998</c:v>
                </c:pt>
                <c:pt idx="32">
                  <c:v>2662.76</c:v>
                </c:pt>
                <c:pt idx="33">
                  <c:v>3147.03</c:v>
                </c:pt>
                <c:pt idx="34">
                  <c:v>2928.22</c:v>
                </c:pt>
                <c:pt idx="35">
                  <c:v>2939.04</c:v>
                </c:pt>
                <c:pt idx="36">
                  <c:v>2133.89</c:v>
                </c:pt>
                <c:pt idx="37">
                  <c:v>2635.73</c:v>
                </c:pt>
                <c:pt idx="38">
                  <c:v>3053.24999999999</c:v>
                </c:pt>
                <c:pt idx="39">
                  <c:v>2543.88</c:v>
                </c:pt>
                <c:pt idx="40">
                  <c:v>2786.37</c:v>
                </c:pt>
                <c:pt idx="41">
                  <c:v>2474.9</c:v>
                </c:pt>
                <c:pt idx="42">
                  <c:v>2494.5300000000002</c:v>
                </c:pt>
                <c:pt idx="43">
                  <c:v>2568.9699999999998</c:v>
                </c:pt>
                <c:pt idx="44">
                  <c:v>2480.38</c:v>
                </c:pt>
                <c:pt idx="45">
                  <c:v>2921.49</c:v>
                </c:pt>
                <c:pt idx="46">
                  <c:v>2885.7</c:v>
                </c:pt>
                <c:pt idx="47">
                  <c:v>2959.3</c:v>
                </c:pt>
                <c:pt idx="48">
                  <c:v>2721.38</c:v>
                </c:pt>
                <c:pt idx="49">
                  <c:v>2678.32</c:v>
                </c:pt>
                <c:pt idx="50">
                  <c:v>2673.59</c:v>
                </c:pt>
                <c:pt idx="51">
                  <c:v>2704.6</c:v>
                </c:pt>
                <c:pt idx="52">
                  <c:v>3198.45</c:v>
                </c:pt>
                <c:pt idx="53">
                  <c:v>3072.23</c:v>
                </c:pt>
                <c:pt idx="54">
                  <c:v>2612.79</c:v>
                </c:pt>
                <c:pt idx="55">
                  <c:v>3123.34</c:v>
                </c:pt>
                <c:pt idx="56">
                  <c:v>2611.31</c:v>
                </c:pt>
                <c:pt idx="57">
                  <c:v>2591.8000000000002</c:v>
                </c:pt>
                <c:pt idx="58">
                  <c:v>2548.6799999999998</c:v>
                </c:pt>
                <c:pt idx="59">
                  <c:v>2849.22</c:v>
                </c:pt>
                <c:pt idx="60">
                  <c:v>2964.06</c:v>
                </c:pt>
                <c:pt idx="61">
                  <c:v>3129.42</c:v>
                </c:pt>
                <c:pt idx="62">
                  <c:v>2952.35</c:v>
                </c:pt>
                <c:pt idx="63">
                  <c:v>3126.79</c:v>
                </c:pt>
                <c:pt idx="64">
                  <c:v>2572.27</c:v>
                </c:pt>
                <c:pt idx="65">
                  <c:v>3356.44</c:v>
                </c:pt>
                <c:pt idx="66">
                  <c:v>2533.7199999999998</c:v>
                </c:pt>
                <c:pt idx="67">
                  <c:v>3099.15</c:v>
                </c:pt>
                <c:pt idx="68">
                  <c:v>3186.87</c:v>
                </c:pt>
                <c:pt idx="69">
                  <c:v>2839.64</c:v>
                </c:pt>
                <c:pt idx="70">
                  <c:v>3232.22</c:v>
                </c:pt>
                <c:pt idx="71">
                  <c:v>2892.46</c:v>
                </c:pt>
                <c:pt idx="72">
                  <c:v>2990.33</c:v>
                </c:pt>
                <c:pt idx="73">
                  <c:v>3288.82</c:v>
                </c:pt>
                <c:pt idx="74">
                  <c:v>3174.71</c:v>
                </c:pt>
                <c:pt idx="75">
                  <c:v>3203.14</c:v>
                </c:pt>
                <c:pt idx="76">
                  <c:v>3277.54</c:v>
                </c:pt>
                <c:pt idx="77">
                  <c:v>3271.34</c:v>
                </c:pt>
                <c:pt idx="78">
                  <c:v>3558.45</c:v>
                </c:pt>
                <c:pt idx="79">
                  <c:v>2956.01</c:v>
                </c:pt>
                <c:pt idx="80">
                  <c:v>3188.96</c:v>
                </c:pt>
                <c:pt idx="81">
                  <c:v>3600.95</c:v>
                </c:pt>
                <c:pt idx="82">
                  <c:v>3290.98</c:v>
                </c:pt>
                <c:pt idx="83">
                  <c:v>3161.99</c:v>
                </c:pt>
                <c:pt idx="84">
                  <c:v>3107.2</c:v>
                </c:pt>
                <c:pt idx="85">
                  <c:v>2899.17</c:v>
                </c:pt>
                <c:pt idx="86">
                  <c:v>3260.65</c:v>
                </c:pt>
                <c:pt idx="87">
                  <c:v>2745.78</c:v>
                </c:pt>
                <c:pt idx="88">
                  <c:v>3070.12</c:v>
                </c:pt>
                <c:pt idx="89">
                  <c:v>3274.48</c:v>
                </c:pt>
                <c:pt idx="90">
                  <c:v>3993.44</c:v>
                </c:pt>
                <c:pt idx="91">
                  <c:v>3376.71</c:v>
                </c:pt>
                <c:pt idx="92">
                  <c:v>2885.07</c:v>
                </c:pt>
                <c:pt idx="93">
                  <c:v>2785.75</c:v>
                </c:pt>
                <c:pt idx="94">
                  <c:v>2777.66</c:v>
                </c:pt>
                <c:pt idx="95">
                  <c:v>2670.28</c:v>
                </c:pt>
                <c:pt idx="96">
                  <c:v>2071.81</c:v>
                </c:pt>
                <c:pt idx="97">
                  <c:v>1815.7</c:v>
                </c:pt>
                <c:pt idx="98">
                  <c:v>1790.16</c:v>
                </c:pt>
                <c:pt idx="99">
                  <c:v>1273.36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72C-4668-B7E4-0D37F43594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3787848"/>
        <c:axId val="663786864"/>
      </c:lineChart>
      <c:catAx>
        <c:axId val="663787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63786864"/>
        <c:crosses val="autoZero"/>
        <c:auto val="1"/>
        <c:lblAlgn val="ctr"/>
        <c:lblOffset val="100"/>
        <c:noMultiLvlLbl val="0"/>
      </c:catAx>
      <c:valAx>
        <c:axId val="6637868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63787848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55106172560052169"/>
          <c:y val="0.19486111111111112"/>
          <c:w val="0.42421003842692145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GG-TSS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gg_TSS!$A$8</c:f>
              <c:strCache>
                <c:ptCount val="1"/>
                <c:pt idx="0">
                  <c:v>E108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gg_TSS!$B$7:$CW$7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SS!$B$8:$CW$8</c:f>
              <c:numCache>
                <c:formatCode>General</c:formatCode>
                <c:ptCount val="100"/>
                <c:pt idx="0">
                  <c:v>701.5</c:v>
                </c:pt>
                <c:pt idx="1">
                  <c:v>1996.92</c:v>
                </c:pt>
                <c:pt idx="2">
                  <c:v>1458.09</c:v>
                </c:pt>
                <c:pt idx="3">
                  <c:v>1735.1</c:v>
                </c:pt>
                <c:pt idx="4">
                  <c:v>1852.52</c:v>
                </c:pt>
                <c:pt idx="5">
                  <c:v>1774.79</c:v>
                </c:pt>
                <c:pt idx="6">
                  <c:v>1757.66</c:v>
                </c:pt>
                <c:pt idx="7">
                  <c:v>1701.23</c:v>
                </c:pt>
                <c:pt idx="8">
                  <c:v>1742.75</c:v>
                </c:pt>
                <c:pt idx="9">
                  <c:v>1370.86</c:v>
                </c:pt>
                <c:pt idx="10">
                  <c:v>1351.37</c:v>
                </c:pt>
                <c:pt idx="11">
                  <c:v>7260.9700000000203</c:v>
                </c:pt>
                <c:pt idx="12">
                  <c:v>1504.61</c:v>
                </c:pt>
                <c:pt idx="13">
                  <c:v>1713.43</c:v>
                </c:pt>
                <c:pt idx="14">
                  <c:v>1721.44</c:v>
                </c:pt>
                <c:pt idx="15">
                  <c:v>1370.06</c:v>
                </c:pt>
                <c:pt idx="16">
                  <c:v>1705.88</c:v>
                </c:pt>
                <c:pt idx="17">
                  <c:v>1425.23</c:v>
                </c:pt>
                <c:pt idx="18">
                  <c:v>1711.58</c:v>
                </c:pt>
                <c:pt idx="19">
                  <c:v>1710.38</c:v>
                </c:pt>
                <c:pt idx="20">
                  <c:v>1552.64</c:v>
                </c:pt>
                <c:pt idx="21">
                  <c:v>1330.81</c:v>
                </c:pt>
                <c:pt idx="22">
                  <c:v>1514.54</c:v>
                </c:pt>
                <c:pt idx="23">
                  <c:v>1651.35</c:v>
                </c:pt>
                <c:pt idx="24">
                  <c:v>1893.99</c:v>
                </c:pt>
                <c:pt idx="25">
                  <c:v>1317.5</c:v>
                </c:pt>
                <c:pt idx="26">
                  <c:v>1674.91</c:v>
                </c:pt>
                <c:pt idx="27">
                  <c:v>1358.7</c:v>
                </c:pt>
                <c:pt idx="28">
                  <c:v>1452.76</c:v>
                </c:pt>
                <c:pt idx="29">
                  <c:v>1634.14</c:v>
                </c:pt>
                <c:pt idx="30">
                  <c:v>1362.06</c:v>
                </c:pt>
                <c:pt idx="31">
                  <c:v>1578.92</c:v>
                </c:pt>
                <c:pt idx="32">
                  <c:v>1459.33</c:v>
                </c:pt>
                <c:pt idx="33">
                  <c:v>1975.6</c:v>
                </c:pt>
                <c:pt idx="34">
                  <c:v>1516.74</c:v>
                </c:pt>
                <c:pt idx="35">
                  <c:v>1400.14</c:v>
                </c:pt>
                <c:pt idx="36">
                  <c:v>1416.95</c:v>
                </c:pt>
                <c:pt idx="37">
                  <c:v>1480.58</c:v>
                </c:pt>
                <c:pt idx="38">
                  <c:v>1053.8499999999999</c:v>
                </c:pt>
                <c:pt idx="39">
                  <c:v>1396.02</c:v>
                </c:pt>
                <c:pt idx="40">
                  <c:v>1343.02</c:v>
                </c:pt>
                <c:pt idx="41">
                  <c:v>1477.19</c:v>
                </c:pt>
                <c:pt idx="42">
                  <c:v>1302.27</c:v>
                </c:pt>
                <c:pt idx="43">
                  <c:v>1553.77</c:v>
                </c:pt>
                <c:pt idx="44">
                  <c:v>1425</c:v>
                </c:pt>
                <c:pt idx="45">
                  <c:v>1194.46</c:v>
                </c:pt>
                <c:pt idx="46">
                  <c:v>1453.17</c:v>
                </c:pt>
                <c:pt idx="47">
                  <c:v>1049.28</c:v>
                </c:pt>
                <c:pt idx="48">
                  <c:v>1180.3399999999999</c:v>
                </c:pt>
                <c:pt idx="49">
                  <c:v>1442.11</c:v>
                </c:pt>
                <c:pt idx="50">
                  <c:v>1706.87</c:v>
                </c:pt>
                <c:pt idx="51">
                  <c:v>2795.59</c:v>
                </c:pt>
                <c:pt idx="52">
                  <c:v>2560.3700000000099</c:v>
                </c:pt>
                <c:pt idx="53">
                  <c:v>3154.42</c:v>
                </c:pt>
                <c:pt idx="54">
                  <c:v>2662.7800000000102</c:v>
                </c:pt>
                <c:pt idx="55">
                  <c:v>3418.87</c:v>
                </c:pt>
                <c:pt idx="56">
                  <c:v>3089.91</c:v>
                </c:pt>
                <c:pt idx="57">
                  <c:v>3081.01</c:v>
                </c:pt>
                <c:pt idx="58">
                  <c:v>7988.71000000003</c:v>
                </c:pt>
                <c:pt idx="59">
                  <c:v>3460.3700000000099</c:v>
                </c:pt>
                <c:pt idx="60">
                  <c:v>2598.85</c:v>
                </c:pt>
                <c:pt idx="61">
                  <c:v>2855.38</c:v>
                </c:pt>
                <c:pt idx="62">
                  <c:v>2679.35</c:v>
                </c:pt>
                <c:pt idx="63">
                  <c:v>2201.11</c:v>
                </c:pt>
                <c:pt idx="64">
                  <c:v>2218.3000000000002</c:v>
                </c:pt>
                <c:pt idx="65">
                  <c:v>2559.63</c:v>
                </c:pt>
                <c:pt idx="66">
                  <c:v>2766.5700000000102</c:v>
                </c:pt>
                <c:pt idx="67">
                  <c:v>2443.81</c:v>
                </c:pt>
                <c:pt idx="68">
                  <c:v>2304.6999999999998</c:v>
                </c:pt>
                <c:pt idx="69">
                  <c:v>2723.13</c:v>
                </c:pt>
                <c:pt idx="70">
                  <c:v>2942.5300000000102</c:v>
                </c:pt>
                <c:pt idx="71">
                  <c:v>2585.96000000001</c:v>
                </c:pt>
                <c:pt idx="72">
                  <c:v>2621.87</c:v>
                </c:pt>
                <c:pt idx="73">
                  <c:v>2840.4700000000098</c:v>
                </c:pt>
                <c:pt idx="74">
                  <c:v>3302.77</c:v>
                </c:pt>
                <c:pt idx="75">
                  <c:v>3253.5500000000102</c:v>
                </c:pt>
                <c:pt idx="76">
                  <c:v>3239.0800000000099</c:v>
                </c:pt>
                <c:pt idx="77">
                  <c:v>3248.97</c:v>
                </c:pt>
                <c:pt idx="78">
                  <c:v>3179.6</c:v>
                </c:pt>
                <c:pt idx="79">
                  <c:v>3176.64</c:v>
                </c:pt>
                <c:pt idx="80">
                  <c:v>2904.9300000000098</c:v>
                </c:pt>
                <c:pt idx="81">
                  <c:v>3595.78</c:v>
                </c:pt>
                <c:pt idx="82">
                  <c:v>3241.2</c:v>
                </c:pt>
                <c:pt idx="83">
                  <c:v>3672.21000000001</c:v>
                </c:pt>
                <c:pt idx="84">
                  <c:v>3375.85</c:v>
                </c:pt>
                <c:pt idx="85">
                  <c:v>3327.9200000000101</c:v>
                </c:pt>
                <c:pt idx="86">
                  <c:v>3089.41</c:v>
                </c:pt>
                <c:pt idx="87">
                  <c:v>3360.71000000001</c:v>
                </c:pt>
                <c:pt idx="88">
                  <c:v>3446.25000000001</c:v>
                </c:pt>
                <c:pt idx="89">
                  <c:v>3244.7800000000102</c:v>
                </c:pt>
                <c:pt idx="90">
                  <c:v>3403.27000000001</c:v>
                </c:pt>
                <c:pt idx="91">
                  <c:v>2783.75</c:v>
                </c:pt>
                <c:pt idx="92">
                  <c:v>3432.62</c:v>
                </c:pt>
                <c:pt idx="93">
                  <c:v>3200.52000000001</c:v>
                </c:pt>
                <c:pt idx="94">
                  <c:v>3187.65</c:v>
                </c:pt>
                <c:pt idx="95">
                  <c:v>2903.37</c:v>
                </c:pt>
                <c:pt idx="96">
                  <c:v>3571.3</c:v>
                </c:pt>
                <c:pt idx="97">
                  <c:v>3192.9300000000098</c:v>
                </c:pt>
                <c:pt idx="98">
                  <c:v>3215.37</c:v>
                </c:pt>
                <c:pt idx="99">
                  <c:v>3430.40000000001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E03-4FA3-ABC0-8E756FA8597B}"/>
            </c:ext>
          </c:extLst>
        </c:ser>
        <c:ser>
          <c:idx val="1"/>
          <c:order val="1"/>
          <c:tx>
            <c:strRef>
              <c:f>ccgg_TSS!$A$9</c:f>
              <c:strCache>
                <c:ptCount val="1"/>
                <c:pt idx="0">
                  <c:v>E108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gg_TSS!$B$7:$CW$7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SS!$B$9:$CW$9</c:f>
              <c:numCache>
                <c:formatCode>General</c:formatCode>
                <c:ptCount val="100"/>
                <c:pt idx="0">
                  <c:v>687.65</c:v>
                </c:pt>
                <c:pt idx="1">
                  <c:v>1667.26</c:v>
                </c:pt>
                <c:pt idx="2">
                  <c:v>1515.24</c:v>
                </c:pt>
                <c:pt idx="3">
                  <c:v>1690.16</c:v>
                </c:pt>
                <c:pt idx="4">
                  <c:v>1943.42</c:v>
                </c:pt>
                <c:pt idx="5">
                  <c:v>1811.69</c:v>
                </c:pt>
                <c:pt idx="6">
                  <c:v>1744.87</c:v>
                </c:pt>
                <c:pt idx="7">
                  <c:v>1613.65</c:v>
                </c:pt>
                <c:pt idx="8">
                  <c:v>1730.64</c:v>
                </c:pt>
                <c:pt idx="9">
                  <c:v>1344.95</c:v>
                </c:pt>
                <c:pt idx="10">
                  <c:v>1221.98</c:v>
                </c:pt>
                <c:pt idx="11">
                  <c:v>7430.5500000000102</c:v>
                </c:pt>
                <c:pt idx="12">
                  <c:v>1483.33</c:v>
                </c:pt>
                <c:pt idx="13">
                  <c:v>1539.5</c:v>
                </c:pt>
                <c:pt idx="14">
                  <c:v>1576.67</c:v>
                </c:pt>
                <c:pt idx="15">
                  <c:v>1190.33</c:v>
                </c:pt>
                <c:pt idx="16">
                  <c:v>1487.49</c:v>
                </c:pt>
                <c:pt idx="17">
                  <c:v>1345.67</c:v>
                </c:pt>
                <c:pt idx="18">
                  <c:v>1682.1</c:v>
                </c:pt>
                <c:pt idx="19">
                  <c:v>1707</c:v>
                </c:pt>
                <c:pt idx="20">
                  <c:v>1550.32</c:v>
                </c:pt>
                <c:pt idx="21">
                  <c:v>1364.57</c:v>
                </c:pt>
                <c:pt idx="22">
                  <c:v>1494.88</c:v>
                </c:pt>
                <c:pt idx="23">
                  <c:v>1613.84</c:v>
                </c:pt>
                <c:pt idx="24">
                  <c:v>1804.98</c:v>
                </c:pt>
                <c:pt idx="25">
                  <c:v>1286.21</c:v>
                </c:pt>
                <c:pt idx="26">
                  <c:v>1721.27</c:v>
                </c:pt>
                <c:pt idx="27">
                  <c:v>1409.77</c:v>
                </c:pt>
                <c:pt idx="28">
                  <c:v>1346.34</c:v>
                </c:pt>
                <c:pt idx="29">
                  <c:v>1729.35</c:v>
                </c:pt>
                <c:pt idx="30">
                  <c:v>1311.89</c:v>
                </c:pt>
                <c:pt idx="31">
                  <c:v>1543.6</c:v>
                </c:pt>
                <c:pt idx="32">
                  <c:v>1426.09</c:v>
                </c:pt>
                <c:pt idx="33">
                  <c:v>1936.64</c:v>
                </c:pt>
                <c:pt idx="34">
                  <c:v>1523.26</c:v>
                </c:pt>
                <c:pt idx="35">
                  <c:v>1326.75</c:v>
                </c:pt>
                <c:pt idx="36">
                  <c:v>1386.16</c:v>
                </c:pt>
                <c:pt idx="37">
                  <c:v>1407.9</c:v>
                </c:pt>
                <c:pt idx="38">
                  <c:v>1123.52</c:v>
                </c:pt>
                <c:pt idx="39">
                  <c:v>1329.51</c:v>
                </c:pt>
                <c:pt idx="40">
                  <c:v>1281.45</c:v>
                </c:pt>
                <c:pt idx="41">
                  <c:v>1537.51</c:v>
                </c:pt>
                <c:pt idx="42">
                  <c:v>1358.52</c:v>
                </c:pt>
                <c:pt idx="43">
                  <c:v>1643.49</c:v>
                </c:pt>
                <c:pt idx="44">
                  <c:v>1451.67</c:v>
                </c:pt>
                <c:pt idx="45">
                  <c:v>1178.81</c:v>
                </c:pt>
                <c:pt idx="46">
                  <c:v>1458.43</c:v>
                </c:pt>
                <c:pt idx="47">
                  <c:v>1076.44</c:v>
                </c:pt>
                <c:pt idx="48">
                  <c:v>1201.77</c:v>
                </c:pt>
                <c:pt idx="49">
                  <c:v>1383.47</c:v>
                </c:pt>
                <c:pt idx="50">
                  <c:v>1632.79</c:v>
                </c:pt>
                <c:pt idx="51">
                  <c:v>2826.24</c:v>
                </c:pt>
                <c:pt idx="52">
                  <c:v>2570.33</c:v>
                </c:pt>
                <c:pt idx="53">
                  <c:v>3503.87</c:v>
                </c:pt>
                <c:pt idx="54">
                  <c:v>2664.42</c:v>
                </c:pt>
                <c:pt idx="55">
                  <c:v>3322.05</c:v>
                </c:pt>
                <c:pt idx="56">
                  <c:v>3607.8099999999899</c:v>
                </c:pt>
                <c:pt idx="57">
                  <c:v>3170.22</c:v>
                </c:pt>
                <c:pt idx="58">
                  <c:v>6406.81</c:v>
                </c:pt>
                <c:pt idx="59">
                  <c:v>3392.34</c:v>
                </c:pt>
                <c:pt idx="60">
                  <c:v>2509.62</c:v>
                </c:pt>
                <c:pt idx="61">
                  <c:v>2911.47</c:v>
                </c:pt>
                <c:pt idx="62">
                  <c:v>2700.72</c:v>
                </c:pt>
                <c:pt idx="63">
                  <c:v>2128.64</c:v>
                </c:pt>
                <c:pt idx="64">
                  <c:v>2150.8200000000002</c:v>
                </c:pt>
                <c:pt idx="65">
                  <c:v>2470.2800000000002</c:v>
                </c:pt>
                <c:pt idx="66">
                  <c:v>2666.98</c:v>
                </c:pt>
                <c:pt idx="67">
                  <c:v>2327.86</c:v>
                </c:pt>
                <c:pt idx="68">
                  <c:v>2246.12</c:v>
                </c:pt>
                <c:pt idx="69">
                  <c:v>2644.02</c:v>
                </c:pt>
                <c:pt idx="70">
                  <c:v>2891.16</c:v>
                </c:pt>
                <c:pt idx="71">
                  <c:v>2466.14</c:v>
                </c:pt>
                <c:pt idx="72">
                  <c:v>2623.6</c:v>
                </c:pt>
                <c:pt idx="73">
                  <c:v>2879.73</c:v>
                </c:pt>
                <c:pt idx="74">
                  <c:v>3365.38</c:v>
                </c:pt>
                <c:pt idx="75">
                  <c:v>3062.68</c:v>
                </c:pt>
                <c:pt idx="76">
                  <c:v>3294.41</c:v>
                </c:pt>
                <c:pt idx="77">
                  <c:v>3398.4</c:v>
                </c:pt>
                <c:pt idx="78">
                  <c:v>2986.42</c:v>
                </c:pt>
                <c:pt idx="79">
                  <c:v>2966.1</c:v>
                </c:pt>
                <c:pt idx="80">
                  <c:v>2771.64</c:v>
                </c:pt>
                <c:pt idx="81">
                  <c:v>3231.5</c:v>
                </c:pt>
                <c:pt idx="82">
                  <c:v>3149.75</c:v>
                </c:pt>
                <c:pt idx="83">
                  <c:v>3785.37</c:v>
                </c:pt>
                <c:pt idx="84">
                  <c:v>3314.54</c:v>
                </c:pt>
                <c:pt idx="85">
                  <c:v>3328.85</c:v>
                </c:pt>
                <c:pt idx="86">
                  <c:v>2989.74</c:v>
                </c:pt>
                <c:pt idx="87">
                  <c:v>3329.25</c:v>
                </c:pt>
                <c:pt idx="88">
                  <c:v>3347.7</c:v>
                </c:pt>
                <c:pt idx="89">
                  <c:v>3223.44</c:v>
                </c:pt>
                <c:pt idx="90">
                  <c:v>3333.51</c:v>
                </c:pt>
                <c:pt idx="91">
                  <c:v>2662.87</c:v>
                </c:pt>
                <c:pt idx="92">
                  <c:v>3440.2</c:v>
                </c:pt>
                <c:pt idx="93">
                  <c:v>3236.99</c:v>
                </c:pt>
                <c:pt idx="94">
                  <c:v>2953.94</c:v>
                </c:pt>
                <c:pt idx="95">
                  <c:v>2708.76</c:v>
                </c:pt>
                <c:pt idx="96">
                  <c:v>3534.74</c:v>
                </c:pt>
                <c:pt idx="97">
                  <c:v>3126.13</c:v>
                </c:pt>
                <c:pt idx="98">
                  <c:v>3186.91</c:v>
                </c:pt>
                <c:pt idx="99">
                  <c:v>3494.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E03-4FA3-ABC0-8E756FA859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1368968"/>
        <c:axId val="641375200"/>
      </c:lineChart>
      <c:catAx>
        <c:axId val="641368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41375200"/>
        <c:crosses val="autoZero"/>
        <c:auto val="1"/>
        <c:lblAlgn val="ctr"/>
        <c:lblOffset val="100"/>
        <c:noMultiLvlLbl val="0"/>
      </c:catAx>
      <c:valAx>
        <c:axId val="64137520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41368968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58416789147047876"/>
          <c:y val="0.18483171968649148"/>
          <c:w val="0.36371529703153305"/>
          <c:h val="7.7801374413260599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GG-TTS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gg_TTS!$A$8</c:f>
              <c:strCache>
                <c:ptCount val="1"/>
                <c:pt idx="0">
                  <c:v>E108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gg_TTS!$B$7:$CW$7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TS!$B$8:$CW$8</c:f>
              <c:numCache>
                <c:formatCode>General</c:formatCode>
                <c:ptCount val="100"/>
                <c:pt idx="0">
                  <c:v>1193.76</c:v>
                </c:pt>
                <c:pt idx="1">
                  <c:v>3404.47</c:v>
                </c:pt>
                <c:pt idx="2">
                  <c:v>8410.9600000000191</c:v>
                </c:pt>
                <c:pt idx="3">
                  <c:v>2495.98</c:v>
                </c:pt>
                <c:pt idx="4">
                  <c:v>2940.28</c:v>
                </c:pt>
                <c:pt idx="5">
                  <c:v>3176.91</c:v>
                </c:pt>
                <c:pt idx="6">
                  <c:v>2909.18</c:v>
                </c:pt>
                <c:pt idx="7">
                  <c:v>2908.77</c:v>
                </c:pt>
                <c:pt idx="8">
                  <c:v>2310.12</c:v>
                </c:pt>
                <c:pt idx="9">
                  <c:v>2954.85</c:v>
                </c:pt>
                <c:pt idx="10">
                  <c:v>3034.05</c:v>
                </c:pt>
                <c:pt idx="11">
                  <c:v>3138.41</c:v>
                </c:pt>
                <c:pt idx="12">
                  <c:v>2517.4899999999998</c:v>
                </c:pt>
                <c:pt idx="13">
                  <c:v>2870.22</c:v>
                </c:pt>
                <c:pt idx="14">
                  <c:v>2974.2000000000098</c:v>
                </c:pt>
                <c:pt idx="15">
                  <c:v>2943.35</c:v>
                </c:pt>
                <c:pt idx="16">
                  <c:v>2773.0900000000101</c:v>
                </c:pt>
                <c:pt idx="17">
                  <c:v>3124.08</c:v>
                </c:pt>
                <c:pt idx="18">
                  <c:v>3428.03</c:v>
                </c:pt>
                <c:pt idx="19">
                  <c:v>2539.29</c:v>
                </c:pt>
                <c:pt idx="20">
                  <c:v>3219.24</c:v>
                </c:pt>
                <c:pt idx="21">
                  <c:v>3056.95</c:v>
                </c:pt>
                <c:pt idx="22">
                  <c:v>2778.02</c:v>
                </c:pt>
                <c:pt idx="23">
                  <c:v>3029.41</c:v>
                </c:pt>
                <c:pt idx="24">
                  <c:v>2731.0700000000102</c:v>
                </c:pt>
                <c:pt idx="25">
                  <c:v>2973.55</c:v>
                </c:pt>
                <c:pt idx="26">
                  <c:v>3157.58</c:v>
                </c:pt>
                <c:pt idx="27">
                  <c:v>3046.07</c:v>
                </c:pt>
                <c:pt idx="28">
                  <c:v>3042.15</c:v>
                </c:pt>
                <c:pt idx="29">
                  <c:v>3241.29</c:v>
                </c:pt>
                <c:pt idx="30">
                  <c:v>3073.32</c:v>
                </c:pt>
                <c:pt idx="31">
                  <c:v>3587.6300000000101</c:v>
                </c:pt>
                <c:pt idx="32">
                  <c:v>3562.02000000001</c:v>
                </c:pt>
                <c:pt idx="33">
                  <c:v>3760.31</c:v>
                </c:pt>
                <c:pt idx="34">
                  <c:v>3248.58</c:v>
                </c:pt>
                <c:pt idx="35">
                  <c:v>4574.6400000000103</c:v>
                </c:pt>
                <c:pt idx="36">
                  <c:v>3785.50000000001</c:v>
                </c:pt>
                <c:pt idx="37">
                  <c:v>3624.3100000000099</c:v>
                </c:pt>
                <c:pt idx="38">
                  <c:v>4050.6800000000098</c:v>
                </c:pt>
                <c:pt idx="39">
                  <c:v>3937.6400000000099</c:v>
                </c:pt>
                <c:pt idx="40">
                  <c:v>3332.73000000001</c:v>
                </c:pt>
                <c:pt idx="41">
                  <c:v>3658.91</c:v>
                </c:pt>
                <c:pt idx="42">
                  <c:v>3726.7600000000102</c:v>
                </c:pt>
                <c:pt idx="43">
                  <c:v>4151.55</c:v>
                </c:pt>
                <c:pt idx="44">
                  <c:v>3166.29</c:v>
                </c:pt>
                <c:pt idx="45">
                  <c:v>3129.32</c:v>
                </c:pt>
                <c:pt idx="46">
                  <c:v>2378.21000000001</c:v>
                </c:pt>
                <c:pt idx="47">
                  <c:v>2402.9899999999998</c:v>
                </c:pt>
                <c:pt idx="48">
                  <c:v>2688.06</c:v>
                </c:pt>
                <c:pt idx="49">
                  <c:v>2823.7600000000102</c:v>
                </c:pt>
                <c:pt idx="50">
                  <c:v>3124.37</c:v>
                </c:pt>
                <c:pt idx="51">
                  <c:v>1389.17</c:v>
                </c:pt>
                <c:pt idx="52">
                  <c:v>1415.53</c:v>
                </c:pt>
                <c:pt idx="53">
                  <c:v>1304.95</c:v>
                </c:pt>
                <c:pt idx="54">
                  <c:v>1515.72</c:v>
                </c:pt>
                <c:pt idx="55">
                  <c:v>1270.24</c:v>
                </c:pt>
                <c:pt idx="56">
                  <c:v>1451.25</c:v>
                </c:pt>
                <c:pt idx="57">
                  <c:v>1317.83</c:v>
                </c:pt>
                <c:pt idx="58">
                  <c:v>1278.26</c:v>
                </c:pt>
                <c:pt idx="59">
                  <c:v>1438.73</c:v>
                </c:pt>
                <c:pt idx="60">
                  <c:v>1530.5</c:v>
                </c:pt>
                <c:pt idx="61">
                  <c:v>1253.99</c:v>
                </c:pt>
                <c:pt idx="62">
                  <c:v>1308.76</c:v>
                </c:pt>
                <c:pt idx="63">
                  <c:v>1176.55</c:v>
                </c:pt>
                <c:pt idx="64">
                  <c:v>1722.55</c:v>
                </c:pt>
                <c:pt idx="65">
                  <c:v>1694.4</c:v>
                </c:pt>
                <c:pt idx="66">
                  <c:v>1357.9</c:v>
                </c:pt>
                <c:pt idx="67">
                  <c:v>1903.95</c:v>
                </c:pt>
                <c:pt idx="68">
                  <c:v>1528.98</c:v>
                </c:pt>
                <c:pt idx="69">
                  <c:v>1607.14</c:v>
                </c:pt>
                <c:pt idx="70">
                  <c:v>1336.6</c:v>
                </c:pt>
                <c:pt idx="71">
                  <c:v>1526.49</c:v>
                </c:pt>
                <c:pt idx="72">
                  <c:v>1445.51</c:v>
                </c:pt>
                <c:pt idx="73">
                  <c:v>1695.19</c:v>
                </c:pt>
                <c:pt idx="74">
                  <c:v>1533.22</c:v>
                </c:pt>
                <c:pt idx="75">
                  <c:v>1485.56</c:v>
                </c:pt>
                <c:pt idx="76">
                  <c:v>1974.05</c:v>
                </c:pt>
                <c:pt idx="77">
                  <c:v>1575.58</c:v>
                </c:pt>
                <c:pt idx="78">
                  <c:v>2017.14</c:v>
                </c:pt>
                <c:pt idx="79">
                  <c:v>1698.51</c:v>
                </c:pt>
                <c:pt idx="80">
                  <c:v>1469.17</c:v>
                </c:pt>
                <c:pt idx="81">
                  <c:v>1765.63</c:v>
                </c:pt>
                <c:pt idx="82">
                  <c:v>1771.85</c:v>
                </c:pt>
                <c:pt idx="83">
                  <c:v>1318.3</c:v>
                </c:pt>
                <c:pt idx="84">
                  <c:v>1790.37</c:v>
                </c:pt>
                <c:pt idx="85">
                  <c:v>1496.22</c:v>
                </c:pt>
                <c:pt idx="86">
                  <c:v>1546.84</c:v>
                </c:pt>
                <c:pt idx="87">
                  <c:v>1752.29</c:v>
                </c:pt>
                <c:pt idx="88">
                  <c:v>1457.71</c:v>
                </c:pt>
                <c:pt idx="89">
                  <c:v>1353.41</c:v>
                </c:pt>
                <c:pt idx="90">
                  <c:v>1911.56</c:v>
                </c:pt>
                <c:pt idx="91">
                  <c:v>1740.47</c:v>
                </c:pt>
                <c:pt idx="92">
                  <c:v>1767.17</c:v>
                </c:pt>
                <c:pt idx="93">
                  <c:v>2011.47</c:v>
                </c:pt>
                <c:pt idx="94">
                  <c:v>1877.24</c:v>
                </c:pt>
                <c:pt idx="95">
                  <c:v>1601.38</c:v>
                </c:pt>
                <c:pt idx="96">
                  <c:v>1671.55</c:v>
                </c:pt>
                <c:pt idx="97">
                  <c:v>1645.99</c:v>
                </c:pt>
                <c:pt idx="98">
                  <c:v>5573.7700000000204</c:v>
                </c:pt>
                <c:pt idx="99">
                  <c:v>1963.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29E-488E-B0B7-995D50D66EBA}"/>
            </c:ext>
          </c:extLst>
        </c:ser>
        <c:ser>
          <c:idx val="1"/>
          <c:order val="1"/>
          <c:tx>
            <c:strRef>
              <c:f>ccgg_TTS!$A$9</c:f>
              <c:strCache>
                <c:ptCount val="1"/>
                <c:pt idx="0">
                  <c:v>E108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gg_TTS!$B$7:$CW$7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TS!$B$9:$CW$9</c:f>
              <c:numCache>
                <c:formatCode>General</c:formatCode>
                <c:ptCount val="100"/>
                <c:pt idx="0">
                  <c:v>1226.01</c:v>
                </c:pt>
                <c:pt idx="1">
                  <c:v>3250.42</c:v>
                </c:pt>
                <c:pt idx="2">
                  <c:v>9017.8800000000192</c:v>
                </c:pt>
                <c:pt idx="3">
                  <c:v>2405.29</c:v>
                </c:pt>
                <c:pt idx="4">
                  <c:v>3003.95</c:v>
                </c:pt>
                <c:pt idx="5">
                  <c:v>2938.42</c:v>
                </c:pt>
                <c:pt idx="6">
                  <c:v>2764.19</c:v>
                </c:pt>
                <c:pt idx="7">
                  <c:v>2742.54</c:v>
                </c:pt>
                <c:pt idx="8">
                  <c:v>2175.85</c:v>
                </c:pt>
                <c:pt idx="9">
                  <c:v>2868.77</c:v>
                </c:pt>
                <c:pt idx="10">
                  <c:v>2970.81</c:v>
                </c:pt>
                <c:pt idx="11">
                  <c:v>3100.57</c:v>
                </c:pt>
                <c:pt idx="12">
                  <c:v>2329.89</c:v>
                </c:pt>
                <c:pt idx="13">
                  <c:v>2807.99</c:v>
                </c:pt>
                <c:pt idx="14">
                  <c:v>2970.1999999999898</c:v>
                </c:pt>
                <c:pt idx="15">
                  <c:v>2872.2</c:v>
                </c:pt>
                <c:pt idx="16">
                  <c:v>2733.14</c:v>
                </c:pt>
                <c:pt idx="17">
                  <c:v>3153.24</c:v>
                </c:pt>
                <c:pt idx="18">
                  <c:v>3434.87</c:v>
                </c:pt>
                <c:pt idx="19">
                  <c:v>2386.5100000000002</c:v>
                </c:pt>
                <c:pt idx="20">
                  <c:v>3376.83</c:v>
                </c:pt>
                <c:pt idx="21">
                  <c:v>3026.04</c:v>
                </c:pt>
                <c:pt idx="22">
                  <c:v>2736.47</c:v>
                </c:pt>
                <c:pt idx="23">
                  <c:v>3086.98</c:v>
                </c:pt>
                <c:pt idx="24">
                  <c:v>2753.36</c:v>
                </c:pt>
                <c:pt idx="25">
                  <c:v>2737.73</c:v>
                </c:pt>
                <c:pt idx="26">
                  <c:v>3046.53</c:v>
                </c:pt>
                <c:pt idx="27">
                  <c:v>2927.61</c:v>
                </c:pt>
                <c:pt idx="28">
                  <c:v>2889.68</c:v>
                </c:pt>
                <c:pt idx="29">
                  <c:v>3328.94</c:v>
                </c:pt>
                <c:pt idx="30">
                  <c:v>3055.27</c:v>
                </c:pt>
                <c:pt idx="31">
                  <c:v>3607.71</c:v>
                </c:pt>
                <c:pt idx="32">
                  <c:v>3681.37</c:v>
                </c:pt>
                <c:pt idx="33">
                  <c:v>3600.4</c:v>
                </c:pt>
                <c:pt idx="34">
                  <c:v>3297.14</c:v>
                </c:pt>
                <c:pt idx="35">
                  <c:v>4645.3199999999897</c:v>
                </c:pt>
                <c:pt idx="36">
                  <c:v>3804.43</c:v>
                </c:pt>
                <c:pt idx="37">
                  <c:v>3593.7399999999898</c:v>
                </c:pt>
                <c:pt idx="38">
                  <c:v>3848.97</c:v>
                </c:pt>
                <c:pt idx="39">
                  <c:v>3923.89</c:v>
                </c:pt>
                <c:pt idx="40">
                  <c:v>3487.59</c:v>
                </c:pt>
                <c:pt idx="41">
                  <c:v>3852.37</c:v>
                </c:pt>
                <c:pt idx="42">
                  <c:v>3967.74</c:v>
                </c:pt>
                <c:pt idx="43">
                  <c:v>4182.74</c:v>
                </c:pt>
                <c:pt idx="44">
                  <c:v>3204.59</c:v>
                </c:pt>
                <c:pt idx="45">
                  <c:v>3030.98</c:v>
                </c:pt>
                <c:pt idx="46">
                  <c:v>2396.12</c:v>
                </c:pt>
                <c:pt idx="47">
                  <c:v>2365.12</c:v>
                </c:pt>
                <c:pt idx="48">
                  <c:v>2636.56</c:v>
                </c:pt>
                <c:pt idx="49">
                  <c:v>2831.05</c:v>
                </c:pt>
                <c:pt idx="50">
                  <c:v>2895.92</c:v>
                </c:pt>
                <c:pt idx="51">
                  <c:v>1413.88</c:v>
                </c:pt>
                <c:pt idx="52">
                  <c:v>1390.24</c:v>
                </c:pt>
                <c:pt idx="53">
                  <c:v>1313.32</c:v>
                </c:pt>
                <c:pt idx="54">
                  <c:v>1556.45</c:v>
                </c:pt>
                <c:pt idx="55">
                  <c:v>1227.51</c:v>
                </c:pt>
                <c:pt idx="56">
                  <c:v>1389.56</c:v>
                </c:pt>
                <c:pt idx="57">
                  <c:v>1260.56</c:v>
                </c:pt>
                <c:pt idx="58">
                  <c:v>1278.77</c:v>
                </c:pt>
                <c:pt idx="59">
                  <c:v>1403.74</c:v>
                </c:pt>
                <c:pt idx="60">
                  <c:v>1687.42</c:v>
                </c:pt>
                <c:pt idx="61">
                  <c:v>1186.8399999999999</c:v>
                </c:pt>
                <c:pt idx="62">
                  <c:v>1322.64</c:v>
                </c:pt>
                <c:pt idx="63">
                  <c:v>1061.33</c:v>
                </c:pt>
                <c:pt idx="64">
                  <c:v>1669.93</c:v>
                </c:pt>
                <c:pt idx="65">
                  <c:v>1602.3</c:v>
                </c:pt>
                <c:pt idx="66">
                  <c:v>1351.74</c:v>
                </c:pt>
                <c:pt idx="67">
                  <c:v>2181.21</c:v>
                </c:pt>
                <c:pt idx="68">
                  <c:v>1548.88</c:v>
                </c:pt>
                <c:pt idx="69">
                  <c:v>1556.37</c:v>
                </c:pt>
                <c:pt idx="70">
                  <c:v>1126.8399999999999</c:v>
                </c:pt>
                <c:pt idx="71">
                  <c:v>1469.23</c:v>
                </c:pt>
                <c:pt idx="72">
                  <c:v>1495.6</c:v>
                </c:pt>
                <c:pt idx="73">
                  <c:v>1671.2</c:v>
                </c:pt>
                <c:pt idx="74">
                  <c:v>1500.31</c:v>
                </c:pt>
                <c:pt idx="75">
                  <c:v>1334.87</c:v>
                </c:pt>
                <c:pt idx="76">
                  <c:v>1931.25</c:v>
                </c:pt>
                <c:pt idx="77">
                  <c:v>1565.82</c:v>
                </c:pt>
                <c:pt idx="78">
                  <c:v>1970.44</c:v>
                </c:pt>
                <c:pt idx="79">
                  <c:v>1611.15</c:v>
                </c:pt>
                <c:pt idx="80">
                  <c:v>1442.17</c:v>
                </c:pt>
                <c:pt idx="81">
                  <c:v>1740.78</c:v>
                </c:pt>
                <c:pt idx="82">
                  <c:v>1900.17</c:v>
                </c:pt>
                <c:pt idx="83">
                  <c:v>1252.3699999999999</c:v>
                </c:pt>
                <c:pt idx="84">
                  <c:v>1842.78</c:v>
                </c:pt>
                <c:pt idx="85">
                  <c:v>1397.65</c:v>
                </c:pt>
                <c:pt idx="86">
                  <c:v>1528.8</c:v>
                </c:pt>
                <c:pt idx="87">
                  <c:v>1600.34</c:v>
                </c:pt>
                <c:pt idx="88">
                  <c:v>1396.99</c:v>
                </c:pt>
                <c:pt idx="89">
                  <c:v>1288.26</c:v>
                </c:pt>
                <c:pt idx="90">
                  <c:v>1863.81</c:v>
                </c:pt>
                <c:pt idx="91">
                  <c:v>1669.87</c:v>
                </c:pt>
                <c:pt idx="92">
                  <c:v>1717.84</c:v>
                </c:pt>
                <c:pt idx="93">
                  <c:v>1866.47</c:v>
                </c:pt>
                <c:pt idx="94">
                  <c:v>1704.35</c:v>
                </c:pt>
                <c:pt idx="95">
                  <c:v>1520.61</c:v>
                </c:pt>
                <c:pt idx="96">
                  <c:v>1573.97</c:v>
                </c:pt>
                <c:pt idx="97">
                  <c:v>1768.49</c:v>
                </c:pt>
                <c:pt idx="98">
                  <c:v>4156.0299999999897</c:v>
                </c:pt>
                <c:pt idx="99">
                  <c:v>1989.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29E-488E-B0B7-995D50D66E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1381432"/>
        <c:axId val="641381760"/>
      </c:lineChart>
      <c:catAx>
        <c:axId val="6413814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41381760"/>
        <c:crosses val="autoZero"/>
        <c:auto val="1"/>
        <c:lblAlgn val="ctr"/>
        <c:lblOffset val="100"/>
        <c:noMultiLvlLbl val="0"/>
      </c:catAx>
      <c:valAx>
        <c:axId val="64138176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41381432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58793063914084553"/>
          <c:y val="0.19351724137931034"/>
          <c:w val="0.3650005100952487"/>
          <c:h val="7.7586749932120558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WGG-TSS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wgg_TSS!$A$8</c:f>
              <c:strCache>
                <c:ptCount val="1"/>
                <c:pt idx="0">
                  <c:v>E108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wgg_TSS!$B$7:$CW$7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SS!$B$8:$CW$8</c:f>
              <c:numCache>
                <c:formatCode>General</c:formatCode>
                <c:ptCount val="100"/>
                <c:pt idx="0">
                  <c:v>555.03</c:v>
                </c:pt>
                <c:pt idx="1">
                  <c:v>1278.06</c:v>
                </c:pt>
                <c:pt idx="2">
                  <c:v>1190.47</c:v>
                </c:pt>
                <c:pt idx="3">
                  <c:v>1370.54</c:v>
                </c:pt>
                <c:pt idx="4">
                  <c:v>1212.96</c:v>
                </c:pt>
                <c:pt idx="5">
                  <c:v>1721.55</c:v>
                </c:pt>
                <c:pt idx="6">
                  <c:v>1296.24</c:v>
                </c:pt>
                <c:pt idx="7">
                  <c:v>1277.28</c:v>
                </c:pt>
                <c:pt idx="8">
                  <c:v>1241.31</c:v>
                </c:pt>
                <c:pt idx="9">
                  <c:v>1303.01</c:v>
                </c:pt>
                <c:pt idx="10">
                  <c:v>1183.97</c:v>
                </c:pt>
                <c:pt idx="11">
                  <c:v>1805.71</c:v>
                </c:pt>
                <c:pt idx="12">
                  <c:v>1247.77</c:v>
                </c:pt>
                <c:pt idx="13">
                  <c:v>1045</c:v>
                </c:pt>
                <c:pt idx="14">
                  <c:v>954.89</c:v>
                </c:pt>
                <c:pt idx="15">
                  <c:v>1438.87</c:v>
                </c:pt>
                <c:pt idx="16">
                  <c:v>1196.53</c:v>
                </c:pt>
                <c:pt idx="17">
                  <c:v>1178.26</c:v>
                </c:pt>
                <c:pt idx="18">
                  <c:v>1278.42</c:v>
                </c:pt>
                <c:pt idx="19">
                  <c:v>1243.26</c:v>
                </c:pt>
                <c:pt idx="20">
                  <c:v>1354.38</c:v>
                </c:pt>
                <c:pt idx="21">
                  <c:v>1306.32</c:v>
                </c:pt>
                <c:pt idx="22">
                  <c:v>963.39</c:v>
                </c:pt>
                <c:pt idx="23">
                  <c:v>1210.94</c:v>
                </c:pt>
                <c:pt idx="24">
                  <c:v>1408.14</c:v>
                </c:pt>
                <c:pt idx="25">
                  <c:v>1029.6500000000001</c:v>
                </c:pt>
                <c:pt idx="26">
                  <c:v>1240.56</c:v>
                </c:pt>
                <c:pt idx="27">
                  <c:v>1126.55</c:v>
                </c:pt>
                <c:pt idx="28">
                  <c:v>1289.3499999999999</c:v>
                </c:pt>
                <c:pt idx="29">
                  <c:v>1157.6300000000001</c:v>
                </c:pt>
                <c:pt idx="30">
                  <c:v>1514.73</c:v>
                </c:pt>
                <c:pt idx="31">
                  <c:v>1361.67</c:v>
                </c:pt>
                <c:pt idx="32">
                  <c:v>1460.68</c:v>
                </c:pt>
                <c:pt idx="33">
                  <c:v>1419.43</c:v>
                </c:pt>
                <c:pt idx="34">
                  <c:v>1217.82</c:v>
                </c:pt>
                <c:pt idx="35">
                  <c:v>953.65999999999894</c:v>
                </c:pt>
                <c:pt idx="36">
                  <c:v>1057.8800000000001</c:v>
                </c:pt>
                <c:pt idx="37">
                  <c:v>1488.87</c:v>
                </c:pt>
                <c:pt idx="38">
                  <c:v>1285.6600000000001</c:v>
                </c:pt>
                <c:pt idx="39">
                  <c:v>1353.13</c:v>
                </c:pt>
                <c:pt idx="40">
                  <c:v>1086.1400000000001</c:v>
                </c:pt>
                <c:pt idx="41">
                  <c:v>994.479999999999</c:v>
                </c:pt>
                <c:pt idx="42">
                  <c:v>1503.85</c:v>
                </c:pt>
                <c:pt idx="43">
                  <c:v>1245.33</c:v>
                </c:pt>
                <c:pt idx="44">
                  <c:v>1416.2</c:v>
                </c:pt>
                <c:pt idx="45">
                  <c:v>1407.33</c:v>
                </c:pt>
                <c:pt idx="46">
                  <c:v>1592.75</c:v>
                </c:pt>
                <c:pt idx="47">
                  <c:v>1500.24</c:v>
                </c:pt>
                <c:pt idx="48">
                  <c:v>1346.34</c:v>
                </c:pt>
                <c:pt idx="49">
                  <c:v>1181.94</c:v>
                </c:pt>
                <c:pt idx="50">
                  <c:v>1684.06</c:v>
                </c:pt>
                <c:pt idx="51">
                  <c:v>2371.5300000000002</c:v>
                </c:pt>
                <c:pt idx="52">
                  <c:v>2459.96</c:v>
                </c:pt>
                <c:pt idx="53">
                  <c:v>2155.7800000000002</c:v>
                </c:pt>
                <c:pt idx="54">
                  <c:v>2115.4299999999998</c:v>
                </c:pt>
                <c:pt idx="55">
                  <c:v>1736.47</c:v>
                </c:pt>
                <c:pt idx="56">
                  <c:v>1772.69</c:v>
                </c:pt>
                <c:pt idx="57">
                  <c:v>1508.7</c:v>
                </c:pt>
                <c:pt idx="58">
                  <c:v>1721.94</c:v>
                </c:pt>
                <c:pt idx="59">
                  <c:v>1910.18</c:v>
                </c:pt>
                <c:pt idx="60">
                  <c:v>1886.87</c:v>
                </c:pt>
                <c:pt idx="61">
                  <c:v>1462.13</c:v>
                </c:pt>
                <c:pt idx="62">
                  <c:v>1465.85</c:v>
                </c:pt>
                <c:pt idx="63">
                  <c:v>1460.67</c:v>
                </c:pt>
                <c:pt idx="64">
                  <c:v>1611.67</c:v>
                </c:pt>
                <c:pt idx="65">
                  <c:v>1711.75</c:v>
                </c:pt>
                <c:pt idx="66">
                  <c:v>1642.37</c:v>
                </c:pt>
                <c:pt idx="67">
                  <c:v>1417.38</c:v>
                </c:pt>
                <c:pt idx="68">
                  <c:v>1824.49</c:v>
                </c:pt>
                <c:pt idx="69">
                  <c:v>1373.39</c:v>
                </c:pt>
                <c:pt idx="70">
                  <c:v>1677.55</c:v>
                </c:pt>
                <c:pt idx="71">
                  <c:v>1448.85</c:v>
                </c:pt>
                <c:pt idx="72">
                  <c:v>1709.39</c:v>
                </c:pt>
                <c:pt idx="73">
                  <c:v>1543.03</c:v>
                </c:pt>
                <c:pt idx="74">
                  <c:v>1601.93</c:v>
                </c:pt>
                <c:pt idx="75">
                  <c:v>1428.67</c:v>
                </c:pt>
                <c:pt idx="76">
                  <c:v>1413.35</c:v>
                </c:pt>
                <c:pt idx="77">
                  <c:v>1520.37</c:v>
                </c:pt>
                <c:pt idx="78">
                  <c:v>1304.6400000000001</c:v>
                </c:pt>
                <c:pt idx="79">
                  <c:v>1649.16</c:v>
                </c:pt>
                <c:pt idx="80">
                  <c:v>1542.55</c:v>
                </c:pt>
                <c:pt idx="81">
                  <c:v>1253.81</c:v>
                </c:pt>
                <c:pt idx="82">
                  <c:v>1794.23</c:v>
                </c:pt>
                <c:pt idx="83">
                  <c:v>1332.11</c:v>
                </c:pt>
                <c:pt idx="84">
                  <c:v>1628.97</c:v>
                </c:pt>
                <c:pt idx="85">
                  <c:v>1366.06</c:v>
                </c:pt>
                <c:pt idx="86">
                  <c:v>1383.82</c:v>
                </c:pt>
                <c:pt idx="87">
                  <c:v>1267.0999999999999</c:v>
                </c:pt>
                <c:pt idx="88">
                  <c:v>1411.64</c:v>
                </c:pt>
                <c:pt idx="89">
                  <c:v>1456.61</c:v>
                </c:pt>
                <c:pt idx="90">
                  <c:v>1533.71</c:v>
                </c:pt>
                <c:pt idx="91">
                  <c:v>1329.33</c:v>
                </c:pt>
                <c:pt idx="92">
                  <c:v>1391.96</c:v>
                </c:pt>
                <c:pt idx="93">
                  <c:v>1329.6</c:v>
                </c:pt>
                <c:pt idx="94">
                  <c:v>1652.48</c:v>
                </c:pt>
                <c:pt idx="95">
                  <c:v>1603.58</c:v>
                </c:pt>
                <c:pt idx="96">
                  <c:v>1228.21</c:v>
                </c:pt>
                <c:pt idx="97">
                  <c:v>1511.44</c:v>
                </c:pt>
                <c:pt idx="98">
                  <c:v>1138.98</c:v>
                </c:pt>
                <c:pt idx="99">
                  <c:v>1840.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ED4-4BD6-8C2F-821500761CF2}"/>
            </c:ext>
          </c:extLst>
        </c:ser>
        <c:ser>
          <c:idx val="1"/>
          <c:order val="1"/>
          <c:tx>
            <c:strRef>
              <c:f>ccwgg_TSS!$A$9</c:f>
              <c:strCache>
                <c:ptCount val="1"/>
                <c:pt idx="0">
                  <c:v>E108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wgg_TSS!$B$7:$CW$7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SS!$B$9:$CW$9</c:f>
              <c:numCache>
                <c:formatCode>General</c:formatCode>
                <c:ptCount val="100"/>
                <c:pt idx="0">
                  <c:v>505.15</c:v>
                </c:pt>
                <c:pt idx="1">
                  <c:v>1218.32</c:v>
                </c:pt>
                <c:pt idx="2">
                  <c:v>1169.99</c:v>
                </c:pt>
                <c:pt idx="3">
                  <c:v>1394.72</c:v>
                </c:pt>
                <c:pt idx="4">
                  <c:v>1122.27</c:v>
                </c:pt>
                <c:pt idx="5">
                  <c:v>1674.49</c:v>
                </c:pt>
                <c:pt idx="6">
                  <c:v>1292</c:v>
                </c:pt>
                <c:pt idx="7">
                  <c:v>1255.8699999999999</c:v>
                </c:pt>
                <c:pt idx="8">
                  <c:v>1208.8499999999999</c:v>
                </c:pt>
                <c:pt idx="9">
                  <c:v>1277.99</c:v>
                </c:pt>
                <c:pt idx="10">
                  <c:v>1104.1400000000001</c:v>
                </c:pt>
                <c:pt idx="11">
                  <c:v>1926.77</c:v>
                </c:pt>
                <c:pt idx="12">
                  <c:v>1226.29</c:v>
                </c:pt>
                <c:pt idx="13">
                  <c:v>1029.06</c:v>
                </c:pt>
                <c:pt idx="14">
                  <c:v>962.68999999999903</c:v>
                </c:pt>
                <c:pt idx="15">
                  <c:v>1411.5</c:v>
                </c:pt>
                <c:pt idx="16">
                  <c:v>1186.0899999999999</c:v>
                </c:pt>
                <c:pt idx="17">
                  <c:v>1195.45</c:v>
                </c:pt>
                <c:pt idx="18">
                  <c:v>1210.99</c:v>
                </c:pt>
                <c:pt idx="19">
                  <c:v>1227.01</c:v>
                </c:pt>
                <c:pt idx="20">
                  <c:v>1336.35</c:v>
                </c:pt>
                <c:pt idx="21">
                  <c:v>1175.97</c:v>
                </c:pt>
                <c:pt idx="22">
                  <c:v>984.11</c:v>
                </c:pt>
                <c:pt idx="23">
                  <c:v>1198.17</c:v>
                </c:pt>
                <c:pt idx="24">
                  <c:v>1301.47</c:v>
                </c:pt>
                <c:pt idx="25">
                  <c:v>1111.6199999999999</c:v>
                </c:pt>
                <c:pt idx="26">
                  <c:v>1382.68</c:v>
                </c:pt>
                <c:pt idx="27">
                  <c:v>1164.6199999999999</c:v>
                </c:pt>
                <c:pt idx="28">
                  <c:v>1247.8</c:v>
                </c:pt>
                <c:pt idx="29">
                  <c:v>1147.18</c:v>
                </c:pt>
                <c:pt idx="30">
                  <c:v>1437.67</c:v>
                </c:pt>
                <c:pt idx="31">
                  <c:v>1360.51</c:v>
                </c:pt>
                <c:pt idx="32">
                  <c:v>1478.62</c:v>
                </c:pt>
                <c:pt idx="33">
                  <c:v>1412.19</c:v>
                </c:pt>
                <c:pt idx="34">
                  <c:v>1176.6600000000001</c:v>
                </c:pt>
                <c:pt idx="35">
                  <c:v>937.84</c:v>
                </c:pt>
                <c:pt idx="36">
                  <c:v>1084.07</c:v>
                </c:pt>
                <c:pt idx="37">
                  <c:v>1562.42</c:v>
                </c:pt>
                <c:pt idx="38">
                  <c:v>1216.92</c:v>
                </c:pt>
                <c:pt idx="39">
                  <c:v>1277.9100000000001</c:v>
                </c:pt>
                <c:pt idx="40">
                  <c:v>1082.0899999999999</c:v>
                </c:pt>
                <c:pt idx="41">
                  <c:v>936.49999999999898</c:v>
                </c:pt>
                <c:pt idx="42">
                  <c:v>1513.49</c:v>
                </c:pt>
                <c:pt idx="43">
                  <c:v>1298.1300000000001</c:v>
                </c:pt>
                <c:pt idx="44">
                  <c:v>1519.55</c:v>
                </c:pt>
                <c:pt idx="45">
                  <c:v>1354.47</c:v>
                </c:pt>
                <c:pt idx="46">
                  <c:v>1506.14</c:v>
                </c:pt>
                <c:pt idx="47">
                  <c:v>1442.38</c:v>
                </c:pt>
                <c:pt idx="48">
                  <c:v>1442.36</c:v>
                </c:pt>
                <c:pt idx="49">
                  <c:v>1202.22</c:v>
                </c:pt>
                <c:pt idx="50">
                  <c:v>1730.83</c:v>
                </c:pt>
                <c:pt idx="51">
                  <c:v>2514.48</c:v>
                </c:pt>
                <c:pt idx="52">
                  <c:v>2517.7800000000002</c:v>
                </c:pt>
                <c:pt idx="53">
                  <c:v>2258.79</c:v>
                </c:pt>
                <c:pt idx="54">
                  <c:v>2122.54</c:v>
                </c:pt>
                <c:pt idx="55">
                  <c:v>1683.83</c:v>
                </c:pt>
                <c:pt idx="56">
                  <c:v>1752.91</c:v>
                </c:pt>
                <c:pt idx="57">
                  <c:v>1349.78</c:v>
                </c:pt>
                <c:pt idx="58">
                  <c:v>1859.01</c:v>
                </c:pt>
                <c:pt idx="59">
                  <c:v>1999.14</c:v>
                </c:pt>
                <c:pt idx="60">
                  <c:v>1897.93</c:v>
                </c:pt>
                <c:pt idx="61">
                  <c:v>1459.79</c:v>
                </c:pt>
                <c:pt idx="62">
                  <c:v>1495.4</c:v>
                </c:pt>
                <c:pt idx="63">
                  <c:v>1491.37</c:v>
                </c:pt>
                <c:pt idx="64">
                  <c:v>1579.88</c:v>
                </c:pt>
                <c:pt idx="65">
                  <c:v>1770.43</c:v>
                </c:pt>
                <c:pt idx="66">
                  <c:v>1604.01</c:v>
                </c:pt>
                <c:pt idx="67">
                  <c:v>1438.99</c:v>
                </c:pt>
                <c:pt idx="68">
                  <c:v>1904.63</c:v>
                </c:pt>
                <c:pt idx="69">
                  <c:v>1369.14</c:v>
                </c:pt>
                <c:pt idx="70">
                  <c:v>1720.7</c:v>
                </c:pt>
                <c:pt idx="71">
                  <c:v>1330.23</c:v>
                </c:pt>
                <c:pt idx="72">
                  <c:v>1774.38</c:v>
                </c:pt>
                <c:pt idx="73">
                  <c:v>1547.72</c:v>
                </c:pt>
                <c:pt idx="74">
                  <c:v>1591.94</c:v>
                </c:pt>
                <c:pt idx="75">
                  <c:v>1526.81</c:v>
                </c:pt>
                <c:pt idx="76">
                  <c:v>1552.3</c:v>
                </c:pt>
                <c:pt idx="77">
                  <c:v>1377.94</c:v>
                </c:pt>
                <c:pt idx="78">
                  <c:v>1314.83</c:v>
                </c:pt>
                <c:pt idx="79">
                  <c:v>1640.95</c:v>
                </c:pt>
                <c:pt idx="80">
                  <c:v>1570.49</c:v>
                </c:pt>
                <c:pt idx="81">
                  <c:v>1124.25</c:v>
                </c:pt>
                <c:pt idx="82">
                  <c:v>1823.36</c:v>
                </c:pt>
                <c:pt idx="83">
                  <c:v>1354.46</c:v>
                </c:pt>
                <c:pt idx="84">
                  <c:v>1538.89</c:v>
                </c:pt>
                <c:pt idx="85">
                  <c:v>1334.94</c:v>
                </c:pt>
                <c:pt idx="86">
                  <c:v>1373.2</c:v>
                </c:pt>
                <c:pt idx="87">
                  <c:v>1208.8900000000001</c:v>
                </c:pt>
                <c:pt idx="88">
                  <c:v>1422.06</c:v>
                </c:pt>
                <c:pt idx="89">
                  <c:v>1557.66</c:v>
                </c:pt>
                <c:pt idx="90">
                  <c:v>1543.01</c:v>
                </c:pt>
                <c:pt idx="91">
                  <c:v>1302.76</c:v>
                </c:pt>
                <c:pt idx="92">
                  <c:v>1422.15</c:v>
                </c:pt>
                <c:pt idx="93">
                  <c:v>1300.74</c:v>
                </c:pt>
                <c:pt idx="94">
                  <c:v>1510.81</c:v>
                </c:pt>
                <c:pt idx="95">
                  <c:v>1763.69</c:v>
                </c:pt>
                <c:pt idx="96">
                  <c:v>1268.56</c:v>
                </c:pt>
                <c:pt idx="97">
                  <c:v>1464.48</c:v>
                </c:pt>
                <c:pt idx="98">
                  <c:v>1147.76</c:v>
                </c:pt>
                <c:pt idx="99">
                  <c:v>1816.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ED4-4BD6-8C2F-821500761C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59391144"/>
        <c:axId val="659386224"/>
      </c:lineChart>
      <c:catAx>
        <c:axId val="659391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9386224"/>
        <c:crosses val="autoZero"/>
        <c:auto val="1"/>
        <c:lblAlgn val="ctr"/>
        <c:lblOffset val="100"/>
        <c:noMultiLvlLbl val="0"/>
      </c:catAx>
      <c:valAx>
        <c:axId val="6593862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9391144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3442767517827004"/>
          <c:y val="0.75041666666666673"/>
          <c:w val="0.36435677021853752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WGG-gene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wgg_Gene!$A$8</c:f>
              <c:strCache>
                <c:ptCount val="1"/>
                <c:pt idx="0">
                  <c:v>E108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wgg_Gene!$B$7:$CW$7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wgg_Gene!$B$8:$CW$8</c:f>
              <c:numCache>
                <c:formatCode>General</c:formatCode>
                <c:ptCount val="100"/>
                <c:pt idx="0">
                  <c:v>966.63</c:v>
                </c:pt>
                <c:pt idx="1">
                  <c:v>1198.44</c:v>
                </c:pt>
                <c:pt idx="2">
                  <c:v>1033.24</c:v>
                </c:pt>
                <c:pt idx="3">
                  <c:v>868.12</c:v>
                </c:pt>
                <c:pt idx="4">
                  <c:v>947.62999999999897</c:v>
                </c:pt>
                <c:pt idx="5">
                  <c:v>1155.6500000000001</c:v>
                </c:pt>
                <c:pt idx="6">
                  <c:v>1217.07</c:v>
                </c:pt>
                <c:pt idx="7">
                  <c:v>1281.3</c:v>
                </c:pt>
                <c:pt idx="8">
                  <c:v>1009.46</c:v>
                </c:pt>
                <c:pt idx="9">
                  <c:v>937.47</c:v>
                </c:pt>
                <c:pt idx="10">
                  <c:v>1044.51</c:v>
                </c:pt>
                <c:pt idx="11">
                  <c:v>885.77999999999895</c:v>
                </c:pt>
                <c:pt idx="12">
                  <c:v>920.86999999999898</c:v>
                </c:pt>
                <c:pt idx="13">
                  <c:v>771.51</c:v>
                </c:pt>
                <c:pt idx="14">
                  <c:v>1071.24</c:v>
                </c:pt>
                <c:pt idx="15">
                  <c:v>1059.47</c:v>
                </c:pt>
                <c:pt idx="16">
                  <c:v>926.60999999999899</c:v>
                </c:pt>
                <c:pt idx="17">
                  <c:v>888.219999999999</c:v>
                </c:pt>
                <c:pt idx="18">
                  <c:v>1293.8</c:v>
                </c:pt>
                <c:pt idx="19">
                  <c:v>946.32999999999902</c:v>
                </c:pt>
                <c:pt idx="20">
                  <c:v>850.23</c:v>
                </c:pt>
                <c:pt idx="21">
                  <c:v>699.93</c:v>
                </c:pt>
                <c:pt idx="22">
                  <c:v>929.06999999999903</c:v>
                </c:pt>
                <c:pt idx="23">
                  <c:v>867.55999999999904</c:v>
                </c:pt>
                <c:pt idx="24">
                  <c:v>839.719999999999</c:v>
                </c:pt>
                <c:pt idx="25">
                  <c:v>1054.26</c:v>
                </c:pt>
                <c:pt idx="26">
                  <c:v>863.94999999999902</c:v>
                </c:pt>
                <c:pt idx="27">
                  <c:v>879.32999999999902</c:v>
                </c:pt>
                <c:pt idx="28">
                  <c:v>1014.64</c:v>
                </c:pt>
                <c:pt idx="29">
                  <c:v>1202.02</c:v>
                </c:pt>
                <c:pt idx="30">
                  <c:v>1234.3699999999999</c:v>
                </c:pt>
                <c:pt idx="31">
                  <c:v>726.98999999999899</c:v>
                </c:pt>
                <c:pt idx="32">
                  <c:v>898.27999999999895</c:v>
                </c:pt>
                <c:pt idx="33">
                  <c:v>826.479999999999</c:v>
                </c:pt>
                <c:pt idx="34">
                  <c:v>869.23999999999899</c:v>
                </c:pt>
                <c:pt idx="35">
                  <c:v>852.20999999999901</c:v>
                </c:pt>
                <c:pt idx="36">
                  <c:v>1064.3499999999999</c:v>
                </c:pt>
                <c:pt idx="37">
                  <c:v>1066.71</c:v>
                </c:pt>
                <c:pt idx="38">
                  <c:v>806.16999999999905</c:v>
                </c:pt>
                <c:pt idx="39">
                  <c:v>882.41999999999905</c:v>
                </c:pt>
                <c:pt idx="40">
                  <c:v>867.19999999999902</c:v>
                </c:pt>
                <c:pt idx="41">
                  <c:v>867.229999999999</c:v>
                </c:pt>
                <c:pt idx="42">
                  <c:v>913.24999999999898</c:v>
                </c:pt>
                <c:pt idx="43">
                  <c:v>1023.47</c:v>
                </c:pt>
                <c:pt idx="44">
                  <c:v>1087.3699999999999</c:v>
                </c:pt>
                <c:pt idx="45">
                  <c:v>860.33999999999901</c:v>
                </c:pt>
                <c:pt idx="46">
                  <c:v>891.36999999999898</c:v>
                </c:pt>
                <c:pt idx="47">
                  <c:v>1135.43</c:v>
                </c:pt>
                <c:pt idx="48">
                  <c:v>799.33999999999901</c:v>
                </c:pt>
                <c:pt idx="49">
                  <c:v>969.32999999999902</c:v>
                </c:pt>
                <c:pt idx="50">
                  <c:v>942.75999999999897</c:v>
                </c:pt>
                <c:pt idx="51">
                  <c:v>1057.81</c:v>
                </c:pt>
                <c:pt idx="52">
                  <c:v>915.25999999999897</c:v>
                </c:pt>
                <c:pt idx="53">
                  <c:v>1129.75</c:v>
                </c:pt>
                <c:pt idx="54">
                  <c:v>903.93999999999903</c:v>
                </c:pt>
                <c:pt idx="55">
                  <c:v>1055.06</c:v>
                </c:pt>
                <c:pt idx="56">
                  <c:v>889.37999999999897</c:v>
                </c:pt>
                <c:pt idx="57">
                  <c:v>898.64</c:v>
                </c:pt>
                <c:pt idx="58">
                  <c:v>1064.24</c:v>
                </c:pt>
                <c:pt idx="59">
                  <c:v>950.39999999999895</c:v>
                </c:pt>
                <c:pt idx="60">
                  <c:v>1022.34</c:v>
                </c:pt>
                <c:pt idx="61">
                  <c:v>1234.75</c:v>
                </c:pt>
                <c:pt idx="62">
                  <c:v>967.77</c:v>
                </c:pt>
                <c:pt idx="63">
                  <c:v>1126.1500000000001</c:v>
                </c:pt>
                <c:pt idx="64">
                  <c:v>1029.57</c:v>
                </c:pt>
                <c:pt idx="65">
                  <c:v>1289.3800000000001</c:v>
                </c:pt>
                <c:pt idx="66">
                  <c:v>1070.42</c:v>
                </c:pt>
                <c:pt idx="67">
                  <c:v>819.53999999999905</c:v>
                </c:pt>
                <c:pt idx="68">
                  <c:v>1039.1600000000001</c:v>
                </c:pt>
                <c:pt idx="69">
                  <c:v>805.38999999999896</c:v>
                </c:pt>
                <c:pt idx="70">
                  <c:v>1110.79</c:v>
                </c:pt>
                <c:pt idx="71">
                  <c:v>910.81999999999903</c:v>
                </c:pt>
                <c:pt idx="72">
                  <c:v>1089.3499999999999</c:v>
                </c:pt>
                <c:pt idx="73">
                  <c:v>965.349999999999</c:v>
                </c:pt>
                <c:pt idx="74">
                  <c:v>856.64999999999895</c:v>
                </c:pt>
                <c:pt idx="75">
                  <c:v>975.46999999999798</c:v>
                </c:pt>
                <c:pt idx="76">
                  <c:v>1249.3399999999999</c:v>
                </c:pt>
                <c:pt idx="77">
                  <c:v>1122.1500000000001</c:v>
                </c:pt>
                <c:pt idx="78">
                  <c:v>1147.48</c:v>
                </c:pt>
                <c:pt idx="79">
                  <c:v>1134.68</c:v>
                </c:pt>
                <c:pt idx="80">
                  <c:v>1130.97</c:v>
                </c:pt>
                <c:pt idx="81">
                  <c:v>885.81999999999903</c:v>
                </c:pt>
                <c:pt idx="82">
                  <c:v>1040.45</c:v>
                </c:pt>
                <c:pt idx="83">
                  <c:v>819.04999999999905</c:v>
                </c:pt>
                <c:pt idx="84">
                  <c:v>978.28999999999905</c:v>
                </c:pt>
                <c:pt idx="85">
                  <c:v>1238.49</c:v>
                </c:pt>
                <c:pt idx="86">
                  <c:v>896.25999999999897</c:v>
                </c:pt>
                <c:pt idx="87">
                  <c:v>1335.8</c:v>
                </c:pt>
                <c:pt idx="88">
                  <c:v>1155.5999999999999</c:v>
                </c:pt>
                <c:pt idx="89">
                  <c:v>1239.6600000000001</c:v>
                </c:pt>
                <c:pt idx="90">
                  <c:v>1309.05</c:v>
                </c:pt>
                <c:pt idx="91">
                  <c:v>861.55999999999904</c:v>
                </c:pt>
                <c:pt idx="92">
                  <c:v>902.30999999999904</c:v>
                </c:pt>
                <c:pt idx="93">
                  <c:v>1263.03</c:v>
                </c:pt>
                <c:pt idx="94">
                  <c:v>1221.02</c:v>
                </c:pt>
                <c:pt idx="95">
                  <c:v>1182.5999999999999</c:v>
                </c:pt>
                <c:pt idx="96">
                  <c:v>1094.33</c:v>
                </c:pt>
                <c:pt idx="97">
                  <c:v>1376.6</c:v>
                </c:pt>
                <c:pt idx="98">
                  <c:v>1257.3900000000001</c:v>
                </c:pt>
                <c:pt idx="99">
                  <c:v>1246.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DCA-461E-91A8-75ECFC4270B0}"/>
            </c:ext>
          </c:extLst>
        </c:ser>
        <c:ser>
          <c:idx val="1"/>
          <c:order val="1"/>
          <c:tx>
            <c:strRef>
              <c:f>ccwgg_Gene!$A$9</c:f>
              <c:strCache>
                <c:ptCount val="1"/>
                <c:pt idx="0">
                  <c:v>E108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wgg_Gene!$B$7:$CW$7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wgg_Gene!$B$9:$CW$9</c:f>
              <c:numCache>
                <c:formatCode>General</c:formatCode>
                <c:ptCount val="100"/>
                <c:pt idx="0">
                  <c:v>1023.71</c:v>
                </c:pt>
                <c:pt idx="1">
                  <c:v>1216.29</c:v>
                </c:pt>
                <c:pt idx="2">
                  <c:v>1004.94</c:v>
                </c:pt>
                <c:pt idx="3">
                  <c:v>878.13999999999896</c:v>
                </c:pt>
                <c:pt idx="4">
                  <c:v>981.50999999999897</c:v>
                </c:pt>
                <c:pt idx="5">
                  <c:v>1226.3800000000001</c:v>
                </c:pt>
                <c:pt idx="6">
                  <c:v>1283.3699999999999</c:v>
                </c:pt>
                <c:pt idx="7">
                  <c:v>1233.74</c:v>
                </c:pt>
                <c:pt idx="8">
                  <c:v>986.17999999999904</c:v>
                </c:pt>
                <c:pt idx="9">
                  <c:v>999.54</c:v>
                </c:pt>
                <c:pt idx="10">
                  <c:v>1112.98</c:v>
                </c:pt>
                <c:pt idx="11">
                  <c:v>858.7</c:v>
                </c:pt>
                <c:pt idx="12">
                  <c:v>876.77999999999895</c:v>
                </c:pt>
                <c:pt idx="13">
                  <c:v>803</c:v>
                </c:pt>
                <c:pt idx="14">
                  <c:v>1101.5</c:v>
                </c:pt>
                <c:pt idx="15">
                  <c:v>980.08999999999901</c:v>
                </c:pt>
                <c:pt idx="16">
                  <c:v>930.45999999999901</c:v>
                </c:pt>
                <c:pt idx="17">
                  <c:v>851.26999999999896</c:v>
                </c:pt>
                <c:pt idx="18">
                  <c:v>1316.91</c:v>
                </c:pt>
                <c:pt idx="19">
                  <c:v>815.05999999999904</c:v>
                </c:pt>
                <c:pt idx="20">
                  <c:v>800.28999999999905</c:v>
                </c:pt>
                <c:pt idx="21">
                  <c:v>703.61</c:v>
                </c:pt>
                <c:pt idx="22">
                  <c:v>1029.07</c:v>
                </c:pt>
                <c:pt idx="23">
                  <c:v>854.58</c:v>
                </c:pt>
                <c:pt idx="24">
                  <c:v>821.73999999999899</c:v>
                </c:pt>
                <c:pt idx="25">
                  <c:v>1096.19</c:v>
                </c:pt>
                <c:pt idx="26">
                  <c:v>863.36999999999898</c:v>
                </c:pt>
                <c:pt idx="27">
                  <c:v>879.44999999999902</c:v>
                </c:pt>
                <c:pt idx="28">
                  <c:v>1064.01</c:v>
                </c:pt>
                <c:pt idx="29">
                  <c:v>1258.57</c:v>
                </c:pt>
                <c:pt idx="30">
                  <c:v>1164.6400000000001</c:v>
                </c:pt>
                <c:pt idx="31">
                  <c:v>743.96</c:v>
                </c:pt>
                <c:pt idx="32">
                  <c:v>878.1</c:v>
                </c:pt>
                <c:pt idx="33">
                  <c:v>847.229999999999</c:v>
                </c:pt>
                <c:pt idx="34">
                  <c:v>837.87</c:v>
                </c:pt>
                <c:pt idx="35">
                  <c:v>803.6</c:v>
                </c:pt>
                <c:pt idx="36">
                  <c:v>1178.6400000000001</c:v>
                </c:pt>
                <c:pt idx="37">
                  <c:v>982.78</c:v>
                </c:pt>
                <c:pt idx="38">
                  <c:v>794.93999999999903</c:v>
                </c:pt>
                <c:pt idx="39">
                  <c:v>836.48</c:v>
                </c:pt>
                <c:pt idx="40">
                  <c:v>959.28</c:v>
                </c:pt>
                <c:pt idx="41">
                  <c:v>917.62999999999897</c:v>
                </c:pt>
                <c:pt idx="42">
                  <c:v>815.78</c:v>
                </c:pt>
                <c:pt idx="43">
                  <c:v>1025.05</c:v>
                </c:pt>
                <c:pt idx="44">
                  <c:v>1206.92</c:v>
                </c:pt>
                <c:pt idx="45">
                  <c:v>931.79</c:v>
                </c:pt>
                <c:pt idx="46">
                  <c:v>897.53999999999905</c:v>
                </c:pt>
                <c:pt idx="47">
                  <c:v>1111.6300000000001</c:v>
                </c:pt>
                <c:pt idx="48">
                  <c:v>853.28999999999905</c:v>
                </c:pt>
                <c:pt idx="49">
                  <c:v>966.69999999999902</c:v>
                </c:pt>
                <c:pt idx="50">
                  <c:v>902.93999999999903</c:v>
                </c:pt>
                <c:pt idx="51">
                  <c:v>1036.4100000000001</c:v>
                </c:pt>
                <c:pt idx="52">
                  <c:v>870.05</c:v>
                </c:pt>
                <c:pt idx="53">
                  <c:v>1110.8800000000001</c:v>
                </c:pt>
                <c:pt idx="54">
                  <c:v>869.37999999999897</c:v>
                </c:pt>
                <c:pt idx="55">
                  <c:v>1045.8499999999999</c:v>
                </c:pt>
                <c:pt idx="56">
                  <c:v>865.27</c:v>
                </c:pt>
                <c:pt idx="57">
                  <c:v>980.15</c:v>
                </c:pt>
                <c:pt idx="58">
                  <c:v>918.35999999999899</c:v>
                </c:pt>
                <c:pt idx="59">
                  <c:v>1077.3900000000001</c:v>
                </c:pt>
                <c:pt idx="60">
                  <c:v>913.00999999999897</c:v>
                </c:pt>
                <c:pt idx="61">
                  <c:v>1022.34</c:v>
                </c:pt>
                <c:pt idx="62">
                  <c:v>920.37999999999897</c:v>
                </c:pt>
                <c:pt idx="63">
                  <c:v>1066.6199999999999</c:v>
                </c:pt>
                <c:pt idx="64">
                  <c:v>957.29</c:v>
                </c:pt>
                <c:pt idx="65">
                  <c:v>1272.6099999999999</c:v>
                </c:pt>
                <c:pt idx="66">
                  <c:v>1090.1300000000001</c:v>
                </c:pt>
                <c:pt idx="67">
                  <c:v>782.82999999999902</c:v>
                </c:pt>
                <c:pt idx="68">
                  <c:v>1028.4000000000001</c:v>
                </c:pt>
                <c:pt idx="69">
                  <c:v>812.33</c:v>
                </c:pt>
                <c:pt idx="70">
                  <c:v>992.82999999999902</c:v>
                </c:pt>
                <c:pt idx="71">
                  <c:v>863.32999999999902</c:v>
                </c:pt>
                <c:pt idx="72">
                  <c:v>1086.75</c:v>
                </c:pt>
                <c:pt idx="73">
                  <c:v>951.3</c:v>
                </c:pt>
                <c:pt idx="74">
                  <c:v>812.99999999999898</c:v>
                </c:pt>
                <c:pt idx="75">
                  <c:v>852.60999999999899</c:v>
                </c:pt>
                <c:pt idx="76">
                  <c:v>1375.3</c:v>
                </c:pt>
                <c:pt idx="77">
                  <c:v>1140.3800000000001</c:v>
                </c:pt>
                <c:pt idx="78">
                  <c:v>1116.31</c:v>
                </c:pt>
                <c:pt idx="79">
                  <c:v>1166.6300000000001</c:v>
                </c:pt>
                <c:pt idx="80">
                  <c:v>1098.1099999999999</c:v>
                </c:pt>
                <c:pt idx="81">
                  <c:v>832.5</c:v>
                </c:pt>
                <c:pt idx="82">
                  <c:v>990.17999999999904</c:v>
                </c:pt>
                <c:pt idx="83">
                  <c:v>783.51</c:v>
                </c:pt>
                <c:pt idx="84">
                  <c:v>1067.32</c:v>
                </c:pt>
                <c:pt idx="85">
                  <c:v>1358.51</c:v>
                </c:pt>
                <c:pt idx="86">
                  <c:v>916.97</c:v>
                </c:pt>
                <c:pt idx="87">
                  <c:v>1287.3599999999999</c:v>
                </c:pt>
                <c:pt idx="88">
                  <c:v>1159.22</c:v>
                </c:pt>
                <c:pt idx="89">
                  <c:v>1314.2</c:v>
                </c:pt>
                <c:pt idx="90">
                  <c:v>1271.95</c:v>
                </c:pt>
                <c:pt idx="91">
                  <c:v>858.65</c:v>
                </c:pt>
                <c:pt idx="92">
                  <c:v>989.5</c:v>
                </c:pt>
                <c:pt idx="93">
                  <c:v>1293.4000000000001</c:v>
                </c:pt>
                <c:pt idx="94">
                  <c:v>1161.9100000000001</c:v>
                </c:pt>
                <c:pt idx="95">
                  <c:v>1078.72</c:v>
                </c:pt>
                <c:pt idx="96">
                  <c:v>1109.6300000000001</c:v>
                </c:pt>
                <c:pt idx="97">
                  <c:v>1465.88</c:v>
                </c:pt>
                <c:pt idx="98">
                  <c:v>1282</c:v>
                </c:pt>
                <c:pt idx="99">
                  <c:v>1276.61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DCA-461E-91A8-75ECFC4270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59401640"/>
        <c:axId val="659392128"/>
      </c:lineChart>
      <c:catAx>
        <c:axId val="659401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9392128"/>
        <c:crosses val="autoZero"/>
        <c:auto val="1"/>
        <c:lblAlgn val="ctr"/>
        <c:lblOffset val="100"/>
        <c:noMultiLvlLbl val="0"/>
      </c:catAx>
      <c:valAx>
        <c:axId val="659392128"/>
        <c:scaling>
          <c:orientation val="minMax"/>
          <c:max val="2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9401640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35628789139033684"/>
          <c:y val="0.77819444444444441"/>
          <c:w val="0.36371529703153305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WGG-TTS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9.5928889958112343E-2"/>
          <c:y val="0.16650481189851271"/>
          <c:w val="0.87167997551542808"/>
          <c:h val="0.65840259550889468"/>
        </c:manualLayout>
      </c:layout>
      <c:lineChart>
        <c:grouping val="standard"/>
        <c:varyColors val="0"/>
        <c:ser>
          <c:idx val="0"/>
          <c:order val="0"/>
          <c:tx>
            <c:strRef>
              <c:f>ccwgg_TTS!$A$8</c:f>
              <c:strCache>
                <c:ptCount val="1"/>
                <c:pt idx="0">
                  <c:v>E108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wgg_TTS!$B$7:$CW$7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TS!$B$8:$CW$8</c:f>
              <c:numCache>
                <c:formatCode>General</c:formatCode>
                <c:ptCount val="100"/>
                <c:pt idx="0">
                  <c:v>546.96</c:v>
                </c:pt>
                <c:pt idx="1">
                  <c:v>1124.94</c:v>
                </c:pt>
                <c:pt idx="2">
                  <c:v>1362.46</c:v>
                </c:pt>
                <c:pt idx="3">
                  <c:v>1192.73</c:v>
                </c:pt>
                <c:pt idx="4">
                  <c:v>1278.45</c:v>
                </c:pt>
                <c:pt idx="5">
                  <c:v>1289.71</c:v>
                </c:pt>
                <c:pt idx="6">
                  <c:v>1611.25</c:v>
                </c:pt>
                <c:pt idx="7">
                  <c:v>1610.01</c:v>
                </c:pt>
                <c:pt idx="8">
                  <c:v>1309.0999999999999</c:v>
                </c:pt>
                <c:pt idx="9">
                  <c:v>1406.82</c:v>
                </c:pt>
                <c:pt idx="10">
                  <c:v>1506.66</c:v>
                </c:pt>
                <c:pt idx="11">
                  <c:v>2004.3</c:v>
                </c:pt>
                <c:pt idx="12">
                  <c:v>1644.83</c:v>
                </c:pt>
                <c:pt idx="13">
                  <c:v>1461.87</c:v>
                </c:pt>
                <c:pt idx="14">
                  <c:v>1557.88</c:v>
                </c:pt>
                <c:pt idx="15">
                  <c:v>1850.08</c:v>
                </c:pt>
                <c:pt idx="16">
                  <c:v>1485.29</c:v>
                </c:pt>
                <c:pt idx="17">
                  <c:v>1502.66</c:v>
                </c:pt>
                <c:pt idx="18">
                  <c:v>1519.63</c:v>
                </c:pt>
                <c:pt idx="19">
                  <c:v>1590.35</c:v>
                </c:pt>
                <c:pt idx="20">
                  <c:v>1292.53</c:v>
                </c:pt>
                <c:pt idx="21">
                  <c:v>1304.97</c:v>
                </c:pt>
                <c:pt idx="22">
                  <c:v>1540.99</c:v>
                </c:pt>
                <c:pt idx="23">
                  <c:v>1151.51</c:v>
                </c:pt>
                <c:pt idx="24">
                  <c:v>1299.79</c:v>
                </c:pt>
                <c:pt idx="25">
                  <c:v>1270.73</c:v>
                </c:pt>
                <c:pt idx="26">
                  <c:v>1317.52</c:v>
                </c:pt>
                <c:pt idx="27">
                  <c:v>1500.59</c:v>
                </c:pt>
                <c:pt idx="28">
                  <c:v>1795.94</c:v>
                </c:pt>
                <c:pt idx="29">
                  <c:v>1297.79</c:v>
                </c:pt>
                <c:pt idx="30">
                  <c:v>1496.12</c:v>
                </c:pt>
                <c:pt idx="31">
                  <c:v>1734.43</c:v>
                </c:pt>
                <c:pt idx="32">
                  <c:v>1628.27</c:v>
                </c:pt>
                <c:pt idx="33">
                  <c:v>1716.7</c:v>
                </c:pt>
                <c:pt idx="34">
                  <c:v>1770.81</c:v>
                </c:pt>
                <c:pt idx="35">
                  <c:v>1891.96</c:v>
                </c:pt>
                <c:pt idx="36">
                  <c:v>2143.61</c:v>
                </c:pt>
                <c:pt idx="37">
                  <c:v>1948.63</c:v>
                </c:pt>
                <c:pt idx="38">
                  <c:v>1836.97</c:v>
                </c:pt>
                <c:pt idx="39">
                  <c:v>1720.71</c:v>
                </c:pt>
                <c:pt idx="40">
                  <c:v>1777.3</c:v>
                </c:pt>
                <c:pt idx="41">
                  <c:v>1770.34</c:v>
                </c:pt>
                <c:pt idx="42">
                  <c:v>2269.73</c:v>
                </c:pt>
                <c:pt idx="43">
                  <c:v>2595.19</c:v>
                </c:pt>
                <c:pt idx="44">
                  <c:v>2310.11</c:v>
                </c:pt>
                <c:pt idx="45">
                  <c:v>2259.63</c:v>
                </c:pt>
                <c:pt idx="46">
                  <c:v>2154.65</c:v>
                </c:pt>
                <c:pt idx="47">
                  <c:v>2033.43</c:v>
                </c:pt>
                <c:pt idx="48">
                  <c:v>2371.4899999999998</c:v>
                </c:pt>
                <c:pt idx="49">
                  <c:v>2388.09</c:v>
                </c:pt>
                <c:pt idx="50">
                  <c:v>1837.44</c:v>
                </c:pt>
                <c:pt idx="51">
                  <c:v>1349.52</c:v>
                </c:pt>
                <c:pt idx="52">
                  <c:v>1162.8699999999999</c:v>
                </c:pt>
                <c:pt idx="53">
                  <c:v>1285.7</c:v>
                </c:pt>
                <c:pt idx="54">
                  <c:v>1139.07</c:v>
                </c:pt>
                <c:pt idx="55">
                  <c:v>1159.7</c:v>
                </c:pt>
                <c:pt idx="56">
                  <c:v>1154.43</c:v>
                </c:pt>
                <c:pt idx="57">
                  <c:v>1166.1400000000001</c:v>
                </c:pt>
                <c:pt idx="58">
                  <c:v>1127.76</c:v>
                </c:pt>
                <c:pt idx="59">
                  <c:v>1128.54</c:v>
                </c:pt>
                <c:pt idx="60">
                  <c:v>1398.04</c:v>
                </c:pt>
                <c:pt idx="61">
                  <c:v>935.92</c:v>
                </c:pt>
                <c:pt idx="62">
                  <c:v>1165.76</c:v>
                </c:pt>
                <c:pt idx="63">
                  <c:v>1450.17</c:v>
                </c:pt>
                <c:pt idx="64">
                  <c:v>1186.79</c:v>
                </c:pt>
                <c:pt idx="65">
                  <c:v>1126.6199999999999</c:v>
                </c:pt>
                <c:pt idx="66">
                  <c:v>796.86</c:v>
                </c:pt>
                <c:pt idx="67">
                  <c:v>1019.87</c:v>
                </c:pt>
                <c:pt idx="68">
                  <c:v>1103.55</c:v>
                </c:pt>
                <c:pt idx="69">
                  <c:v>1221.4100000000001</c:v>
                </c:pt>
                <c:pt idx="70">
                  <c:v>1222.27</c:v>
                </c:pt>
                <c:pt idx="71">
                  <c:v>1310.4000000000001</c:v>
                </c:pt>
                <c:pt idx="72">
                  <c:v>1597.21</c:v>
                </c:pt>
                <c:pt idx="73">
                  <c:v>1368.97</c:v>
                </c:pt>
                <c:pt idx="74">
                  <c:v>1197.25</c:v>
                </c:pt>
                <c:pt idx="75">
                  <c:v>1549.9</c:v>
                </c:pt>
                <c:pt idx="76">
                  <c:v>1329.43</c:v>
                </c:pt>
                <c:pt idx="77">
                  <c:v>1422.26</c:v>
                </c:pt>
                <c:pt idx="78">
                  <c:v>1333.35</c:v>
                </c:pt>
                <c:pt idx="79">
                  <c:v>1370.96</c:v>
                </c:pt>
                <c:pt idx="80">
                  <c:v>1106.77</c:v>
                </c:pt>
                <c:pt idx="81">
                  <c:v>1253.42</c:v>
                </c:pt>
                <c:pt idx="82">
                  <c:v>1478.4</c:v>
                </c:pt>
                <c:pt idx="83">
                  <c:v>1320.83</c:v>
                </c:pt>
                <c:pt idx="84">
                  <c:v>1216.31</c:v>
                </c:pt>
                <c:pt idx="85">
                  <c:v>1285.73</c:v>
                </c:pt>
                <c:pt idx="86">
                  <c:v>1240.1099999999999</c:v>
                </c:pt>
                <c:pt idx="87">
                  <c:v>1259.8499999999999</c:v>
                </c:pt>
                <c:pt idx="88">
                  <c:v>981.94999999999902</c:v>
                </c:pt>
                <c:pt idx="89">
                  <c:v>1144.75</c:v>
                </c:pt>
                <c:pt idx="90">
                  <c:v>1042.1199999999999</c:v>
                </c:pt>
                <c:pt idx="91">
                  <c:v>1410.18</c:v>
                </c:pt>
                <c:pt idx="92">
                  <c:v>1388.31</c:v>
                </c:pt>
                <c:pt idx="93">
                  <c:v>1546.66</c:v>
                </c:pt>
                <c:pt idx="94">
                  <c:v>1614.87</c:v>
                </c:pt>
                <c:pt idx="95">
                  <c:v>1466.7</c:v>
                </c:pt>
                <c:pt idx="96">
                  <c:v>1019.92</c:v>
                </c:pt>
                <c:pt idx="97">
                  <c:v>1196.06</c:v>
                </c:pt>
                <c:pt idx="98">
                  <c:v>1561.21</c:v>
                </c:pt>
                <c:pt idx="99">
                  <c:v>1214.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96B-4A7E-9D2B-73147D241D9F}"/>
            </c:ext>
          </c:extLst>
        </c:ser>
        <c:ser>
          <c:idx val="1"/>
          <c:order val="1"/>
          <c:tx>
            <c:strRef>
              <c:f>ccwgg_TTS!$A$9</c:f>
              <c:strCache>
                <c:ptCount val="1"/>
                <c:pt idx="0">
                  <c:v>E108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wgg_TTS!$B$7:$CW$7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TS!$B$9:$CW$9</c:f>
              <c:numCache>
                <c:formatCode>General</c:formatCode>
                <c:ptCount val="100"/>
                <c:pt idx="0">
                  <c:v>520.55999999999995</c:v>
                </c:pt>
                <c:pt idx="1">
                  <c:v>1112.26</c:v>
                </c:pt>
                <c:pt idx="2">
                  <c:v>1284.72</c:v>
                </c:pt>
                <c:pt idx="3">
                  <c:v>1111.57</c:v>
                </c:pt>
                <c:pt idx="4">
                  <c:v>1258.46</c:v>
                </c:pt>
                <c:pt idx="5">
                  <c:v>1263.8599999999999</c:v>
                </c:pt>
                <c:pt idx="6">
                  <c:v>1676.53</c:v>
                </c:pt>
                <c:pt idx="7">
                  <c:v>1578.46</c:v>
                </c:pt>
                <c:pt idx="8">
                  <c:v>1299.42</c:v>
                </c:pt>
                <c:pt idx="9">
                  <c:v>1385.39</c:v>
                </c:pt>
                <c:pt idx="10">
                  <c:v>1571.11</c:v>
                </c:pt>
                <c:pt idx="11">
                  <c:v>2003.84</c:v>
                </c:pt>
                <c:pt idx="12">
                  <c:v>1844.88</c:v>
                </c:pt>
                <c:pt idx="13">
                  <c:v>1406.15</c:v>
                </c:pt>
                <c:pt idx="14">
                  <c:v>1542.97</c:v>
                </c:pt>
                <c:pt idx="15">
                  <c:v>1842.22</c:v>
                </c:pt>
                <c:pt idx="16">
                  <c:v>1430.89</c:v>
                </c:pt>
                <c:pt idx="17">
                  <c:v>1652.3</c:v>
                </c:pt>
                <c:pt idx="18">
                  <c:v>1445.03</c:v>
                </c:pt>
                <c:pt idx="19">
                  <c:v>1503.43</c:v>
                </c:pt>
                <c:pt idx="20">
                  <c:v>1355.76</c:v>
                </c:pt>
                <c:pt idx="21">
                  <c:v>1202.81</c:v>
                </c:pt>
                <c:pt idx="22">
                  <c:v>1553.72</c:v>
                </c:pt>
                <c:pt idx="23">
                  <c:v>1090.74</c:v>
                </c:pt>
                <c:pt idx="24">
                  <c:v>1274.58</c:v>
                </c:pt>
                <c:pt idx="25">
                  <c:v>1228.31</c:v>
                </c:pt>
                <c:pt idx="26">
                  <c:v>1194.1400000000001</c:v>
                </c:pt>
                <c:pt idx="27">
                  <c:v>1502.69</c:v>
                </c:pt>
                <c:pt idx="28">
                  <c:v>1680.49</c:v>
                </c:pt>
                <c:pt idx="29">
                  <c:v>1294.68</c:v>
                </c:pt>
                <c:pt idx="30">
                  <c:v>1488.59</c:v>
                </c:pt>
                <c:pt idx="31">
                  <c:v>1809.34</c:v>
                </c:pt>
                <c:pt idx="32">
                  <c:v>1701.9</c:v>
                </c:pt>
                <c:pt idx="33">
                  <c:v>1734.83</c:v>
                </c:pt>
                <c:pt idx="34">
                  <c:v>1690.54</c:v>
                </c:pt>
                <c:pt idx="35">
                  <c:v>1916.69</c:v>
                </c:pt>
                <c:pt idx="36">
                  <c:v>2046.76</c:v>
                </c:pt>
                <c:pt idx="37">
                  <c:v>1944.19</c:v>
                </c:pt>
                <c:pt idx="38">
                  <c:v>1775.79</c:v>
                </c:pt>
                <c:pt idx="39">
                  <c:v>1733.45</c:v>
                </c:pt>
                <c:pt idx="40">
                  <c:v>1705.35</c:v>
                </c:pt>
                <c:pt idx="41">
                  <c:v>1793.17</c:v>
                </c:pt>
                <c:pt idx="42">
                  <c:v>2193.7399999999998</c:v>
                </c:pt>
                <c:pt idx="43">
                  <c:v>2777.45</c:v>
                </c:pt>
                <c:pt idx="44">
                  <c:v>2451.35</c:v>
                </c:pt>
                <c:pt idx="45">
                  <c:v>2254.75</c:v>
                </c:pt>
                <c:pt idx="46">
                  <c:v>2070.92</c:v>
                </c:pt>
                <c:pt idx="47">
                  <c:v>2116.04</c:v>
                </c:pt>
                <c:pt idx="48">
                  <c:v>2484.21</c:v>
                </c:pt>
                <c:pt idx="49">
                  <c:v>2457.39</c:v>
                </c:pt>
                <c:pt idx="50">
                  <c:v>1781.81</c:v>
                </c:pt>
                <c:pt idx="51">
                  <c:v>1383.4</c:v>
                </c:pt>
                <c:pt idx="52">
                  <c:v>1215.55</c:v>
                </c:pt>
                <c:pt idx="53">
                  <c:v>1378.64</c:v>
                </c:pt>
                <c:pt idx="54">
                  <c:v>1192.06</c:v>
                </c:pt>
                <c:pt idx="55">
                  <c:v>1127.72</c:v>
                </c:pt>
                <c:pt idx="56">
                  <c:v>1213.58</c:v>
                </c:pt>
                <c:pt idx="57">
                  <c:v>1282.01</c:v>
                </c:pt>
                <c:pt idx="58">
                  <c:v>1137.81</c:v>
                </c:pt>
                <c:pt idx="59">
                  <c:v>1108.28</c:v>
                </c:pt>
                <c:pt idx="60">
                  <c:v>1500.74</c:v>
                </c:pt>
                <c:pt idx="61">
                  <c:v>876.73999999999899</c:v>
                </c:pt>
                <c:pt idx="62">
                  <c:v>1169.98</c:v>
                </c:pt>
                <c:pt idx="63">
                  <c:v>1576.56</c:v>
                </c:pt>
                <c:pt idx="64">
                  <c:v>1100.9000000000001</c:v>
                </c:pt>
                <c:pt idx="65">
                  <c:v>1136.45</c:v>
                </c:pt>
                <c:pt idx="66">
                  <c:v>753.3</c:v>
                </c:pt>
                <c:pt idx="67">
                  <c:v>1006.26</c:v>
                </c:pt>
                <c:pt idx="68">
                  <c:v>1098.17</c:v>
                </c:pt>
                <c:pt idx="69">
                  <c:v>1192.76</c:v>
                </c:pt>
                <c:pt idx="70">
                  <c:v>1241.1099999999999</c:v>
                </c:pt>
                <c:pt idx="71">
                  <c:v>1221.57</c:v>
                </c:pt>
                <c:pt idx="72">
                  <c:v>1483.29</c:v>
                </c:pt>
                <c:pt idx="73">
                  <c:v>1453.16</c:v>
                </c:pt>
                <c:pt idx="74">
                  <c:v>1147.22</c:v>
                </c:pt>
                <c:pt idx="75">
                  <c:v>1600.56</c:v>
                </c:pt>
                <c:pt idx="76">
                  <c:v>1233.02</c:v>
                </c:pt>
                <c:pt idx="77">
                  <c:v>1338.32</c:v>
                </c:pt>
                <c:pt idx="78">
                  <c:v>1370.59</c:v>
                </c:pt>
                <c:pt idx="79">
                  <c:v>1272.6400000000001</c:v>
                </c:pt>
                <c:pt idx="80">
                  <c:v>1096.1600000000001</c:v>
                </c:pt>
                <c:pt idx="81">
                  <c:v>1131.08</c:v>
                </c:pt>
                <c:pt idx="82">
                  <c:v>1444.4</c:v>
                </c:pt>
                <c:pt idx="83">
                  <c:v>1316.22</c:v>
                </c:pt>
                <c:pt idx="84">
                  <c:v>1161.23</c:v>
                </c:pt>
                <c:pt idx="85">
                  <c:v>1345.08</c:v>
                </c:pt>
                <c:pt idx="86">
                  <c:v>1194.77</c:v>
                </c:pt>
                <c:pt idx="87">
                  <c:v>1255.8399999999999</c:v>
                </c:pt>
                <c:pt idx="88">
                  <c:v>1000.88</c:v>
                </c:pt>
                <c:pt idx="89">
                  <c:v>1236.3699999999999</c:v>
                </c:pt>
                <c:pt idx="90">
                  <c:v>986.79999999999905</c:v>
                </c:pt>
                <c:pt idx="91">
                  <c:v>1374.65</c:v>
                </c:pt>
                <c:pt idx="92">
                  <c:v>1363.21</c:v>
                </c:pt>
                <c:pt idx="93">
                  <c:v>1519.56</c:v>
                </c:pt>
                <c:pt idx="94">
                  <c:v>1572.54</c:v>
                </c:pt>
                <c:pt idx="95">
                  <c:v>1540.3</c:v>
                </c:pt>
                <c:pt idx="96">
                  <c:v>1087.51</c:v>
                </c:pt>
                <c:pt idx="97">
                  <c:v>1114.32</c:v>
                </c:pt>
                <c:pt idx="98">
                  <c:v>1394.75</c:v>
                </c:pt>
                <c:pt idx="99">
                  <c:v>1229.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96B-4A7E-9D2B-73147D241D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82707352"/>
        <c:axId val="682700792"/>
      </c:lineChart>
      <c:catAx>
        <c:axId val="682707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82700792"/>
        <c:crosses val="autoZero"/>
        <c:auto val="1"/>
        <c:lblAlgn val="ctr"/>
        <c:lblOffset val="100"/>
        <c:noMultiLvlLbl val="0"/>
      </c:catAx>
      <c:valAx>
        <c:axId val="6827007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82707352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34400159381120105"/>
          <c:y val="0.74578703703703708"/>
          <c:w val="0.3650005100952487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 dirty="0">
                <a:solidFill>
                  <a:schemeClr val="tx1"/>
                </a:solidFill>
              </a:rPr>
              <a:t>CCGG-TSS</a:t>
            </a:r>
            <a:endParaRPr lang="zh-CN" altLang="en-US" b="1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gg_TSS!$A$2</c:f>
              <c:strCache>
                <c:ptCount val="1"/>
                <c:pt idx="0">
                  <c:v>E20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gg_TSS!$B$1:$CW$1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SS!$B$2:$CW$2</c:f>
              <c:numCache>
                <c:formatCode>General</c:formatCode>
                <c:ptCount val="100"/>
                <c:pt idx="0">
                  <c:v>690.96</c:v>
                </c:pt>
                <c:pt idx="1">
                  <c:v>1885.76</c:v>
                </c:pt>
                <c:pt idx="2">
                  <c:v>1527.16</c:v>
                </c:pt>
                <c:pt idx="3">
                  <c:v>1510.63</c:v>
                </c:pt>
                <c:pt idx="4">
                  <c:v>1882.57</c:v>
                </c:pt>
                <c:pt idx="5">
                  <c:v>1694.02</c:v>
                </c:pt>
                <c:pt idx="6">
                  <c:v>1727.36</c:v>
                </c:pt>
                <c:pt idx="7">
                  <c:v>1818.08</c:v>
                </c:pt>
                <c:pt idx="8">
                  <c:v>1700.36</c:v>
                </c:pt>
                <c:pt idx="9">
                  <c:v>1362.67</c:v>
                </c:pt>
                <c:pt idx="10">
                  <c:v>1283.42</c:v>
                </c:pt>
                <c:pt idx="11">
                  <c:v>3883.93</c:v>
                </c:pt>
                <c:pt idx="12">
                  <c:v>1514.85</c:v>
                </c:pt>
                <c:pt idx="13">
                  <c:v>1670.83</c:v>
                </c:pt>
                <c:pt idx="14">
                  <c:v>1589.07</c:v>
                </c:pt>
                <c:pt idx="15">
                  <c:v>1432.05</c:v>
                </c:pt>
                <c:pt idx="16">
                  <c:v>1580.69</c:v>
                </c:pt>
                <c:pt idx="17">
                  <c:v>1368.88</c:v>
                </c:pt>
                <c:pt idx="18">
                  <c:v>1618.49</c:v>
                </c:pt>
                <c:pt idx="19">
                  <c:v>1773.61</c:v>
                </c:pt>
                <c:pt idx="20">
                  <c:v>1546.44</c:v>
                </c:pt>
                <c:pt idx="21">
                  <c:v>1379.86</c:v>
                </c:pt>
                <c:pt idx="22">
                  <c:v>1549.94</c:v>
                </c:pt>
                <c:pt idx="23">
                  <c:v>1728.38</c:v>
                </c:pt>
                <c:pt idx="24">
                  <c:v>1851.76</c:v>
                </c:pt>
                <c:pt idx="25">
                  <c:v>1346.52</c:v>
                </c:pt>
                <c:pt idx="26">
                  <c:v>1738.11</c:v>
                </c:pt>
                <c:pt idx="27">
                  <c:v>1166.04</c:v>
                </c:pt>
                <c:pt idx="28">
                  <c:v>1339.85</c:v>
                </c:pt>
                <c:pt idx="29">
                  <c:v>1571.69</c:v>
                </c:pt>
                <c:pt idx="30">
                  <c:v>1281.72</c:v>
                </c:pt>
                <c:pt idx="31">
                  <c:v>1448.18</c:v>
                </c:pt>
                <c:pt idx="32">
                  <c:v>1567.41</c:v>
                </c:pt>
                <c:pt idx="33">
                  <c:v>1788.97</c:v>
                </c:pt>
                <c:pt idx="34">
                  <c:v>1552.69</c:v>
                </c:pt>
                <c:pt idx="35">
                  <c:v>1384.33</c:v>
                </c:pt>
                <c:pt idx="36">
                  <c:v>1454.12</c:v>
                </c:pt>
                <c:pt idx="37">
                  <c:v>1538.97</c:v>
                </c:pt>
                <c:pt idx="38">
                  <c:v>1012.04</c:v>
                </c:pt>
                <c:pt idx="39">
                  <c:v>1376.01</c:v>
                </c:pt>
                <c:pt idx="40">
                  <c:v>1354.97</c:v>
                </c:pt>
                <c:pt idx="41">
                  <c:v>1498.45</c:v>
                </c:pt>
                <c:pt idx="42">
                  <c:v>1133.72</c:v>
                </c:pt>
                <c:pt idx="43">
                  <c:v>1527.41</c:v>
                </c:pt>
                <c:pt idx="44">
                  <c:v>1472.76</c:v>
                </c:pt>
                <c:pt idx="45">
                  <c:v>1220.31</c:v>
                </c:pt>
                <c:pt idx="46">
                  <c:v>1468.57</c:v>
                </c:pt>
                <c:pt idx="47">
                  <c:v>1090.2</c:v>
                </c:pt>
                <c:pt idx="48">
                  <c:v>1063.92</c:v>
                </c:pt>
                <c:pt idx="49">
                  <c:v>1232.27</c:v>
                </c:pt>
                <c:pt idx="50">
                  <c:v>1571.56</c:v>
                </c:pt>
                <c:pt idx="51">
                  <c:v>2977.22</c:v>
                </c:pt>
                <c:pt idx="52">
                  <c:v>2443.4899999999998</c:v>
                </c:pt>
                <c:pt idx="53">
                  <c:v>3055.22</c:v>
                </c:pt>
                <c:pt idx="54">
                  <c:v>2584.0300000000002</c:v>
                </c:pt>
                <c:pt idx="55">
                  <c:v>3035.68</c:v>
                </c:pt>
                <c:pt idx="56">
                  <c:v>2854</c:v>
                </c:pt>
                <c:pt idx="57">
                  <c:v>3269.9</c:v>
                </c:pt>
                <c:pt idx="58">
                  <c:v>5112.4799999999996</c:v>
                </c:pt>
                <c:pt idx="59">
                  <c:v>3190.38</c:v>
                </c:pt>
                <c:pt idx="60">
                  <c:v>2656.47</c:v>
                </c:pt>
                <c:pt idx="61">
                  <c:v>2634.92</c:v>
                </c:pt>
                <c:pt idx="62">
                  <c:v>2600.21</c:v>
                </c:pt>
                <c:pt idx="63">
                  <c:v>2137.08</c:v>
                </c:pt>
                <c:pt idx="64">
                  <c:v>2296.63</c:v>
                </c:pt>
                <c:pt idx="65">
                  <c:v>2271.4</c:v>
                </c:pt>
                <c:pt idx="66">
                  <c:v>2564.4899999999998</c:v>
                </c:pt>
                <c:pt idx="67">
                  <c:v>2219.09</c:v>
                </c:pt>
                <c:pt idx="68">
                  <c:v>2346.7600000000002</c:v>
                </c:pt>
                <c:pt idx="69">
                  <c:v>2571.86</c:v>
                </c:pt>
                <c:pt idx="70">
                  <c:v>2797.5499999999902</c:v>
                </c:pt>
                <c:pt idx="71">
                  <c:v>2475.41</c:v>
                </c:pt>
                <c:pt idx="72">
                  <c:v>2570.17</c:v>
                </c:pt>
                <c:pt idx="73">
                  <c:v>2593.54</c:v>
                </c:pt>
                <c:pt idx="74">
                  <c:v>3342.15</c:v>
                </c:pt>
                <c:pt idx="75">
                  <c:v>3266.71</c:v>
                </c:pt>
                <c:pt idx="76">
                  <c:v>3301.83</c:v>
                </c:pt>
                <c:pt idx="77">
                  <c:v>3235.81</c:v>
                </c:pt>
                <c:pt idx="78">
                  <c:v>3049.99</c:v>
                </c:pt>
                <c:pt idx="79">
                  <c:v>2959.28</c:v>
                </c:pt>
                <c:pt idx="80">
                  <c:v>2877.92</c:v>
                </c:pt>
                <c:pt idx="81">
                  <c:v>3332.77</c:v>
                </c:pt>
                <c:pt idx="82">
                  <c:v>3108.35</c:v>
                </c:pt>
                <c:pt idx="83">
                  <c:v>3415.12</c:v>
                </c:pt>
                <c:pt idx="84">
                  <c:v>3265.5699999999902</c:v>
                </c:pt>
                <c:pt idx="85">
                  <c:v>3273.75</c:v>
                </c:pt>
                <c:pt idx="86">
                  <c:v>3244.58</c:v>
                </c:pt>
                <c:pt idx="87">
                  <c:v>3434</c:v>
                </c:pt>
                <c:pt idx="88">
                  <c:v>3225.13</c:v>
                </c:pt>
                <c:pt idx="89">
                  <c:v>3153.62</c:v>
                </c:pt>
                <c:pt idx="90">
                  <c:v>3227.92</c:v>
                </c:pt>
                <c:pt idx="91">
                  <c:v>2551.1799999999998</c:v>
                </c:pt>
                <c:pt idx="92">
                  <c:v>3248.62</c:v>
                </c:pt>
                <c:pt idx="93">
                  <c:v>3198.02</c:v>
                </c:pt>
                <c:pt idx="94">
                  <c:v>3059.24</c:v>
                </c:pt>
                <c:pt idx="95">
                  <c:v>2879.43</c:v>
                </c:pt>
                <c:pt idx="96">
                  <c:v>3632.48</c:v>
                </c:pt>
                <c:pt idx="97">
                  <c:v>3064.14</c:v>
                </c:pt>
                <c:pt idx="98">
                  <c:v>2866.13</c:v>
                </c:pt>
                <c:pt idx="99">
                  <c:v>3429.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4B0-4D26-8373-AFD5E8AD33ED}"/>
            </c:ext>
          </c:extLst>
        </c:ser>
        <c:ser>
          <c:idx val="1"/>
          <c:order val="1"/>
          <c:tx>
            <c:strRef>
              <c:f>ccgg_TSS!$A$3</c:f>
              <c:strCache>
                <c:ptCount val="1"/>
                <c:pt idx="0">
                  <c:v>E20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gg_TSS!$B$1:$CW$1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SS!$B$3:$CW$3</c:f>
              <c:numCache>
                <c:formatCode>General</c:formatCode>
                <c:ptCount val="100"/>
                <c:pt idx="0">
                  <c:v>675.05</c:v>
                </c:pt>
                <c:pt idx="1">
                  <c:v>2073.04</c:v>
                </c:pt>
                <c:pt idx="2">
                  <c:v>1547.51</c:v>
                </c:pt>
                <c:pt idx="3">
                  <c:v>1489.39</c:v>
                </c:pt>
                <c:pt idx="4">
                  <c:v>1846.44</c:v>
                </c:pt>
                <c:pt idx="5">
                  <c:v>1770.19</c:v>
                </c:pt>
                <c:pt idx="6">
                  <c:v>1749.82</c:v>
                </c:pt>
                <c:pt idx="7">
                  <c:v>2031.04</c:v>
                </c:pt>
                <c:pt idx="8">
                  <c:v>1514.58</c:v>
                </c:pt>
                <c:pt idx="9">
                  <c:v>1449.77</c:v>
                </c:pt>
                <c:pt idx="10">
                  <c:v>1302.23</c:v>
                </c:pt>
                <c:pt idx="11">
                  <c:v>1947.27999999999</c:v>
                </c:pt>
                <c:pt idx="12">
                  <c:v>1511.23</c:v>
                </c:pt>
                <c:pt idx="13">
                  <c:v>1681.29</c:v>
                </c:pt>
                <c:pt idx="14">
                  <c:v>1424.85</c:v>
                </c:pt>
                <c:pt idx="15">
                  <c:v>1381.09</c:v>
                </c:pt>
                <c:pt idx="16">
                  <c:v>1560.13</c:v>
                </c:pt>
                <c:pt idx="17">
                  <c:v>1354.47</c:v>
                </c:pt>
                <c:pt idx="18">
                  <c:v>1528.92</c:v>
                </c:pt>
                <c:pt idx="19">
                  <c:v>1596.88</c:v>
                </c:pt>
                <c:pt idx="20">
                  <c:v>1414.88</c:v>
                </c:pt>
                <c:pt idx="21">
                  <c:v>1412.34</c:v>
                </c:pt>
                <c:pt idx="22">
                  <c:v>1531.62</c:v>
                </c:pt>
                <c:pt idx="23">
                  <c:v>1799.47</c:v>
                </c:pt>
                <c:pt idx="24">
                  <c:v>1790.24</c:v>
                </c:pt>
                <c:pt idx="25">
                  <c:v>1336.04</c:v>
                </c:pt>
                <c:pt idx="26">
                  <c:v>1780.11</c:v>
                </c:pt>
                <c:pt idx="27">
                  <c:v>1140.7</c:v>
                </c:pt>
                <c:pt idx="28">
                  <c:v>1276.29</c:v>
                </c:pt>
                <c:pt idx="29">
                  <c:v>1418.25</c:v>
                </c:pt>
                <c:pt idx="30">
                  <c:v>1178.51</c:v>
                </c:pt>
                <c:pt idx="31">
                  <c:v>1409.71</c:v>
                </c:pt>
                <c:pt idx="32">
                  <c:v>1536.38</c:v>
                </c:pt>
                <c:pt idx="33">
                  <c:v>1686.45</c:v>
                </c:pt>
                <c:pt idx="34">
                  <c:v>1490.42</c:v>
                </c:pt>
                <c:pt idx="35">
                  <c:v>1267.04</c:v>
                </c:pt>
                <c:pt idx="36">
                  <c:v>1427.11</c:v>
                </c:pt>
                <c:pt idx="37">
                  <c:v>1440.4</c:v>
                </c:pt>
                <c:pt idx="38">
                  <c:v>1066.93</c:v>
                </c:pt>
                <c:pt idx="39">
                  <c:v>1309.27</c:v>
                </c:pt>
                <c:pt idx="40">
                  <c:v>1306.3</c:v>
                </c:pt>
                <c:pt idx="41">
                  <c:v>1474.17</c:v>
                </c:pt>
                <c:pt idx="42">
                  <c:v>1027.67</c:v>
                </c:pt>
                <c:pt idx="43">
                  <c:v>1552.71</c:v>
                </c:pt>
                <c:pt idx="44">
                  <c:v>1659.43</c:v>
                </c:pt>
                <c:pt idx="45">
                  <c:v>1200.04</c:v>
                </c:pt>
                <c:pt idx="46">
                  <c:v>1333.42</c:v>
                </c:pt>
                <c:pt idx="47">
                  <c:v>1115.1500000000001</c:v>
                </c:pt>
                <c:pt idx="48">
                  <c:v>968.38000000000102</c:v>
                </c:pt>
                <c:pt idx="49">
                  <c:v>1122.5999999999999</c:v>
                </c:pt>
                <c:pt idx="50">
                  <c:v>1424.11</c:v>
                </c:pt>
                <c:pt idx="51">
                  <c:v>2959.0999999999899</c:v>
                </c:pt>
                <c:pt idx="52">
                  <c:v>2467.4899999999898</c:v>
                </c:pt>
                <c:pt idx="53">
                  <c:v>2977.6499999999901</c:v>
                </c:pt>
                <c:pt idx="54">
                  <c:v>2571.4899999999898</c:v>
                </c:pt>
                <c:pt idx="55">
                  <c:v>2908.7199999999798</c:v>
                </c:pt>
                <c:pt idx="56">
                  <c:v>2947.6599999999899</c:v>
                </c:pt>
                <c:pt idx="57">
                  <c:v>3236.6199999999899</c:v>
                </c:pt>
                <c:pt idx="58">
                  <c:v>4642.0599999999904</c:v>
                </c:pt>
                <c:pt idx="59">
                  <c:v>3025.8999999999901</c:v>
                </c:pt>
                <c:pt idx="60">
                  <c:v>2559.3399999999901</c:v>
                </c:pt>
                <c:pt idx="61">
                  <c:v>2541.9399999999901</c:v>
                </c:pt>
                <c:pt idx="62">
                  <c:v>2506.74999999999</c:v>
                </c:pt>
                <c:pt idx="63">
                  <c:v>2061.6899999999901</c:v>
                </c:pt>
                <c:pt idx="64">
                  <c:v>2270.3699999999899</c:v>
                </c:pt>
                <c:pt idx="65">
                  <c:v>2095.4899999999998</c:v>
                </c:pt>
                <c:pt idx="66">
                  <c:v>2493.3699999999899</c:v>
                </c:pt>
                <c:pt idx="67">
                  <c:v>2088.9</c:v>
                </c:pt>
                <c:pt idx="68">
                  <c:v>2351.1</c:v>
                </c:pt>
                <c:pt idx="69">
                  <c:v>2588.99999999999</c:v>
                </c:pt>
                <c:pt idx="70">
                  <c:v>2628.51999999999</c:v>
                </c:pt>
                <c:pt idx="71">
                  <c:v>2498.17</c:v>
                </c:pt>
                <c:pt idx="72">
                  <c:v>2604.1599999999899</c:v>
                </c:pt>
                <c:pt idx="73">
                  <c:v>2531.8799999999901</c:v>
                </c:pt>
                <c:pt idx="74">
                  <c:v>3252.6299999999901</c:v>
                </c:pt>
                <c:pt idx="75">
                  <c:v>3276.6799999999898</c:v>
                </c:pt>
                <c:pt idx="76">
                  <c:v>3299.5999999999899</c:v>
                </c:pt>
                <c:pt idx="77">
                  <c:v>3293.6699999999901</c:v>
                </c:pt>
                <c:pt idx="78">
                  <c:v>2906.16</c:v>
                </c:pt>
                <c:pt idx="79">
                  <c:v>2877.66</c:v>
                </c:pt>
                <c:pt idx="80">
                  <c:v>2840.6</c:v>
                </c:pt>
                <c:pt idx="81">
                  <c:v>3205.45999999999</c:v>
                </c:pt>
                <c:pt idx="82">
                  <c:v>3080.6299999999901</c:v>
                </c:pt>
                <c:pt idx="83">
                  <c:v>3255.9299999999898</c:v>
                </c:pt>
                <c:pt idx="84">
                  <c:v>3066.5599999999899</c:v>
                </c:pt>
                <c:pt idx="85">
                  <c:v>3051.74999999999</c:v>
                </c:pt>
                <c:pt idx="86">
                  <c:v>3094.38</c:v>
                </c:pt>
                <c:pt idx="87">
                  <c:v>3284.48</c:v>
                </c:pt>
                <c:pt idx="88">
                  <c:v>2953.9499999999898</c:v>
                </c:pt>
                <c:pt idx="89">
                  <c:v>2932.0899999999901</c:v>
                </c:pt>
                <c:pt idx="90">
                  <c:v>3131.9399999999901</c:v>
                </c:pt>
                <c:pt idx="91">
                  <c:v>2475.72999999999</c:v>
                </c:pt>
                <c:pt idx="92">
                  <c:v>3344.16</c:v>
                </c:pt>
                <c:pt idx="93">
                  <c:v>2991.3299999999899</c:v>
                </c:pt>
                <c:pt idx="94">
                  <c:v>2845.0099999999902</c:v>
                </c:pt>
                <c:pt idx="95">
                  <c:v>2927.6599999999899</c:v>
                </c:pt>
                <c:pt idx="96">
                  <c:v>3286.3599999999901</c:v>
                </c:pt>
                <c:pt idx="97">
                  <c:v>2922.84</c:v>
                </c:pt>
                <c:pt idx="98">
                  <c:v>2857.6699999999901</c:v>
                </c:pt>
                <c:pt idx="99">
                  <c:v>3301.19999999998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4B0-4D26-8373-AFD5E8AD33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32928320"/>
        <c:axId val="532924384"/>
      </c:lineChart>
      <c:catAx>
        <c:axId val="53292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32924384"/>
        <c:crosses val="autoZero"/>
        <c:auto val="1"/>
        <c:lblAlgn val="ctr"/>
        <c:lblOffset val="100"/>
        <c:noMultiLvlLbl val="0"/>
      </c:catAx>
      <c:valAx>
        <c:axId val="532924384"/>
        <c:scaling>
          <c:orientation val="minMax"/>
          <c:max val="9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32928320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61437920851394801"/>
          <c:y val="0.18996763754045309"/>
          <c:w val="0.3310200240787125"/>
          <c:h val="7.8017189598872966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GG-TTS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gg_TTS!$A$2</c:f>
              <c:strCache>
                <c:ptCount val="1"/>
                <c:pt idx="0">
                  <c:v>E20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gg_TTS!$B$1:$CW$1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TS!$B$2:$CW$2</c:f>
              <c:numCache>
                <c:formatCode>General</c:formatCode>
                <c:ptCount val="100"/>
                <c:pt idx="0">
                  <c:v>1196.8800000000001</c:v>
                </c:pt>
                <c:pt idx="1">
                  <c:v>2999.99</c:v>
                </c:pt>
                <c:pt idx="2">
                  <c:v>5028.04</c:v>
                </c:pt>
                <c:pt idx="3">
                  <c:v>2242.71</c:v>
                </c:pt>
                <c:pt idx="4">
                  <c:v>2985.91</c:v>
                </c:pt>
                <c:pt idx="5">
                  <c:v>2793.08</c:v>
                </c:pt>
                <c:pt idx="6">
                  <c:v>2952.29</c:v>
                </c:pt>
                <c:pt idx="7">
                  <c:v>2752.1</c:v>
                </c:pt>
                <c:pt idx="8">
                  <c:v>2216.34</c:v>
                </c:pt>
                <c:pt idx="9">
                  <c:v>2824.3</c:v>
                </c:pt>
                <c:pt idx="10">
                  <c:v>2911.85</c:v>
                </c:pt>
                <c:pt idx="11">
                  <c:v>3011.4099999999899</c:v>
                </c:pt>
                <c:pt idx="12">
                  <c:v>2407.5300000000002</c:v>
                </c:pt>
                <c:pt idx="13">
                  <c:v>2695.68</c:v>
                </c:pt>
                <c:pt idx="14">
                  <c:v>3160.91</c:v>
                </c:pt>
                <c:pt idx="15">
                  <c:v>2888.44</c:v>
                </c:pt>
                <c:pt idx="16">
                  <c:v>2742.37</c:v>
                </c:pt>
                <c:pt idx="17">
                  <c:v>3168</c:v>
                </c:pt>
                <c:pt idx="18">
                  <c:v>3163.35</c:v>
                </c:pt>
                <c:pt idx="19">
                  <c:v>2375.52</c:v>
                </c:pt>
                <c:pt idx="20">
                  <c:v>3043.36</c:v>
                </c:pt>
                <c:pt idx="21">
                  <c:v>2922.48</c:v>
                </c:pt>
                <c:pt idx="22">
                  <c:v>2687.89</c:v>
                </c:pt>
                <c:pt idx="23">
                  <c:v>2911.88</c:v>
                </c:pt>
                <c:pt idx="24">
                  <c:v>2738.08</c:v>
                </c:pt>
                <c:pt idx="25">
                  <c:v>2808.21</c:v>
                </c:pt>
                <c:pt idx="26">
                  <c:v>3057.83</c:v>
                </c:pt>
                <c:pt idx="27">
                  <c:v>2945.2799999999902</c:v>
                </c:pt>
                <c:pt idx="28">
                  <c:v>2740.8</c:v>
                </c:pt>
                <c:pt idx="29">
                  <c:v>3109.05</c:v>
                </c:pt>
                <c:pt idx="30">
                  <c:v>2898.21</c:v>
                </c:pt>
                <c:pt idx="31">
                  <c:v>3564.07</c:v>
                </c:pt>
                <c:pt idx="32">
                  <c:v>3557.1</c:v>
                </c:pt>
                <c:pt idx="33">
                  <c:v>3584.39</c:v>
                </c:pt>
                <c:pt idx="34">
                  <c:v>3315.55</c:v>
                </c:pt>
                <c:pt idx="35">
                  <c:v>4577.72</c:v>
                </c:pt>
                <c:pt idx="36">
                  <c:v>3562.24</c:v>
                </c:pt>
                <c:pt idx="37">
                  <c:v>3236.64</c:v>
                </c:pt>
                <c:pt idx="38">
                  <c:v>3478.1599999999899</c:v>
                </c:pt>
                <c:pt idx="39">
                  <c:v>3621.92</c:v>
                </c:pt>
                <c:pt idx="40">
                  <c:v>3401.05</c:v>
                </c:pt>
                <c:pt idx="41">
                  <c:v>3855.26</c:v>
                </c:pt>
                <c:pt idx="42">
                  <c:v>3437.4299999999898</c:v>
                </c:pt>
                <c:pt idx="43">
                  <c:v>3929.8399999999901</c:v>
                </c:pt>
                <c:pt idx="44">
                  <c:v>3144.71</c:v>
                </c:pt>
                <c:pt idx="45">
                  <c:v>2856.89</c:v>
                </c:pt>
                <c:pt idx="46">
                  <c:v>2301.4199999999901</c:v>
                </c:pt>
                <c:pt idx="47">
                  <c:v>2188.61</c:v>
                </c:pt>
                <c:pt idx="48">
                  <c:v>2525.86</c:v>
                </c:pt>
                <c:pt idx="49">
                  <c:v>2599.51999999999</c:v>
                </c:pt>
                <c:pt idx="50">
                  <c:v>2178.41</c:v>
                </c:pt>
                <c:pt idx="51">
                  <c:v>1294.95</c:v>
                </c:pt>
                <c:pt idx="52">
                  <c:v>1459.06</c:v>
                </c:pt>
                <c:pt idx="53">
                  <c:v>1230.4000000000001</c:v>
                </c:pt>
                <c:pt idx="54">
                  <c:v>1466.82</c:v>
                </c:pt>
                <c:pt idx="55">
                  <c:v>1371.71</c:v>
                </c:pt>
                <c:pt idx="56">
                  <c:v>1476.62</c:v>
                </c:pt>
                <c:pt idx="57">
                  <c:v>1424.72</c:v>
                </c:pt>
                <c:pt idx="58">
                  <c:v>1306.58</c:v>
                </c:pt>
                <c:pt idx="59">
                  <c:v>1572.7</c:v>
                </c:pt>
                <c:pt idx="60">
                  <c:v>1504.63</c:v>
                </c:pt>
                <c:pt idx="61">
                  <c:v>1158.99</c:v>
                </c:pt>
                <c:pt idx="62">
                  <c:v>1247.32</c:v>
                </c:pt>
                <c:pt idx="63">
                  <c:v>1170.18</c:v>
                </c:pt>
                <c:pt idx="64">
                  <c:v>1604.59</c:v>
                </c:pt>
                <c:pt idx="65">
                  <c:v>1776.64</c:v>
                </c:pt>
                <c:pt idx="66">
                  <c:v>1489.56</c:v>
                </c:pt>
                <c:pt idx="67">
                  <c:v>1579.99</c:v>
                </c:pt>
                <c:pt idx="68">
                  <c:v>1379.85</c:v>
                </c:pt>
                <c:pt idx="69">
                  <c:v>1647.31</c:v>
                </c:pt>
                <c:pt idx="70">
                  <c:v>1306.8900000000001</c:v>
                </c:pt>
                <c:pt idx="71">
                  <c:v>1422.63</c:v>
                </c:pt>
                <c:pt idx="72">
                  <c:v>1257.77</c:v>
                </c:pt>
                <c:pt idx="73">
                  <c:v>1575.21</c:v>
                </c:pt>
                <c:pt idx="74">
                  <c:v>1449.59</c:v>
                </c:pt>
                <c:pt idx="75">
                  <c:v>1349.35</c:v>
                </c:pt>
                <c:pt idx="76">
                  <c:v>1974.44</c:v>
                </c:pt>
                <c:pt idx="77">
                  <c:v>1753.61</c:v>
                </c:pt>
                <c:pt idx="78">
                  <c:v>1864.81</c:v>
                </c:pt>
                <c:pt idx="79">
                  <c:v>1670.88</c:v>
                </c:pt>
                <c:pt idx="80">
                  <c:v>1481.89</c:v>
                </c:pt>
                <c:pt idx="81">
                  <c:v>1587.42</c:v>
                </c:pt>
                <c:pt idx="82">
                  <c:v>1809.36</c:v>
                </c:pt>
                <c:pt idx="83">
                  <c:v>1378.09</c:v>
                </c:pt>
                <c:pt idx="84">
                  <c:v>1897.37</c:v>
                </c:pt>
                <c:pt idx="85">
                  <c:v>1470.37</c:v>
                </c:pt>
                <c:pt idx="86">
                  <c:v>1501.13</c:v>
                </c:pt>
                <c:pt idx="87">
                  <c:v>1591.67</c:v>
                </c:pt>
                <c:pt idx="88">
                  <c:v>1655.37</c:v>
                </c:pt>
                <c:pt idx="89">
                  <c:v>1175.81</c:v>
                </c:pt>
                <c:pt idx="90">
                  <c:v>1692.96</c:v>
                </c:pt>
                <c:pt idx="91">
                  <c:v>1746.95</c:v>
                </c:pt>
                <c:pt idx="92">
                  <c:v>1665.58</c:v>
                </c:pt>
                <c:pt idx="93">
                  <c:v>1923.35</c:v>
                </c:pt>
                <c:pt idx="94">
                  <c:v>1784.06</c:v>
                </c:pt>
                <c:pt idx="95">
                  <c:v>1658.19</c:v>
                </c:pt>
                <c:pt idx="96">
                  <c:v>1495.12</c:v>
                </c:pt>
                <c:pt idx="97">
                  <c:v>1694.67</c:v>
                </c:pt>
                <c:pt idx="98">
                  <c:v>3534.78</c:v>
                </c:pt>
                <c:pt idx="99">
                  <c:v>2037.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2EC-4E34-96CB-732E1CE6092E}"/>
            </c:ext>
          </c:extLst>
        </c:ser>
        <c:ser>
          <c:idx val="1"/>
          <c:order val="1"/>
          <c:tx>
            <c:strRef>
              <c:f>ccgg_TTS!$A$3</c:f>
              <c:strCache>
                <c:ptCount val="1"/>
                <c:pt idx="0">
                  <c:v>E20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gg_TTS!$B$1:$CW$1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TS!$B$3:$CW$3</c:f>
              <c:numCache>
                <c:formatCode>General</c:formatCode>
                <c:ptCount val="100"/>
                <c:pt idx="0">
                  <c:v>1241.8900000000001</c:v>
                </c:pt>
                <c:pt idx="1">
                  <c:v>2931.7599999999902</c:v>
                </c:pt>
                <c:pt idx="2">
                  <c:v>3196.6799999999898</c:v>
                </c:pt>
                <c:pt idx="3">
                  <c:v>2142.1499999999901</c:v>
                </c:pt>
                <c:pt idx="4">
                  <c:v>2814.2799999999902</c:v>
                </c:pt>
                <c:pt idx="5">
                  <c:v>2688.2599999999902</c:v>
                </c:pt>
                <c:pt idx="6">
                  <c:v>2640.8599999999901</c:v>
                </c:pt>
                <c:pt idx="7">
                  <c:v>2620.8399999999901</c:v>
                </c:pt>
                <c:pt idx="8">
                  <c:v>2120.6799999999898</c:v>
                </c:pt>
                <c:pt idx="9">
                  <c:v>2767.24999999999</c:v>
                </c:pt>
                <c:pt idx="10">
                  <c:v>2656.02</c:v>
                </c:pt>
                <c:pt idx="11">
                  <c:v>2955.0899999999901</c:v>
                </c:pt>
                <c:pt idx="12">
                  <c:v>2362.5699999999902</c:v>
                </c:pt>
                <c:pt idx="13">
                  <c:v>2601.96</c:v>
                </c:pt>
                <c:pt idx="14">
                  <c:v>3092.2199999999898</c:v>
                </c:pt>
                <c:pt idx="15">
                  <c:v>2815.1099999999901</c:v>
                </c:pt>
                <c:pt idx="16">
                  <c:v>2737.99999999999</c:v>
                </c:pt>
                <c:pt idx="17">
                  <c:v>3143.3699999999899</c:v>
                </c:pt>
                <c:pt idx="18">
                  <c:v>3035.0599999999899</c:v>
                </c:pt>
                <c:pt idx="19">
                  <c:v>2345.51999999999</c:v>
                </c:pt>
                <c:pt idx="20">
                  <c:v>2963.1899999999901</c:v>
                </c:pt>
                <c:pt idx="21">
                  <c:v>2807.3</c:v>
                </c:pt>
                <c:pt idx="22">
                  <c:v>2620.8199999999902</c:v>
                </c:pt>
                <c:pt idx="23">
                  <c:v>2713.1499999999901</c:v>
                </c:pt>
                <c:pt idx="24">
                  <c:v>2787.6899999999901</c:v>
                </c:pt>
                <c:pt idx="25">
                  <c:v>2676.14</c:v>
                </c:pt>
                <c:pt idx="26">
                  <c:v>3046.93</c:v>
                </c:pt>
                <c:pt idx="27">
                  <c:v>2810.21</c:v>
                </c:pt>
                <c:pt idx="28">
                  <c:v>2530.4299999999898</c:v>
                </c:pt>
                <c:pt idx="29">
                  <c:v>3071.0599999999899</c:v>
                </c:pt>
                <c:pt idx="30">
                  <c:v>2949.7199999999898</c:v>
                </c:pt>
                <c:pt idx="31">
                  <c:v>3241.8199999999902</c:v>
                </c:pt>
                <c:pt idx="32">
                  <c:v>3413.1099999999901</c:v>
                </c:pt>
                <c:pt idx="33">
                  <c:v>3394.4399999999901</c:v>
                </c:pt>
                <c:pt idx="34">
                  <c:v>3193.3399999999901</c:v>
                </c:pt>
                <c:pt idx="35">
                  <c:v>4603.1099999999897</c:v>
                </c:pt>
                <c:pt idx="36">
                  <c:v>3422.7199999999898</c:v>
                </c:pt>
                <c:pt idx="37">
                  <c:v>3048.4099999999899</c:v>
                </c:pt>
                <c:pt idx="38">
                  <c:v>3230.3199999999902</c:v>
                </c:pt>
                <c:pt idx="39">
                  <c:v>3560.0599999999899</c:v>
                </c:pt>
                <c:pt idx="40">
                  <c:v>3281.8699999999899</c:v>
                </c:pt>
                <c:pt idx="41">
                  <c:v>3835.74999999999</c:v>
                </c:pt>
                <c:pt idx="42">
                  <c:v>3331.0499999999902</c:v>
                </c:pt>
                <c:pt idx="43">
                  <c:v>3948.6699999999901</c:v>
                </c:pt>
                <c:pt idx="44">
                  <c:v>3168.1199999999899</c:v>
                </c:pt>
                <c:pt idx="45">
                  <c:v>2703.42</c:v>
                </c:pt>
                <c:pt idx="46">
                  <c:v>2368.49999999999</c:v>
                </c:pt>
                <c:pt idx="47">
                  <c:v>2118.48</c:v>
                </c:pt>
                <c:pt idx="48">
                  <c:v>2460.7399999999898</c:v>
                </c:pt>
                <c:pt idx="49">
                  <c:v>2423.6899999999901</c:v>
                </c:pt>
                <c:pt idx="50">
                  <c:v>2109.9299999999998</c:v>
                </c:pt>
                <c:pt idx="51">
                  <c:v>1385.25</c:v>
                </c:pt>
                <c:pt idx="52">
                  <c:v>1430.89</c:v>
                </c:pt>
                <c:pt idx="53">
                  <c:v>1132.8800000000001</c:v>
                </c:pt>
                <c:pt idx="54">
                  <c:v>1370.76</c:v>
                </c:pt>
                <c:pt idx="55">
                  <c:v>1411.46</c:v>
                </c:pt>
                <c:pt idx="56">
                  <c:v>1523.45</c:v>
                </c:pt>
                <c:pt idx="57">
                  <c:v>1477.05</c:v>
                </c:pt>
                <c:pt idx="58">
                  <c:v>1263.71</c:v>
                </c:pt>
                <c:pt idx="59">
                  <c:v>1602.71</c:v>
                </c:pt>
                <c:pt idx="60">
                  <c:v>1497.2</c:v>
                </c:pt>
                <c:pt idx="61">
                  <c:v>1103.98</c:v>
                </c:pt>
                <c:pt idx="62">
                  <c:v>1213.32</c:v>
                </c:pt>
                <c:pt idx="63">
                  <c:v>1099.93</c:v>
                </c:pt>
                <c:pt idx="64">
                  <c:v>1563.46</c:v>
                </c:pt>
                <c:pt idx="65">
                  <c:v>1809.85</c:v>
                </c:pt>
                <c:pt idx="66">
                  <c:v>1487.12</c:v>
                </c:pt>
                <c:pt idx="67">
                  <c:v>1486.33</c:v>
                </c:pt>
                <c:pt idx="68">
                  <c:v>1359.27</c:v>
                </c:pt>
                <c:pt idx="69">
                  <c:v>1607.18</c:v>
                </c:pt>
                <c:pt idx="70">
                  <c:v>1216.18</c:v>
                </c:pt>
                <c:pt idx="71">
                  <c:v>1400.06</c:v>
                </c:pt>
                <c:pt idx="72">
                  <c:v>1201.8699999999999</c:v>
                </c:pt>
                <c:pt idx="73">
                  <c:v>1516.75</c:v>
                </c:pt>
                <c:pt idx="74">
                  <c:v>1448.95</c:v>
                </c:pt>
                <c:pt idx="75">
                  <c:v>1240.31</c:v>
                </c:pt>
                <c:pt idx="76">
                  <c:v>1952.87</c:v>
                </c:pt>
                <c:pt idx="77">
                  <c:v>1642.38</c:v>
                </c:pt>
                <c:pt idx="78">
                  <c:v>1937.72</c:v>
                </c:pt>
                <c:pt idx="79">
                  <c:v>1670.91</c:v>
                </c:pt>
                <c:pt idx="80">
                  <c:v>1519.76</c:v>
                </c:pt>
                <c:pt idx="81">
                  <c:v>1572.42</c:v>
                </c:pt>
                <c:pt idx="82">
                  <c:v>1917.34</c:v>
                </c:pt>
                <c:pt idx="83">
                  <c:v>1444.13</c:v>
                </c:pt>
                <c:pt idx="84">
                  <c:v>1890.66</c:v>
                </c:pt>
                <c:pt idx="85">
                  <c:v>1586.84</c:v>
                </c:pt>
                <c:pt idx="86">
                  <c:v>1593.84</c:v>
                </c:pt>
                <c:pt idx="87">
                  <c:v>1534.94</c:v>
                </c:pt>
                <c:pt idx="88">
                  <c:v>1640.13</c:v>
                </c:pt>
                <c:pt idx="89">
                  <c:v>1105.46</c:v>
                </c:pt>
                <c:pt idx="90">
                  <c:v>1528.27</c:v>
                </c:pt>
                <c:pt idx="91">
                  <c:v>1773.2</c:v>
                </c:pt>
                <c:pt idx="92">
                  <c:v>1631.66</c:v>
                </c:pt>
                <c:pt idx="93">
                  <c:v>1967.03</c:v>
                </c:pt>
                <c:pt idx="94">
                  <c:v>1769.78</c:v>
                </c:pt>
                <c:pt idx="95">
                  <c:v>1456.4</c:v>
                </c:pt>
                <c:pt idx="96">
                  <c:v>1418.98</c:v>
                </c:pt>
                <c:pt idx="97">
                  <c:v>1686.12</c:v>
                </c:pt>
                <c:pt idx="98">
                  <c:v>3045.17</c:v>
                </c:pt>
                <c:pt idx="99">
                  <c:v>1895.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2EC-4E34-96CB-732E1CE609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1353552"/>
        <c:axId val="641349944"/>
      </c:lineChart>
      <c:catAx>
        <c:axId val="641353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41349944"/>
        <c:crosses val="autoZero"/>
        <c:auto val="1"/>
        <c:lblAlgn val="ctr"/>
        <c:lblOffset val="100"/>
        <c:noMultiLvlLbl val="0"/>
      </c:catAx>
      <c:valAx>
        <c:axId val="641349944"/>
        <c:scaling>
          <c:orientation val="minMax"/>
          <c:max val="1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41353552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61162169225957286"/>
          <c:y val="0.18891954022988508"/>
          <c:w val="0.3316028058112454"/>
          <c:h val="7.7586749932120558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WGG-TSS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wgg_TSS!$A$2</c:f>
              <c:strCache>
                <c:ptCount val="1"/>
                <c:pt idx="0">
                  <c:v>E20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wgg_TSS!$B$1:$CW$1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SS!$B$2:$CW$2</c:f>
              <c:numCache>
                <c:formatCode>General</c:formatCode>
                <c:ptCount val="100"/>
                <c:pt idx="0">
                  <c:v>719.52</c:v>
                </c:pt>
                <c:pt idx="1">
                  <c:v>1276.97</c:v>
                </c:pt>
                <c:pt idx="2">
                  <c:v>1256.9000000000001</c:v>
                </c:pt>
                <c:pt idx="3">
                  <c:v>1257.25</c:v>
                </c:pt>
                <c:pt idx="4">
                  <c:v>1294.53</c:v>
                </c:pt>
                <c:pt idx="5">
                  <c:v>1695.61</c:v>
                </c:pt>
                <c:pt idx="6">
                  <c:v>1231.9000000000001</c:v>
                </c:pt>
                <c:pt idx="7">
                  <c:v>1234.8699999999999</c:v>
                </c:pt>
                <c:pt idx="8">
                  <c:v>1251.22</c:v>
                </c:pt>
                <c:pt idx="9">
                  <c:v>1285.1400000000001</c:v>
                </c:pt>
                <c:pt idx="10">
                  <c:v>1319.41</c:v>
                </c:pt>
                <c:pt idx="11">
                  <c:v>1716.88</c:v>
                </c:pt>
                <c:pt idx="12">
                  <c:v>1180.54</c:v>
                </c:pt>
                <c:pt idx="13">
                  <c:v>1205.42</c:v>
                </c:pt>
                <c:pt idx="14">
                  <c:v>990.650000000001</c:v>
                </c:pt>
                <c:pt idx="15">
                  <c:v>1427.1</c:v>
                </c:pt>
                <c:pt idx="16">
                  <c:v>1132.1099999999999</c:v>
                </c:pt>
                <c:pt idx="17">
                  <c:v>1114.9100000000001</c:v>
                </c:pt>
                <c:pt idx="18">
                  <c:v>1408.41</c:v>
                </c:pt>
                <c:pt idx="19">
                  <c:v>1156.6600000000001</c:v>
                </c:pt>
                <c:pt idx="20">
                  <c:v>1250.21</c:v>
                </c:pt>
                <c:pt idx="21">
                  <c:v>1355.53</c:v>
                </c:pt>
                <c:pt idx="22">
                  <c:v>1026.3599999999999</c:v>
                </c:pt>
                <c:pt idx="23">
                  <c:v>1329.54</c:v>
                </c:pt>
                <c:pt idx="24">
                  <c:v>1472.57</c:v>
                </c:pt>
                <c:pt idx="25">
                  <c:v>1086.3</c:v>
                </c:pt>
                <c:pt idx="26">
                  <c:v>1448.75</c:v>
                </c:pt>
                <c:pt idx="27">
                  <c:v>1185.68</c:v>
                </c:pt>
                <c:pt idx="28">
                  <c:v>1273.73</c:v>
                </c:pt>
                <c:pt idx="29">
                  <c:v>1017.79</c:v>
                </c:pt>
                <c:pt idx="30">
                  <c:v>1423.73</c:v>
                </c:pt>
                <c:pt idx="31">
                  <c:v>1328.75</c:v>
                </c:pt>
                <c:pt idx="32">
                  <c:v>1382.04</c:v>
                </c:pt>
                <c:pt idx="33">
                  <c:v>1355.92</c:v>
                </c:pt>
                <c:pt idx="34">
                  <c:v>1210.31</c:v>
                </c:pt>
                <c:pt idx="35">
                  <c:v>1133.97</c:v>
                </c:pt>
                <c:pt idx="36">
                  <c:v>1130.6099999999999</c:v>
                </c:pt>
                <c:pt idx="37">
                  <c:v>1493.37</c:v>
                </c:pt>
                <c:pt idx="38">
                  <c:v>1273.96</c:v>
                </c:pt>
                <c:pt idx="39">
                  <c:v>1357.02</c:v>
                </c:pt>
                <c:pt idx="40">
                  <c:v>1257.22</c:v>
                </c:pt>
                <c:pt idx="41">
                  <c:v>1060.18</c:v>
                </c:pt>
                <c:pt idx="42">
                  <c:v>1711.36</c:v>
                </c:pt>
                <c:pt idx="43">
                  <c:v>1230.44</c:v>
                </c:pt>
                <c:pt idx="44">
                  <c:v>1570.15</c:v>
                </c:pt>
                <c:pt idx="45">
                  <c:v>1154.73</c:v>
                </c:pt>
                <c:pt idx="46">
                  <c:v>1620.03</c:v>
                </c:pt>
                <c:pt idx="47">
                  <c:v>1367.5</c:v>
                </c:pt>
                <c:pt idx="48">
                  <c:v>1304.17</c:v>
                </c:pt>
                <c:pt idx="49">
                  <c:v>1197.68</c:v>
                </c:pt>
                <c:pt idx="50">
                  <c:v>1681.75</c:v>
                </c:pt>
                <c:pt idx="51">
                  <c:v>2571.22999999999</c:v>
                </c:pt>
                <c:pt idx="52">
                  <c:v>2524.6199999999899</c:v>
                </c:pt>
                <c:pt idx="53">
                  <c:v>2203.2399999999898</c:v>
                </c:pt>
                <c:pt idx="54">
                  <c:v>2146.53999999999</c:v>
                </c:pt>
                <c:pt idx="55">
                  <c:v>1805.85</c:v>
                </c:pt>
                <c:pt idx="56">
                  <c:v>1810.96</c:v>
                </c:pt>
                <c:pt idx="57">
                  <c:v>1674.3</c:v>
                </c:pt>
                <c:pt idx="58">
                  <c:v>1787.99</c:v>
                </c:pt>
                <c:pt idx="59">
                  <c:v>2216.27</c:v>
                </c:pt>
                <c:pt idx="60">
                  <c:v>1941.28</c:v>
                </c:pt>
                <c:pt idx="61">
                  <c:v>1569.93</c:v>
                </c:pt>
                <c:pt idx="62">
                  <c:v>1646.03</c:v>
                </c:pt>
                <c:pt idx="63">
                  <c:v>1415.84</c:v>
                </c:pt>
                <c:pt idx="64">
                  <c:v>1520.93</c:v>
                </c:pt>
                <c:pt idx="65">
                  <c:v>1633.38</c:v>
                </c:pt>
                <c:pt idx="66">
                  <c:v>1546.94</c:v>
                </c:pt>
                <c:pt idx="67">
                  <c:v>1481.34</c:v>
                </c:pt>
                <c:pt idx="68">
                  <c:v>1732.44</c:v>
                </c:pt>
                <c:pt idx="69">
                  <c:v>1309.26</c:v>
                </c:pt>
                <c:pt idx="70">
                  <c:v>1630.77</c:v>
                </c:pt>
                <c:pt idx="71">
                  <c:v>1525.68</c:v>
                </c:pt>
                <c:pt idx="72">
                  <c:v>1559.56</c:v>
                </c:pt>
                <c:pt idx="73">
                  <c:v>1472.74</c:v>
                </c:pt>
                <c:pt idx="74">
                  <c:v>1528.66</c:v>
                </c:pt>
                <c:pt idx="75">
                  <c:v>1251.3</c:v>
                </c:pt>
                <c:pt idx="76">
                  <c:v>1463.15</c:v>
                </c:pt>
                <c:pt idx="77">
                  <c:v>1458.71</c:v>
                </c:pt>
                <c:pt idx="78">
                  <c:v>1346.93</c:v>
                </c:pt>
                <c:pt idx="79">
                  <c:v>1771.15</c:v>
                </c:pt>
                <c:pt idx="80">
                  <c:v>1641.81</c:v>
                </c:pt>
                <c:pt idx="81">
                  <c:v>1224.4000000000001</c:v>
                </c:pt>
                <c:pt idx="82">
                  <c:v>1842.65</c:v>
                </c:pt>
                <c:pt idx="83">
                  <c:v>1465.06</c:v>
                </c:pt>
                <c:pt idx="84">
                  <c:v>1496.29</c:v>
                </c:pt>
                <c:pt idx="85">
                  <c:v>1298.51</c:v>
                </c:pt>
                <c:pt idx="86">
                  <c:v>1241.42</c:v>
                </c:pt>
                <c:pt idx="87">
                  <c:v>1254.24</c:v>
                </c:pt>
                <c:pt idx="88">
                  <c:v>1258.96</c:v>
                </c:pt>
                <c:pt idx="89">
                  <c:v>1292.2</c:v>
                </c:pt>
                <c:pt idx="90">
                  <c:v>1412.46</c:v>
                </c:pt>
                <c:pt idx="91">
                  <c:v>1351.43</c:v>
                </c:pt>
                <c:pt idx="92">
                  <c:v>1387.49</c:v>
                </c:pt>
                <c:pt idx="93">
                  <c:v>1251.93</c:v>
                </c:pt>
                <c:pt idx="94">
                  <c:v>1595.08</c:v>
                </c:pt>
                <c:pt idx="95">
                  <c:v>1488.38</c:v>
                </c:pt>
                <c:pt idx="96">
                  <c:v>1325.31</c:v>
                </c:pt>
                <c:pt idx="97">
                  <c:v>1658.63</c:v>
                </c:pt>
                <c:pt idx="98">
                  <c:v>1037.76</c:v>
                </c:pt>
                <c:pt idx="99">
                  <c:v>1886.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164-449E-A918-4BE441A6D282}"/>
            </c:ext>
          </c:extLst>
        </c:ser>
        <c:ser>
          <c:idx val="1"/>
          <c:order val="1"/>
          <c:tx>
            <c:strRef>
              <c:f>ccwgg_TSS!$A$3</c:f>
              <c:strCache>
                <c:ptCount val="1"/>
                <c:pt idx="0">
                  <c:v>E20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wgg_TSS!$B$1:$CW$1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SS!$B$3:$CW$3</c:f>
              <c:numCache>
                <c:formatCode>General</c:formatCode>
                <c:ptCount val="100"/>
                <c:pt idx="0">
                  <c:v>715.53</c:v>
                </c:pt>
                <c:pt idx="1">
                  <c:v>1209.1500000000001</c:v>
                </c:pt>
                <c:pt idx="2">
                  <c:v>1145.9100000000001</c:v>
                </c:pt>
                <c:pt idx="3">
                  <c:v>1240</c:v>
                </c:pt>
                <c:pt idx="4">
                  <c:v>1279.3699999999999</c:v>
                </c:pt>
                <c:pt idx="5">
                  <c:v>1768.47</c:v>
                </c:pt>
                <c:pt idx="6">
                  <c:v>1299.19</c:v>
                </c:pt>
                <c:pt idx="7">
                  <c:v>1240.76</c:v>
                </c:pt>
                <c:pt idx="8">
                  <c:v>1255.4000000000001</c:v>
                </c:pt>
                <c:pt idx="9">
                  <c:v>1396.95</c:v>
                </c:pt>
                <c:pt idx="10">
                  <c:v>1172.71</c:v>
                </c:pt>
                <c:pt idx="11">
                  <c:v>1671.14</c:v>
                </c:pt>
                <c:pt idx="12">
                  <c:v>1209.94</c:v>
                </c:pt>
                <c:pt idx="13">
                  <c:v>1285</c:v>
                </c:pt>
                <c:pt idx="14">
                  <c:v>857.93</c:v>
                </c:pt>
                <c:pt idx="15">
                  <c:v>1292.31</c:v>
                </c:pt>
                <c:pt idx="16">
                  <c:v>1162.52</c:v>
                </c:pt>
                <c:pt idx="17">
                  <c:v>1102.52</c:v>
                </c:pt>
                <c:pt idx="18">
                  <c:v>1425.71</c:v>
                </c:pt>
                <c:pt idx="19">
                  <c:v>1160.0999999999999</c:v>
                </c:pt>
                <c:pt idx="20">
                  <c:v>1266.78</c:v>
                </c:pt>
                <c:pt idx="21">
                  <c:v>1232.8</c:v>
                </c:pt>
                <c:pt idx="22">
                  <c:v>1041.5999999999999</c:v>
                </c:pt>
                <c:pt idx="23">
                  <c:v>1345.81</c:v>
                </c:pt>
                <c:pt idx="24">
                  <c:v>1458.21</c:v>
                </c:pt>
                <c:pt idx="25">
                  <c:v>1111</c:v>
                </c:pt>
                <c:pt idx="26">
                  <c:v>1489.8</c:v>
                </c:pt>
                <c:pt idx="27">
                  <c:v>1057.83</c:v>
                </c:pt>
                <c:pt idx="28">
                  <c:v>1426.14</c:v>
                </c:pt>
                <c:pt idx="29">
                  <c:v>973.54999999999905</c:v>
                </c:pt>
                <c:pt idx="30">
                  <c:v>1407.91</c:v>
                </c:pt>
                <c:pt idx="31">
                  <c:v>1351.94</c:v>
                </c:pt>
                <c:pt idx="32">
                  <c:v>1401</c:v>
                </c:pt>
                <c:pt idx="33">
                  <c:v>1349.83</c:v>
                </c:pt>
                <c:pt idx="34">
                  <c:v>1282.55</c:v>
                </c:pt>
                <c:pt idx="35">
                  <c:v>1141.45</c:v>
                </c:pt>
                <c:pt idx="36">
                  <c:v>1154.05</c:v>
                </c:pt>
                <c:pt idx="37">
                  <c:v>1469.11</c:v>
                </c:pt>
                <c:pt idx="38">
                  <c:v>1288.68</c:v>
                </c:pt>
                <c:pt idx="39">
                  <c:v>1300.4100000000001</c:v>
                </c:pt>
                <c:pt idx="40">
                  <c:v>1299.5999999999999</c:v>
                </c:pt>
                <c:pt idx="41">
                  <c:v>1126.8399999999999</c:v>
                </c:pt>
                <c:pt idx="42">
                  <c:v>1828.07</c:v>
                </c:pt>
                <c:pt idx="43">
                  <c:v>1286.17</c:v>
                </c:pt>
                <c:pt idx="44">
                  <c:v>1657.69</c:v>
                </c:pt>
                <c:pt idx="45">
                  <c:v>1132.1099999999999</c:v>
                </c:pt>
                <c:pt idx="46">
                  <c:v>1512.51</c:v>
                </c:pt>
                <c:pt idx="47">
                  <c:v>1312.97</c:v>
                </c:pt>
                <c:pt idx="48">
                  <c:v>1414.42</c:v>
                </c:pt>
                <c:pt idx="49">
                  <c:v>1171.82</c:v>
                </c:pt>
                <c:pt idx="50">
                  <c:v>1578.7</c:v>
                </c:pt>
                <c:pt idx="51">
                  <c:v>2597.17</c:v>
                </c:pt>
                <c:pt idx="52">
                  <c:v>2649.4</c:v>
                </c:pt>
                <c:pt idx="53">
                  <c:v>2410.4899999999998</c:v>
                </c:pt>
                <c:pt idx="54">
                  <c:v>2174.52</c:v>
                </c:pt>
                <c:pt idx="55">
                  <c:v>1855.7</c:v>
                </c:pt>
                <c:pt idx="56">
                  <c:v>1775.93</c:v>
                </c:pt>
                <c:pt idx="57">
                  <c:v>1711.82</c:v>
                </c:pt>
                <c:pt idx="58">
                  <c:v>1915.4</c:v>
                </c:pt>
                <c:pt idx="59">
                  <c:v>2267.0300000000002</c:v>
                </c:pt>
                <c:pt idx="60">
                  <c:v>1826.51</c:v>
                </c:pt>
                <c:pt idx="61">
                  <c:v>1569.73</c:v>
                </c:pt>
                <c:pt idx="62">
                  <c:v>1633.07</c:v>
                </c:pt>
                <c:pt idx="63">
                  <c:v>1418.07</c:v>
                </c:pt>
                <c:pt idx="64">
                  <c:v>1552.73</c:v>
                </c:pt>
                <c:pt idx="65">
                  <c:v>1663.01</c:v>
                </c:pt>
                <c:pt idx="66">
                  <c:v>1639.89</c:v>
                </c:pt>
                <c:pt idx="67">
                  <c:v>1365.04</c:v>
                </c:pt>
                <c:pt idx="68">
                  <c:v>1738.1</c:v>
                </c:pt>
                <c:pt idx="69">
                  <c:v>1386.12</c:v>
                </c:pt>
                <c:pt idx="70">
                  <c:v>1699.58</c:v>
                </c:pt>
                <c:pt idx="71">
                  <c:v>1515.9</c:v>
                </c:pt>
                <c:pt idx="72">
                  <c:v>1578.34</c:v>
                </c:pt>
                <c:pt idx="73">
                  <c:v>1633.83</c:v>
                </c:pt>
                <c:pt idx="74">
                  <c:v>1465.89</c:v>
                </c:pt>
                <c:pt idx="75">
                  <c:v>1252.17</c:v>
                </c:pt>
                <c:pt idx="76">
                  <c:v>1492.33</c:v>
                </c:pt>
                <c:pt idx="77">
                  <c:v>1371.43</c:v>
                </c:pt>
                <c:pt idx="78">
                  <c:v>1292.3800000000001</c:v>
                </c:pt>
                <c:pt idx="79">
                  <c:v>1725.13</c:v>
                </c:pt>
                <c:pt idx="80">
                  <c:v>1585.24</c:v>
                </c:pt>
                <c:pt idx="81">
                  <c:v>1172.68</c:v>
                </c:pt>
                <c:pt idx="82">
                  <c:v>1863.46</c:v>
                </c:pt>
                <c:pt idx="83">
                  <c:v>1505.34</c:v>
                </c:pt>
                <c:pt idx="84">
                  <c:v>1476.48</c:v>
                </c:pt>
                <c:pt idx="85">
                  <c:v>1279.8699999999999</c:v>
                </c:pt>
                <c:pt idx="86">
                  <c:v>1284.23</c:v>
                </c:pt>
                <c:pt idx="87">
                  <c:v>1331.71</c:v>
                </c:pt>
                <c:pt idx="88">
                  <c:v>1223.54</c:v>
                </c:pt>
                <c:pt idx="89">
                  <c:v>1317.93</c:v>
                </c:pt>
                <c:pt idx="90">
                  <c:v>1335.4</c:v>
                </c:pt>
                <c:pt idx="91">
                  <c:v>1307.3699999999999</c:v>
                </c:pt>
                <c:pt idx="92">
                  <c:v>1351.24</c:v>
                </c:pt>
                <c:pt idx="93">
                  <c:v>1182.8399999999999</c:v>
                </c:pt>
                <c:pt idx="94">
                  <c:v>1515.77</c:v>
                </c:pt>
                <c:pt idx="95">
                  <c:v>1442.03</c:v>
                </c:pt>
                <c:pt idx="96">
                  <c:v>1448.52</c:v>
                </c:pt>
                <c:pt idx="97">
                  <c:v>1785.11</c:v>
                </c:pt>
                <c:pt idx="98">
                  <c:v>1103.3599999999999</c:v>
                </c:pt>
                <c:pt idx="99">
                  <c:v>1870.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164-449E-A918-4BE441A6D2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82706696"/>
        <c:axId val="682699808"/>
      </c:lineChart>
      <c:catAx>
        <c:axId val="682706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82699808"/>
        <c:crosses val="autoZero"/>
        <c:auto val="1"/>
        <c:lblAlgn val="ctr"/>
        <c:lblOffset val="100"/>
        <c:noMultiLvlLbl val="0"/>
      </c:catAx>
      <c:valAx>
        <c:axId val="6826998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82706696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36354132009907214"/>
          <c:y val="0.75041666666666673"/>
          <c:w val="0.3316028058112454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WGG-gene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wgg_Gene!$A$2</c:f>
              <c:strCache>
                <c:ptCount val="1"/>
                <c:pt idx="0">
                  <c:v>E20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wgg_Gene!$B$1:$CW$1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wgg_Gene!$B$2:$CW$2</c:f>
              <c:numCache>
                <c:formatCode>General</c:formatCode>
                <c:ptCount val="100"/>
                <c:pt idx="0">
                  <c:v>907.87000000000103</c:v>
                </c:pt>
                <c:pt idx="1">
                  <c:v>1544.09</c:v>
                </c:pt>
                <c:pt idx="2">
                  <c:v>1075.54</c:v>
                </c:pt>
                <c:pt idx="3">
                  <c:v>1041.92</c:v>
                </c:pt>
                <c:pt idx="4">
                  <c:v>901.97000000000105</c:v>
                </c:pt>
                <c:pt idx="5">
                  <c:v>1115.3599999999999</c:v>
                </c:pt>
                <c:pt idx="6">
                  <c:v>1345.9</c:v>
                </c:pt>
                <c:pt idx="7">
                  <c:v>1302.31</c:v>
                </c:pt>
                <c:pt idx="8">
                  <c:v>1031.5899999999999</c:v>
                </c:pt>
                <c:pt idx="9">
                  <c:v>869.21000000000095</c:v>
                </c:pt>
                <c:pt idx="10">
                  <c:v>1040.51</c:v>
                </c:pt>
                <c:pt idx="11">
                  <c:v>760.08000000000095</c:v>
                </c:pt>
                <c:pt idx="12">
                  <c:v>879.91000000000099</c:v>
                </c:pt>
                <c:pt idx="13">
                  <c:v>748.12</c:v>
                </c:pt>
                <c:pt idx="14">
                  <c:v>1017.43</c:v>
                </c:pt>
                <c:pt idx="15">
                  <c:v>1069.1400000000001</c:v>
                </c:pt>
                <c:pt idx="16">
                  <c:v>918.650000000001</c:v>
                </c:pt>
                <c:pt idx="17">
                  <c:v>887.76000000000101</c:v>
                </c:pt>
                <c:pt idx="18">
                  <c:v>1336.55</c:v>
                </c:pt>
                <c:pt idx="19">
                  <c:v>845.32000000000096</c:v>
                </c:pt>
                <c:pt idx="20">
                  <c:v>853.85000000000105</c:v>
                </c:pt>
                <c:pt idx="21">
                  <c:v>732.80000000000098</c:v>
                </c:pt>
                <c:pt idx="22">
                  <c:v>905.63000000000102</c:v>
                </c:pt>
                <c:pt idx="23">
                  <c:v>740.61000000000104</c:v>
                </c:pt>
                <c:pt idx="24">
                  <c:v>826.270000000001</c:v>
                </c:pt>
                <c:pt idx="25">
                  <c:v>1006.12</c:v>
                </c:pt>
                <c:pt idx="26">
                  <c:v>819.57000000000096</c:v>
                </c:pt>
                <c:pt idx="27">
                  <c:v>873.92000000000098</c:v>
                </c:pt>
                <c:pt idx="28">
                  <c:v>1101.53</c:v>
                </c:pt>
                <c:pt idx="29">
                  <c:v>1164.9000000000001</c:v>
                </c:pt>
                <c:pt idx="30">
                  <c:v>1164.5</c:v>
                </c:pt>
                <c:pt idx="31">
                  <c:v>759.61000000000104</c:v>
                </c:pt>
                <c:pt idx="32">
                  <c:v>783.89000000000101</c:v>
                </c:pt>
                <c:pt idx="33">
                  <c:v>672.43000000000097</c:v>
                </c:pt>
                <c:pt idx="34">
                  <c:v>906.32000000000096</c:v>
                </c:pt>
                <c:pt idx="35">
                  <c:v>924.64000000000101</c:v>
                </c:pt>
                <c:pt idx="36">
                  <c:v>1386.46</c:v>
                </c:pt>
                <c:pt idx="37">
                  <c:v>1095.56</c:v>
                </c:pt>
                <c:pt idx="38">
                  <c:v>777.14</c:v>
                </c:pt>
                <c:pt idx="39">
                  <c:v>916.400000000001</c:v>
                </c:pt>
                <c:pt idx="40">
                  <c:v>929.37000000000103</c:v>
                </c:pt>
                <c:pt idx="41">
                  <c:v>900.82000000000096</c:v>
                </c:pt>
                <c:pt idx="42">
                  <c:v>901.900000000001</c:v>
                </c:pt>
                <c:pt idx="43">
                  <c:v>944.36000000000104</c:v>
                </c:pt>
                <c:pt idx="44">
                  <c:v>1105.32</c:v>
                </c:pt>
                <c:pt idx="45">
                  <c:v>1079.55</c:v>
                </c:pt>
                <c:pt idx="46">
                  <c:v>960.06000000000097</c:v>
                </c:pt>
                <c:pt idx="47">
                  <c:v>1012.86</c:v>
                </c:pt>
                <c:pt idx="48">
                  <c:v>919.85000000000105</c:v>
                </c:pt>
                <c:pt idx="49">
                  <c:v>994.69000000000199</c:v>
                </c:pt>
                <c:pt idx="50">
                  <c:v>785.650000000001</c:v>
                </c:pt>
                <c:pt idx="51">
                  <c:v>1091.3900000000001</c:v>
                </c:pt>
                <c:pt idx="52">
                  <c:v>956.31000000000097</c:v>
                </c:pt>
                <c:pt idx="53">
                  <c:v>1096.68</c:v>
                </c:pt>
                <c:pt idx="54">
                  <c:v>928.99000000000103</c:v>
                </c:pt>
                <c:pt idx="55">
                  <c:v>945.85000000000105</c:v>
                </c:pt>
                <c:pt idx="56">
                  <c:v>821.71000000000095</c:v>
                </c:pt>
                <c:pt idx="57">
                  <c:v>1320.17</c:v>
                </c:pt>
                <c:pt idx="58">
                  <c:v>957.76000000000101</c:v>
                </c:pt>
                <c:pt idx="59">
                  <c:v>955.09000000000106</c:v>
                </c:pt>
                <c:pt idx="60">
                  <c:v>963.99000000000103</c:v>
                </c:pt>
                <c:pt idx="61">
                  <c:v>981.25000000000102</c:v>
                </c:pt>
                <c:pt idx="62">
                  <c:v>908.20000000000095</c:v>
                </c:pt>
                <c:pt idx="63">
                  <c:v>1012.9</c:v>
                </c:pt>
                <c:pt idx="64">
                  <c:v>1138.77</c:v>
                </c:pt>
                <c:pt idx="65">
                  <c:v>1095.19</c:v>
                </c:pt>
                <c:pt idx="66">
                  <c:v>1043.76</c:v>
                </c:pt>
                <c:pt idx="67">
                  <c:v>779.650000000001</c:v>
                </c:pt>
                <c:pt idx="68">
                  <c:v>1007.69</c:v>
                </c:pt>
                <c:pt idx="69">
                  <c:v>874.280000000001</c:v>
                </c:pt>
                <c:pt idx="70">
                  <c:v>1165.57</c:v>
                </c:pt>
                <c:pt idx="71">
                  <c:v>865.72000000000105</c:v>
                </c:pt>
                <c:pt idx="72">
                  <c:v>966.31000000000097</c:v>
                </c:pt>
                <c:pt idx="73">
                  <c:v>1009.91</c:v>
                </c:pt>
                <c:pt idx="74">
                  <c:v>850.73000000000104</c:v>
                </c:pt>
                <c:pt idx="75">
                  <c:v>892.56000000000097</c:v>
                </c:pt>
                <c:pt idx="76">
                  <c:v>1158.9000000000001</c:v>
                </c:pt>
                <c:pt idx="77">
                  <c:v>1144</c:v>
                </c:pt>
                <c:pt idx="78">
                  <c:v>968.23000000000104</c:v>
                </c:pt>
                <c:pt idx="79">
                  <c:v>1311.58</c:v>
                </c:pt>
                <c:pt idx="80">
                  <c:v>1099.6600000000001</c:v>
                </c:pt>
                <c:pt idx="81">
                  <c:v>959.650000000001</c:v>
                </c:pt>
                <c:pt idx="82">
                  <c:v>942.87000000000103</c:v>
                </c:pt>
                <c:pt idx="83">
                  <c:v>966.32000000000096</c:v>
                </c:pt>
                <c:pt idx="84">
                  <c:v>1054.23</c:v>
                </c:pt>
                <c:pt idx="85">
                  <c:v>1078.74</c:v>
                </c:pt>
                <c:pt idx="86">
                  <c:v>1035.48</c:v>
                </c:pt>
                <c:pt idx="87">
                  <c:v>1232.19</c:v>
                </c:pt>
                <c:pt idx="88">
                  <c:v>1872.55</c:v>
                </c:pt>
                <c:pt idx="89">
                  <c:v>1051.9000000000001</c:v>
                </c:pt>
                <c:pt idx="90">
                  <c:v>1250.0899999999999</c:v>
                </c:pt>
                <c:pt idx="91">
                  <c:v>909.28000000000202</c:v>
                </c:pt>
                <c:pt idx="92">
                  <c:v>882.91000000000099</c:v>
                </c:pt>
                <c:pt idx="93">
                  <c:v>1416.68</c:v>
                </c:pt>
                <c:pt idx="94">
                  <c:v>1274.03</c:v>
                </c:pt>
                <c:pt idx="95">
                  <c:v>1254.97</c:v>
                </c:pt>
                <c:pt idx="96">
                  <c:v>1216.9000000000001</c:v>
                </c:pt>
                <c:pt idx="97">
                  <c:v>1364.19</c:v>
                </c:pt>
                <c:pt idx="98">
                  <c:v>1073.97</c:v>
                </c:pt>
                <c:pt idx="99">
                  <c:v>1251.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828-4DF4-9272-7C51EF921A1B}"/>
            </c:ext>
          </c:extLst>
        </c:ser>
        <c:ser>
          <c:idx val="1"/>
          <c:order val="1"/>
          <c:tx>
            <c:strRef>
              <c:f>ccwgg_Gene!$A$3</c:f>
              <c:strCache>
                <c:ptCount val="1"/>
                <c:pt idx="0">
                  <c:v>E20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wgg_Gene!$B$1:$CW$1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wgg_Gene!$B$3:$CW$3</c:f>
              <c:numCache>
                <c:formatCode>General</c:formatCode>
                <c:ptCount val="100"/>
                <c:pt idx="0">
                  <c:v>842.50999999999897</c:v>
                </c:pt>
                <c:pt idx="1">
                  <c:v>1642.71</c:v>
                </c:pt>
                <c:pt idx="2">
                  <c:v>1100.82</c:v>
                </c:pt>
                <c:pt idx="3">
                  <c:v>1034.77</c:v>
                </c:pt>
                <c:pt idx="4">
                  <c:v>853.08</c:v>
                </c:pt>
                <c:pt idx="5">
                  <c:v>1182.3900000000001</c:v>
                </c:pt>
                <c:pt idx="6">
                  <c:v>1450.87</c:v>
                </c:pt>
                <c:pt idx="7">
                  <c:v>1332.89</c:v>
                </c:pt>
                <c:pt idx="8">
                  <c:v>1086.28</c:v>
                </c:pt>
                <c:pt idx="9">
                  <c:v>863.19</c:v>
                </c:pt>
                <c:pt idx="10">
                  <c:v>1121.58</c:v>
                </c:pt>
                <c:pt idx="11">
                  <c:v>804.87</c:v>
                </c:pt>
                <c:pt idx="12">
                  <c:v>892.75999999999897</c:v>
                </c:pt>
                <c:pt idx="13">
                  <c:v>783.71</c:v>
                </c:pt>
                <c:pt idx="14">
                  <c:v>1008.8</c:v>
                </c:pt>
                <c:pt idx="15">
                  <c:v>1031.53</c:v>
                </c:pt>
                <c:pt idx="16">
                  <c:v>943.92</c:v>
                </c:pt>
                <c:pt idx="17">
                  <c:v>874.54999999999905</c:v>
                </c:pt>
                <c:pt idx="18">
                  <c:v>1325.1</c:v>
                </c:pt>
                <c:pt idx="19">
                  <c:v>814.97</c:v>
                </c:pt>
                <c:pt idx="20">
                  <c:v>801.59</c:v>
                </c:pt>
                <c:pt idx="21">
                  <c:v>753.4</c:v>
                </c:pt>
                <c:pt idx="22">
                  <c:v>920.75999999999897</c:v>
                </c:pt>
                <c:pt idx="23">
                  <c:v>712.86</c:v>
                </c:pt>
                <c:pt idx="24">
                  <c:v>809.69</c:v>
                </c:pt>
                <c:pt idx="25">
                  <c:v>990.60999999999899</c:v>
                </c:pt>
                <c:pt idx="26">
                  <c:v>822.64999999999895</c:v>
                </c:pt>
                <c:pt idx="27">
                  <c:v>839.65999999999894</c:v>
                </c:pt>
                <c:pt idx="28">
                  <c:v>1101.22</c:v>
                </c:pt>
                <c:pt idx="29">
                  <c:v>1147.0999999999999</c:v>
                </c:pt>
                <c:pt idx="30">
                  <c:v>1139.01</c:v>
                </c:pt>
                <c:pt idx="31">
                  <c:v>771.89</c:v>
                </c:pt>
                <c:pt idx="32">
                  <c:v>733.45</c:v>
                </c:pt>
                <c:pt idx="33">
                  <c:v>669.31</c:v>
                </c:pt>
                <c:pt idx="34">
                  <c:v>896.48999999999899</c:v>
                </c:pt>
                <c:pt idx="35">
                  <c:v>851.89</c:v>
                </c:pt>
                <c:pt idx="36">
                  <c:v>1412.76</c:v>
                </c:pt>
                <c:pt idx="37">
                  <c:v>1144.6400000000001</c:v>
                </c:pt>
                <c:pt idx="38">
                  <c:v>787.38</c:v>
                </c:pt>
                <c:pt idx="39">
                  <c:v>878.64</c:v>
                </c:pt>
                <c:pt idx="40">
                  <c:v>939.88999999999896</c:v>
                </c:pt>
                <c:pt idx="41">
                  <c:v>861.24</c:v>
                </c:pt>
                <c:pt idx="42">
                  <c:v>879.45</c:v>
                </c:pt>
                <c:pt idx="43">
                  <c:v>914.349999999999</c:v>
                </c:pt>
                <c:pt idx="44">
                  <c:v>1034.0999999999999</c:v>
                </c:pt>
                <c:pt idx="45">
                  <c:v>1062.8699999999999</c:v>
                </c:pt>
                <c:pt idx="46">
                  <c:v>1059.8800000000001</c:v>
                </c:pt>
                <c:pt idx="47">
                  <c:v>969.86999999999898</c:v>
                </c:pt>
                <c:pt idx="48">
                  <c:v>852.729999999999</c:v>
                </c:pt>
                <c:pt idx="49">
                  <c:v>977.19999999999902</c:v>
                </c:pt>
                <c:pt idx="50">
                  <c:v>812.07999999999902</c:v>
                </c:pt>
                <c:pt idx="51">
                  <c:v>1110.69</c:v>
                </c:pt>
                <c:pt idx="52">
                  <c:v>948.02999999999895</c:v>
                </c:pt>
                <c:pt idx="53">
                  <c:v>1117.58</c:v>
                </c:pt>
                <c:pt idx="54">
                  <c:v>907.40999999999894</c:v>
                </c:pt>
                <c:pt idx="55">
                  <c:v>909.85</c:v>
                </c:pt>
                <c:pt idx="56">
                  <c:v>845.41</c:v>
                </c:pt>
                <c:pt idx="57">
                  <c:v>1510.95</c:v>
                </c:pt>
                <c:pt idx="58">
                  <c:v>960.15999999999894</c:v>
                </c:pt>
                <c:pt idx="59">
                  <c:v>1027.1400000000001</c:v>
                </c:pt>
                <c:pt idx="60">
                  <c:v>962.20999999999901</c:v>
                </c:pt>
                <c:pt idx="61">
                  <c:v>902.23999999999899</c:v>
                </c:pt>
                <c:pt idx="62">
                  <c:v>922.91</c:v>
                </c:pt>
                <c:pt idx="63">
                  <c:v>1051.1300000000001</c:v>
                </c:pt>
                <c:pt idx="64">
                  <c:v>1101.3399999999999</c:v>
                </c:pt>
                <c:pt idx="65">
                  <c:v>1085.08</c:v>
                </c:pt>
                <c:pt idx="66">
                  <c:v>1001.89</c:v>
                </c:pt>
                <c:pt idx="67">
                  <c:v>756.16999999999905</c:v>
                </c:pt>
                <c:pt idx="68">
                  <c:v>1141.46</c:v>
                </c:pt>
                <c:pt idx="69">
                  <c:v>840.54</c:v>
                </c:pt>
                <c:pt idx="70">
                  <c:v>1236.33</c:v>
                </c:pt>
                <c:pt idx="71">
                  <c:v>884.30999999999904</c:v>
                </c:pt>
                <c:pt idx="72">
                  <c:v>895.67999999999904</c:v>
                </c:pt>
                <c:pt idx="73">
                  <c:v>958.13</c:v>
                </c:pt>
                <c:pt idx="74">
                  <c:v>826.33</c:v>
                </c:pt>
                <c:pt idx="75">
                  <c:v>898.56999999999903</c:v>
                </c:pt>
                <c:pt idx="76">
                  <c:v>1156.08</c:v>
                </c:pt>
                <c:pt idx="77">
                  <c:v>1141.3900000000001</c:v>
                </c:pt>
                <c:pt idx="78">
                  <c:v>973.07999999999902</c:v>
                </c:pt>
                <c:pt idx="79">
                  <c:v>1272.43</c:v>
                </c:pt>
                <c:pt idx="80">
                  <c:v>1026.71</c:v>
                </c:pt>
                <c:pt idx="81">
                  <c:v>980.83999999999901</c:v>
                </c:pt>
                <c:pt idx="82">
                  <c:v>882.26</c:v>
                </c:pt>
                <c:pt idx="83">
                  <c:v>906.61999999999898</c:v>
                </c:pt>
                <c:pt idx="84">
                  <c:v>1049.8399999999999</c:v>
                </c:pt>
                <c:pt idx="85">
                  <c:v>1027.8900000000001</c:v>
                </c:pt>
                <c:pt idx="86">
                  <c:v>1128.5</c:v>
                </c:pt>
                <c:pt idx="87">
                  <c:v>1136.28</c:v>
                </c:pt>
                <c:pt idx="88">
                  <c:v>1810.23</c:v>
                </c:pt>
                <c:pt idx="89">
                  <c:v>1018.58</c:v>
                </c:pt>
                <c:pt idx="90">
                  <c:v>1230.29</c:v>
                </c:pt>
                <c:pt idx="91">
                  <c:v>885.43999999999903</c:v>
                </c:pt>
                <c:pt idx="92">
                  <c:v>876.62</c:v>
                </c:pt>
                <c:pt idx="93">
                  <c:v>1452.89</c:v>
                </c:pt>
                <c:pt idx="94">
                  <c:v>1269.24</c:v>
                </c:pt>
                <c:pt idx="95">
                  <c:v>1186.1300000000001</c:v>
                </c:pt>
                <c:pt idx="96">
                  <c:v>1255.3599999999999</c:v>
                </c:pt>
                <c:pt idx="97">
                  <c:v>1323.21</c:v>
                </c:pt>
                <c:pt idx="98">
                  <c:v>1130.9000000000001</c:v>
                </c:pt>
                <c:pt idx="99">
                  <c:v>1303.61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828-4DF4-9272-7C51EF921A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08805528"/>
        <c:axId val="508803888"/>
      </c:lineChart>
      <c:catAx>
        <c:axId val="5088055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08803888"/>
        <c:crosses val="autoZero"/>
        <c:auto val="1"/>
        <c:lblAlgn val="ctr"/>
        <c:lblOffset val="100"/>
        <c:noMultiLvlLbl val="0"/>
      </c:catAx>
      <c:valAx>
        <c:axId val="5088038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08805528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34006714169531627"/>
          <c:y val="0.77819444444444441"/>
          <c:w val="0.3316028058112454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WGG-TTS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wgg_TTS!$A$2</c:f>
              <c:strCache>
                <c:ptCount val="1"/>
                <c:pt idx="0">
                  <c:v>E20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wgg_TTS!$B$1:$CW$1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TS!$B$2:$CW$2</c:f>
              <c:numCache>
                <c:formatCode>General</c:formatCode>
                <c:ptCount val="100"/>
                <c:pt idx="0">
                  <c:v>642.75</c:v>
                </c:pt>
                <c:pt idx="1">
                  <c:v>1027.3900000000001</c:v>
                </c:pt>
                <c:pt idx="2">
                  <c:v>1361.53</c:v>
                </c:pt>
                <c:pt idx="3">
                  <c:v>1221.02</c:v>
                </c:pt>
                <c:pt idx="4">
                  <c:v>1240.8</c:v>
                </c:pt>
                <c:pt idx="5">
                  <c:v>1264.5899999999999</c:v>
                </c:pt>
                <c:pt idx="6">
                  <c:v>1815.57</c:v>
                </c:pt>
                <c:pt idx="7">
                  <c:v>1527.91</c:v>
                </c:pt>
                <c:pt idx="8">
                  <c:v>1386</c:v>
                </c:pt>
                <c:pt idx="9">
                  <c:v>1485.15</c:v>
                </c:pt>
                <c:pt idx="10">
                  <c:v>1326.46</c:v>
                </c:pt>
                <c:pt idx="11">
                  <c:v>2025.23</c:v>
                </c:pt>
                <c:pt idx="12">
                  <c:v>1605.48</c:v>
                </c:pt>
                <c:pt idx="13">
                  <c:v>1477.36</c:v>
                </c:pt>
                <c:pt idx="14">
                  <c:v>1456.44</c:v>
                </c:pt>
                <c:pt idx="15">
                  <c:v>1847.51</c:v>
                </c:pt>
                <c:pt idx="16">
                  <c:v>1370.79</c:v>
                </c:pt>
                <c:pt idx="17">
                  <c:v>1500.01</c:v>
                </c:pt>
                <c:pt idx="18">
                  <c:v>1574.83</c:v>
                </c:pt>
                <c:pt idx="19">
                  <c:v>1290.27</c:v>
                </c:pt>
                <c:pt idx="20">
                  <c:v>1336.1</c:v>
                </c:pt>
                <c:pt idx="21">
                  <c:v>1451.99</c:v>
                </c:pt>
                <c:pt idx="22">
                  <c:v>1362.89</c:v>
                </c:pt>
                <c:pt idx="23">
                  <c:v>1203.25</c:v>
                </c:pt>
                <c:pt idx="24">
                  <c:v>1274.6099999999999</c:v>
                </c:pt>
                <c:pt idx="25">
                  <c:v>1137.93</c:v>
                </c:pt>
                <c:pt idx="26">
                  <c:v>1379.69</c:v>
                </c:pt>
                <c:pt idx="27">
                  <c:v>1532.05</c:v>
                </c:pt>
                <c:pt idx="28">
                  <c:v>1655.65</c:v>
                </c:pt>
                <c:pt idx="29">
                  <c:v>1413.62</c:v>
                </c:pt>
                <c:pt idx="30">
                  <c:v>1472.44</c:v>
                </c:pt>
                <c:pt idx="31">
                  <c:v>1935.11</c:v>
                </c:pt>
                <c:pt idx="32">
                  <c:v>1640</c:v>
                </c:pt>
                <c:pt idx="33">
                  <c:v>1826.1899999999901</c:v>
                </c:pt>
                <c:pt idx="34">
                  <c:v>1706.71</c:v>
                </c:pt>
                <c:pt idx="35">
                  <c:v>1987.18</c:v>
                </c:pt>
                <c:pt idx="36">
                  <c:v>1952.44999999999</c:v>
                </c:pt>
                <c:pt idx="37">
                  <c:v>2622.9399999999901</c:v>
                </c:pt>
                <c:pt idx="38">
                  <c:v>1752.11</c:v>
                </c:pt>
                <c:pt idx="39">
                  <c:v>1929.72999999999</c:v>
                </c:pt>
                <c:pt idx="40">
                  <c:v>1901.48</c:v>
                </c:pt>
                <c:pt idx="41">
                  <c:v>2062.44</c:v>
                </c:pt>
                <c:pt idx="42">
                  <c:v>2165.8699999999899</c:v>
                </c:pt>
                <c:pt idx="43">
                  <c:v>2511.6099999999901</c:v>
                </c:pt>
                <c:pt idx="44">
                  <c:v>2525.7599999999902</c:v>
                </c:pt>
                <c:pt idx="45">
                  <c:v>2194.96</c:v>
                </c:pt>
                <c:pt idx="46">
                  <c:v>1980.81</c:v>
                </c:pt>
                <c:pt idx="47">
                  <c:v>1966.65</c:v>
                </c:pt>
                <c:pt idx="48">
                  <c:v>2492.2199999999898</c:v>
                </c:pt>
                <c:pt idx="49">
                  <c:v>2203.58</c:v>
                </c:pt>
                <c:pt idx="50">
                  <c:v>1904.13</c:v>
                </c:pt>
                <c:pt idx="51">
                  <c:v>1415.19</c:v>
                </c:pt>
                <c:pt idx="52">
                  <c:v>1117.83</c:v>
                </c:pt>
                <c:pt idx="53">
                  <c:v>1063.97</c:v>
                </c:pt>
                <c:pt idx="54">
                  <c:v>1241.27</c:v>
                </c:pt>
                <c:pt idx="55">
                  <c:v>1217.04</c:v>
                </c:pt>
                <c:pt idx="56">
                  <c:v>1073.5999999999999</c:v>
                </c:pt>
                <c:pt idx="57">
                  <c:v>1195.4100000000001</c:v>
                </c:pt>
                <c:pt idx="58">
                  <c:v>1215.57</c:v>
                </c:pt>
                <c:pt idx="59">
                  <c:v>1140.29</c:v>
                </c:pt>
                <c:pt idx="60">
                  <c:v>1329.14</c:v>
                </c:pt>
                <c:pt idx="61">
                  <c:v>1034.05</c:v>
                </c:pt>
                <c:pt idx="62">
                  <c:v>1221.06</c:v>
                </c:pt>
                <c:pt idx="63">
                  <c:v>1567.81</c:v>
                </c:pt>
                <c:pt idx="64">
                  <c:v>1335.42</c:v>
                </c:pt>
                <c:pt idx="65">
                  <c:v>998.030000000001</c:v>
                </c:pt>
                <c:pt idx="66">
                  <c:v>774.11000000000104</c:v>
                </c:pt>
                <c:pt idx="67">
                  <c:v>1154.1500000000001</c:v>
                </c:pt>
                <c:pt idx="68">
                  <c:v>1053.8599999999999</c:v>
                </c:pt>
                <c:pt idx="69">
                  <c:v>1305.3399999999999</c:v>
                </c:pt>
                <c:pt idx="70">
                  <c:v>1247.1600000000001</c:v>
                </c:pt>
                <c:pt idx="71">
                  <c:v>1298.23</c:v>
                </c:pt>
                <c:pt idx="72">
                  <c:v>1646.51</c:v>
                </c:pt>
                <c:pt idx="73">
                  <c:v>1412.55</c:v>
                </c:pt>
                <c:pt idx="74">
                  <c:v>1345.57</c:v>
                </c:pt>
                <c:pt idx="75">
                  <c:v>1547.36</c:v>
                </c:pt>
                <c:pt idx="76">
                  <c:v>1180.52</c:v>
                </c:pt>
                <c:pt idx="77">
                  <c:v>1456.89</c:v>
                </c:pt>
                <c:pt idx="78">
                  <c:v>1176.1300000000001</c:v>
                </c:pt>
                <c:pt idx="79">
                  <c:v>1379.75</c:v>
                </c:pt>
                <c:pt idx="80">
                  <c:v>1085.93</c:v>
                </c:pt>
                <c:pt idx="81">
                  <c:v>1341.06</c:v>
                </c:pt>
                <c:pt idx="82">
                  <c:v>1462.48</c:v>
                </c:pt>
                <c:pt idx="83">
                  <c:v>1092.96</c:v>
                </c:pt>
                <c:pt idx="84">
                  <c:v>1243.4000000000001</c:v>
                </c:pt>
                <c:pt idx="85">
                  <c:v>1316.86</c:v>
                </c:pt>
                <c:pt idx="86">
                  <c:v>1163.74</c:v>
                </c:pt>
                <c:pt idx="87">
                  <c:v>1271.81</c:v>
                </c:pt>
                <c:pt idx="88">
                  <c:v>989.05000000000098</c:v>
                </c:pt>
                <c:pt idx="89">
                  <c:v>1145.54</c:v>
                </c:pt>
                <c:pt idx="90">
                  <c:v>990.58000000000095</c:v>
                </c:pt>
                <c:pt idx="91">
                  <c:v>1279.92</c:v>
                </c:pt>
                <c:pt idx="92">
                  <c:v>1314.65</c:v>
                </c:pt>
                <c:pt idx="93">
                  <c:v>1493.82</c:v>
                </c:pt>
                <c:pt idx="94">
                  <c:v>1547.76</c:v>
                </c:pt>
                <c:pt idx="95">
                  <c:v>1346.91</c:v>
                </c:pt>
                <c:pt idx="96">
                  <c:v>1132.07</c:v>
                </c:pt>
                <c:pt idx="97">
                  <c:v>1322.81</c:v>
                </c:pt>
                <c:pt idx="98">
                  <c:v>1089.94</c:v>
                </c:pt>
                <c:pt idx="99">
                  <c:v>1209.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496-44D9-9F67-64B0C75CEE87}"/>
            </c:ext>
          </c:extLst>
        </c:ser>
        <c:ser>
          <c:idx val="1"/>
          <c:order val="1"/>
          <c:tx>
            <c:strRef>
              <c:f>ccwgg_TTS!$A$3</c:f>
              <c:strCache>
                <c:ptCount val="1"/>
                <c:pt idx="0">
                  <c:v>E20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wgg_TTS!$B$1:$CW$1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wgg_TTS!$B$3:$CW$3</c:f>
              <c:numCache>
                <c:formatCode>General</c:formatCode>
                <c:ptCount val="100"/>
                <c:pt idx="0">
                  <c:v>699.68</c:v>
                </c:pt>
                <c:pt idx="1">
                  <c:v>1017.83</c:v>
                </c:pt>
                <c:pt idx="2">
                  <c:v>1335.33</c:v>
                </c:pt>
                <c:pt idx="3">
                  <c:v>1154.92</c:v>
                </c:pt>
                <c:pt idx="4">
                  <c:v>1215.33</c:v>
                </c:pt>
                <c:pt idx="5">
                  <c:v>1240.44</c:v>
                </c:pt>
                <c:pt idx="6">
                  <c:v>1869.11</c:v>
                </c:pt>
                <c:pt idx="7">
                  <c:v>1504.5</c:v>
                </c:pt>
                <c:pt idx="8">
                  <c:v>1391.28</c:v>
                </c:pt>
                <c:pt idx="9">
                  <c:v>1369.03</c:v>
                </c:pt>
                <c:pt idx="10">
                  <c:v>1358.84</c:v>
                </c:pt>
                <c:pt idx="11">
                  <c:v>2118.9499999999998</c:v>
                </c:pt>
                <c:pt idx="12">
                  <c:v>1787.94</c:v>
                </c:pt>
                <c:pt idx="13">
                  <c:v>1363.64</c:v>
                </c:pt>
                <c:pt idx="14">
                  <c:v>1497.69</c:v>
                </c:pt>
                <c:pt idx="15">
                  <c:v>1833.79</c:v>
                </c:pt>
                <c:pt idx="16">
                  <c:v>1352.81</c:v>
                </c:pt>
                <c:pt idx="17">
                  <c:v>1533.77</c:v>
                </c:pt>
                <c:pt idx="18">
                  <c:v>1569.7</c:v>
                </c:pt>
                <c:pt idx="19">
                  <c:v>1341.1</c:v>
                </c:pt>
                <c:pt idx="20">
                  <c:v>1368.63</c:v>
                </c:pt>
                <c:pt idx="21">
                  <c:v>1427.44</c:v>
                </c:pt>
                <c:pt idx="22">
                  <c:v>1305.74</c:v>
                </c:pt>
                <c:pt idx="23">
                  <c:v>1267.68</c:v>
                </c:pt>
                <c:pt idx="24">
                  <c:v>1253.3399999999999</c:v>
                </c:pt>
                <c:pt idx="25">
                  <c:v>1152.05</c:v>
                </c:pt>
                <c:pt idx="26">
                  <c:v>1258.75</c:v>
                </c:pt>
                <c:pt idx="27">
                  <c:v>1637.98</c:v>
                </c:pt>
                <c:pt idx="28">
                  <c:v>1575.88</c:v>
                </c:pt>
                <c:pt idx="29">
                  <c:v>1498.83</c:v>
                </c:pt>
                <c:pt idx="30">
                  <c:v>1412.88</c:v>
                </c:pt>
                <c:pt idx="31">
                  <c:v>2155.85</c:v>
                </c:pt>
                <c:pt idx="32">
                  <c:v>1561.62</c:v>
                </c:pt>
                <c:pt idx="33">
                  <c:v>1818.45</c:v>
                </c:pt>
                <c:pt idx="34">
                  <c:v>1655.42</c:v>
                </c:pt>
                <c:pt idx="35">
                  <c:v>1957.13</c:v>
                </c:pt>
                <c:pt idx="36">
                  <c:v>1800.24</c:v>
                </c:pt>
                <c:pt idx="37">
                  <c:v>2593.98</c:v>
                </c:pt>
                <c:pt idx="38">
                  <c:v>1712.2</c:v>
                </c:pt>
                <c:pt idx="39">
                  <c:v>2007.88</c:v>
                </c:pt>
                <c:pt idx="40">
                  <c:v>2009.58</c:v>
                </c:pt>
                <c:pt idx="41">
                  <c:v>1995.35</c:v>
                </c:pt>
                <c:pt idx="42">
                  <c:v>2177.4</c:v>
                </c:pt>
                <c:pt idx="43">
                  <c:v>2690.7</c:v>
                </c:pt>
                <c:pt idx="44">
                  <c:v>2507.52</c:v>
                </c:pt>
                <c:pt idx="45">
                  <c:v>2154.2199999999998</c:v>
                </c:pt>
                <c:pt idx="46">
                  <c:v>1980.55</c:v>
                </c:pt>
                <c:pt idx="47">
                  <c:v>1969.28</c:v>
                </c:pt>
                <c:pt idx="48">
                  <c:v>2648.21</c:v>
                </c:pt>
                <c:pt idx="49">
                  <c:v>2163.88</c:v>
                </c:pt>
                <c:pt idx="50">
                  <c:v>1942.83</c:v>
                </c:pt>
                <c:pt idx="51">
                  <c:v>1591.21</c:v>
                </c:pt>
                <c:pt idx="52">
                  <c:v>1175.1600000000001</c:v>
                </c:pt>
                <c:pt idx="53">
                  <c:v>1050.55</c:v>
                </c:pt>
                <c:pt idx="54">
                  <c:v>1297.5899999999999</c:v>
                </c:pt>
                <c:pt idx="55">
                  <c:v>1207.1500000000001</c:v>
                </c:pt>
                <c:pt idx="56">
                  <c:v>1063.94</c:v>
                </c:pt>
                <c:pt idx="57">
                  <c:v>1209.98</c:v>
                </c:pt>
                <c:pt idx="58">
                  <c:v>1282.1500000000001</c:v>
                </c:pt>
                <c:pt idx="59">
                  <c:v>1121.06</c:v>
                </c:pt>
                <c:pt idx="60">
                  <c:v>1340.15</c:v>
                </c:pt>
                <c:pt idx="61">
                  <c:v>1089.1199999999999</c:v>
                </c:pt>
                <c:pt idx="62">
                  <c:v>1255.05</c:v>
                </c:pt>
                <c:pt idx="63">
                  <c:v>1585.57</c:v>
                </c:pt>
                <c:pt idx="64">
                  <c:v>1339.38</c:v>
                </c:pt>
                <c:pt idx="65">
                  <c:v>945.479999999999</c:v>
                </c:pt>
                <c:pt idx="66">
                  <c:v>736.64999999999895</c:v>
                </c:pt>
                <c:pt idx="67">
                  <c:v>1152.73</c:v>
                </c:pt>
                <c:pt idx="68">
                  <c:v>1045.23</c:v>
                </c:pt>
                <c:pt idx="69">
                  <c:v>1324.26</c:v>
                </c:pt>
                <c:pt idx="70">
                  <c:v>1266.27</c:v>
                </c:pt>
                <c:pt idx="71">
                  <c:v>1283.3699999999999</c:v>
                </c:pt>
                <c:pt idx="72">
                  <c:v>1627.78</c:v>
                </c:pt>
                <c:pt idx="73">
                  <c:v>1412.8</c:v>
                </c:pt>
                <c:pt idx="74">
                  <c:v>1293.1400000000001</c:v>
                </c:pt>
                <c:pt idx="75">
                  <c:v>1478.13</c:v>
                </c:pt>
                <c:pt idx="76">
                  <c:v>1070.42</c:v>
                </c:pt>
                <c:pt idx="77">
                  <c:v>1446.5</c:v>
                </c:pt>
                <c:pt idx="78">
                  <c:v>1179.95</c:v>
                </c:pt>
                <c:pt idx="79">
                  <c:v>1458.63</c:v>
                </c:pt>
                <c:pt idx="80">
                  <c:v>1081.82</c:v>
                </c:pt>
                <c:pt idx="81">
                  <c:v>1326.8</c:v>
                </c:pt>
                <c:pt idx="82">
                  <c:v>1409.06</c:v>
                </c:pt>
                <c:pt idx="83">
                  <c:v>1098.83</c:v>
                </c:pt>
                <c:pt idx="84">
                  <c:v>1242.06</c:v>
                </c:pt>
                <c:pt idx="85">
                  <c:v>1347.79</c:v>
                </c:pt>
                <c:pt idx="86">
                  <c:v>1220.1099999999999</c:v>
                </c:pt>
                <c:pt idx="87">
                  <c:v>1270.83</c:v>
                </c:pt>
                <c:pt idx="88">
                  <c:v>951.15</c:v>
                </c:pt>
                <c:pt idx="89">
                  <c:v>1149.56</c:v>
                </c:pt>
                <c:pt idx="90">
                  <c:v>988.05999999999904</c:v>
                </c:pt>
                <c:pt idx="91">
                  <c:v>1343.81</c:v>
                </c:pt>
                <c:pt idx="92">
                  <c:v>1257.3800000000001</c:v>
                </c:pt>
                <c:pt idx="93">
                  <c:v>1579.39</c:v>
                </c:pt>
                <c:pt idx="94">
                  <c:v>1515.46</c:v>
                </c:pt>
                <c:pt idx="95">
                  <c:v>1339.31</c:v>
                </c:pt>
                <c:pt idx="96">
                  <c:v>1202.29</c:v>
                </c:pt>
                <c:pt idx="97">
                  <c:v>1316.27</c:v>
                </c:pt>
                <c:pt idx="98">
                  <c:v>1084.26</c:v>
                </c:pt>
                <c:pt idx="99">
                  <c:v>1237.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496-44D9-9F67-64B0C75CEE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82708336"/>
        <c:axId val="682708664"/>
      </c:lineChart>
      <c:catAx>
        <c:axId val="682708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82708664"/>
        <c:crosses val="autoZero"/>
        <c:auto val="1"/>
        <c:lblAlgn val="ctr"/>
        <c:lblOffset val="100"/>
        <c:noMultiLvlLbl val="0"/>
      </c:catAx>
      <c:valAx>
        <c:axId val="6827086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82708336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35154287079595969"/>
          <c:y val="0.75041666666666673"/>
          <c:w val="0.33218764321126526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GG-gene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gg_Gene!$A$5</c:f>
              <c:strCache>
                <c:ptCount val="1"/>
                <c:pt idx="0">
                  <c:v>E26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gg_Gene!$B$4:$CW$4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gg_Gene!$B$5:$CW$5</c:f>
              <c:numCache>
                <c:formatCode>General</c:formatCode>
                <c:ptCount val="100"/>
                <c:pt idx="0">
                  <c:v>1004.33</c:v>
                </c:pt>
                <c:pt idx="1">
                  <c:v>1490.5</c:v>
                </c:pt>
                <c:pt idx="2">
                  <c:v>1272.44</c:v>
                </c:pt>
                <c:pt idx="3">
                  <c:v>1287.4000000000001</c:v>
                </c:pt>
                <c:pt idx="4">
                  <c:v>1648.25</c:v>
                </c:pt>
                <c:pt idx="5">
                  <c:v>1354.61</c:v>
                </c:pt>
                <c:pt idx="6">
                  <c:v>1402.29</c:v>
                </c:pt>
                <c:pt idx="7">
                  <c:v>1558.51</c:v>
                </c:pt>
                <c:pt idx="8">
                  <c:v>1142.03</c:v>
                </c:pt>
                <c:pt idx="9">
                  <c:v>1816.96</c:v>
                </c:pt>
                <c:pt idx="10">
                  <c:v>1567</c:v>
                </c:pt>
                <c:pt idx="11">
                  <c:v>1661.48</c:v>
                </c:pt>
                <c:pt idx="12">
                  <c:v>2200.84</c:v>
                </c:pt>
                <c:pt idx="13">
                  <c:v>2084.12</c:v>
                </c:pt>
                <c:pt idx="14">
                  <c:v>2055.21</c:v>
                </c:pt>
                <c:pt idx="15">
                  <c:v>2024.81</c:v>
                </c:pt>
                <c:pt idx="16">
                  <c:v>2122.89</c:v>
                </c:pt>
                <c:pt idx="17">
                  <c:v>2161.4</c:v>
                </c:pt>
                <c:pt idx="18">
                  <c:v>2224.2800000000002</c:v>
                </c:pt>
                <c:pt idx="19">
                  <c:v>2467.3299999999899</c:v>
                </c:pt>
                <c:pt idx="20">
                  <c:v>1971.44</c:v>
                </c:pt>
                <c:pt idx="21">
                  <c:v>2402.9</c:v>
                </c:pt>
                <c:pt idx="22">
                  <c:v>2699.66</c:v>
                </c:pt>
                <c:pt idx="23">
                  <c:v>2448.0100000000002</c:v>
                </c:pt>
                <c:pt idx="24">
                  <c:v>2346.9499999999998</c:v>
                </c:pt>
                <c:pt idx="25">
                  <c:v>2255.7600000000002</c:v>
                </c:pt>
                <c:pt idx="26">
                  <c:v>2506.04</c:v>
                </c:pt>
                <c:pt idx="27">
                  <c:v>2424.86</c:v>
                </c:pt>
                <c:pt idx="28">
                  <c:v>2271.9</c:v>
                </c:pt>
                <c:pt idx="29">
                  <c:v>4788.2199999999903</c:v>
                </c:pt>
                <c:pt idx="30">
                  <c:v>2679.6599999999899</c:v>
                </c:pt>
                <c:pt idx="31">
                  <c:v>2361.58</c:v>
                </c:pt>
                <c:pt idx="32">
                  <c:v>2655.03</c:v>
                </c:pt>
                <c:pt idx="33">
                  <c:v>3298.85</c:v>
                </c:pt>
                <c:pt idx="34">
                  <c:v>2830.7599999999902</c:v>
                </c:pt>
                <c:pt idx="35">
                  <c:v>2815.04</c:v>
                </c:pt>
                <c:pt idx="36">
                  <c:v>2349.89</c:v>
                </c:pt>
                <c:pt idx="37">
                  <c:v>2718.87</c:v>
                </c:pt>
                <c:pt idx="38">
                  <c:v>3008.6799999999898</c:v>
                </c:pt>
                <c:pt idx="39">
                  <c:v>2569.8499999999899</c:v>
                </c:pt>
                <c:pt idx="40">
                  <c:v>2638.32</c:v>
                </c:pt>
                <c:pt idx="41">
                  <c:v>2500.1799999999998</c:v>
                </c:pt>
                <c:pt idx="42">
                  <c:v>2584.1</c:v>
                </c:pt>
                <c:pt idx="43">
                  <c:v>2783.56</c:v>
                </c:pt>
                <c:pt idx="44">
                  <c:v>2644.13</c:v>
                </c:pt>
                <c:pt idx="45">
                  <c:v>2961.8399999999901</c:v>
                </c:pt>
                <c:pt idx="46">
                  <c:v>3191.3099999999899</c:v>
                </c:pt>
                <c:pt idx="47">
                  <c:v>2911.66</c:v>
                </c:pt>
                <c:pt idx="48">
                  <c:v>2823.7599999999902</c:v>
                </c:pt>
                <c:pt idx="49">
                  <c:v>2700.49</c:v>
                </c:pt>
                <c:pt idx="50">
                  <c:v>2718.85</c:v>
                </c:pt>
                <c:pt idx="51">
                  <c:v>2813.92</c:v>
                </c:pt>
                <c:pt idx="52">
                  <c:v>3188.76</c:v>
                </c:pt>
                <c:pt idx="53">
                  <c:v>3020.99999999999</c:v>
                </c:pt>
                <c:pt idx="54">
                  <c:v>2958.48</c:v>
                </c:pt>
                <c:pt idx="55">
                  <c:v>3137.85</c:v>
                </c:pt>
                <c:pt idx="56">
                  <c:v>2696.9099999999899</c:v>
                </c:pt>
                <c:pt idx="57">
                  <c:v>2832.57</c:v>
                </c:pt>
                <c:pt idx="58">
                  <c:v>2784.6199999999899</c:v>
                </c:pt>
                <c:pt idx="59">
                  <c:v>2905.49</c:v>
                </c:pt>
                <c:pt idx="60">
                  <c:v>3017.87</c:v>
                </c:pt>
                <c:pt idx="61">
                  <c:v>2963.4</c:v>
                </c:pt>
                <c:pt idx="62">
                  <c:v>3147.72999999999</c:v>
                </c:pt>
                <c:pt idx="63">
                  <c:v>3113.3099999999899</c:v>
                </c:pt>
                <c:pt idx="64">
                  <c:v>2511.6399999999899</c:v>
                </c:pt>
                <c:pt idx="65">
                  <c:v>3114.4299999999898</c:v>
                </c:pt>
                <c:pt idx="66">
                  <c:v>2835.51</c:v>
                </c:pt>
                <c:pt idx="67">
                  <c:v>3012.2999999999902</c:v>
                </c:pt>
                <c:pt idx="68">
                  <c:v>3220.61</c:v>
                </c:pt>
                <c:pt idx="69">
                  <c:v>2877.6099999999901</c:v>
                </c:pt>
                <c:pt idx="70">
                  <c:v>3228.33</c:v>
                </c:pt>
                <c:pt idx="71">
                  <c:v>2786.48</c:v>
                </c:pt>
                <c:pt idx="72">
                  <c:v>3046.6699999999901</c:v>
                </c:pt>
                <c:pt idx="73">
                  <c:v>3468.39</c:v>
                </c:pt>
                <c:pt idx="74">
                  <c:v>2979.8499999999899</c:v>
                </c:pt>
                <c:pt idx="75">
                  <c:v>3373.5099999999902</c:v>
                </c:pt>
                <c:pt idx="76">
                  <c:v>3459.5999999999899</c:v>
                </c:pt>
                <c:pt idx="77">
                  <c:v>3301.49999999999</c:v>
                </c:pt>
                <c:pt idx="78">
                  <c:v>3501.72999999999</c:v>
                </c:pt>
                <c:pt idx="79">
                  <c:v>3157.2599999999902</c:v>
                </c:pt>
                <c:pt idx="80">
                  <c:v>3297.1699999999901</c:v>
                </c:pt>
                <c:pt idx="81">
                  <c:v>3692.0699999999902</c:v>
                </c:pt>
                <c:pt idx="82">
                  <c:v>3103.88</c:v>
                </c:pt>
                <c:pt idx="83">
                  <c:v>3191.6399999999899</c:v>
                </c:pt>
                <c:pt idx="84">
                  <c:v>3258.24999999999</c:v>
                </c:pt>
                <c:pt idx="85">
                  <c:v>3127.23</c:v>
                </c:pt>
                <c:pt idx="86">
                  <c:v>3186.5599999999899</c:v>
                </c:pt>
                <c:pt idx="87">
                  <c:v>2797.47</c:v>
                </c:pt>
                <c:pt idx="88">
                  <c:v>3106.3599999999901</c:v>
                </c:pt>
                <c:pt idx="89">
                  <c:v>3202.6299999999901</c:v>
                </c:pt>
                <c:pt idx="90">
                  <c:v>3437.97</c:v>
                </c:pt>
                <c:pt idx="91">
                  <c:v>3326.39</c:v>
                </c:pt>
                <c:pt idx="92">
                  <c:v>2914.95</c:v>
                </c:pt>
                <c:pt idx="93">
                  <c:v>2569.03999999999</c:v>
                </c:pt>
                <c:pt idx="94">
                  <c:v>2667.99999999999</c:v>
                </c:pt>
                <c:pt idx="95">
                  <c:v>2298.2199999999998</c:v>
                </c:pt>
                <c:pt idx="96">
                  <c:v>1929.28</c:v>
                </c:pt>
                <c:pt idx="97">
                  <c:v>1814.41</c:v>
                </c:pt>
                <c:pt idx="98">
                  <c:v>1657.45</c:v>
                </c:pt>
                <c:pt idx="99">
                  <c:v>1394.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C50-4C61-8056-37160AAF09B9}"/>
            </c:ext>
          </c:extLst>
        </c:ser>
        <c:ser>
          <c:idx val="1"/>
          <c:order val="1"/>
          <c:tx>
            <c:strRef>
              <c:f>ccgg_Gene!$A$6</c:f>
              <c:strCache>
                <c:ptCount val="1"/>
                <c:pt idx="0">
                  <c:v>E26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gg_Gene!$B$4:$CW$4</c:f>
              <c:numCache>
                <c:formatCode>General</c:formatCode>
                <c:ptCount val="100"/>
                <c:pt idx="0">
                  <c:v>0.01</c:v>
                </c:pt>
                <c:pt idx="1">
                  <c:v>0.02</c:v>
                </c:pt>
                <c:pt idx="2">
                  <c:v>0.03</c:v>
                </c:pt>
                <c:pt idx="3">
                  <c:v>0.04</c:v>
                </c:pt>
                <c:pt idx="4">
                  <c:v>0.05</c:v>
                </c:pt>
                <c:pt idx="5">
                  <c:v>0.06</c:v>
                </c:pt>
                <c:pt idx="6">
                  <c:v>7.0000000000000007E-2</c:v>
                </c:pt>
                <c:pt idx="7">
                  <c:v>0.08</c:v>
                </c:pt>
                <c:pt idx="8">
                  <c:v>0.09</c:v>
                </c:pt>
                <c:pt idx="9">
                  <c:v>0.1</c:v>
                </c:pt>
                <c:pt idx="10">
                  <c:v>0.11</c:v>
                </c:pt>
                <c:pt idx="11">
                  <c:v>0.1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</c:v>
                </c:pt>
                <c:pt idx="15">
                  <c:v>0.16</c:v>
                </c:pt>
                <c:pt idx="16">
                  <c:v>0.17</c:v>
                </c:pt>
                <c:pt idx="17">
                  <c:v>0.18</c:v>
                </c:pt>
                <c:pt idx="18">
                  <c:v>0.19</c:v>
                </c:pt>
                <c:pt idx="19">
                  <c:v>0.2</c:v>
                </c:pt>
                <c:pt idx="20">
                  <c:v>0.21</c:v>
                </c:pt>
                <c:pt idx="21">
                  <c:v>0.22</c:v>
                </c:pt>
                <c:pt idx="22">
                  <c:v>0.23</c:v>
                </c:pt>
                <c:pt idx="23">
                  <c:v>0.24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3</c:v>
                </c:pt>
                <c:pt idx="28">
                  <c:v>0.28999999999999998</c:v>
                </c:pt>
                <c:pt idx="29">
                  <c:v>0.3</c:v>
                </c:pt>
                <c:pt idx="30">
                  <c:v>0.31</c:v>
                </c:pt>
                <c:pt idx="31">
                  <c:v>0.32</c:v>
                </c:pt>
                <c:pt idx="32">
                  <c:v>0.33</c:v>
                </c:pt>
                <c:pt idx="33">
                  <c:v>0.34</c:v>
                </c:pt>
                <c:pt idx="34">
                  <c:v>0.35</c:v>
                </c:pt>
                <c:pt idx="35">
                  <c:v>0.36</c:v>
                </c:pt>
                <c:pt idx="36">
                  <c:v>0.37</c:v>
                </c:pt>
                <c:pt idx="37">
                  <c:v>0.38</c:v>
                </c:pt>
                <c:pt idx="38">
                  <c:v>0.39</c:v>
                </c:pt>
                <c:pt idx="39">
                  <c:v>0.4</c:v>
                </c:pt>
                <c:pt idx="40">
                  <c:v>0.41</c:v>
                </c:pt>
                <c:pt idx="41">
                  <c:v>0.42</c:v>
                </c:pt>
                <c:pt idx="42">
                  <c:v>0.43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</c:v>
                </c:pt>
                <c:pt idx="47">
                  <c:v>0.48</c:v>
                </c:pt>
                <c:pt idx="48">
                  <c:v>0.49</c:v>
                </c:pt>
                <c:pt idx="49">
                  <c:v>0.5</c:v>
                </c:pt>
                <c:pt idx="50">
                  <c:v>0.51</c:v>
                </c:pt>
                <c:pt idx="51">
                  <c:v>0.52</c:v>
                </c:pt>
                <c:pt idx="52">
                  <c:v>0.53</c:v>
                </c:pt>
                <c:pt idx="53">
                  <c:v>0.54</c:v>
                </c:pt>
                <c:pt idx="54">
                  <c:v>0.55000000000000004</c:v>
                </c:pt>
                <c:pt idx="55">
                  <c:v>0.56000000000000005</c:v>
                </c:pt>
                <c:pt idx="56">
                  <c:v>0.56999999999999995</c:v>
                </c:pt>
                <c:pt idx="57">
                  <c:v>0.57999999999999996</c:v>
                </c:pt>
                <c:pt idx="58">
                  <c:v>0.59</c:v>
                </c:pt>
                <c:pt idx="59">
                  <c:v>0.6</c:v>
                </c:pt>
                <c:pt idx="60">
                  <c:v>0.61</c:v>
                </c:pt>
                <c:pt idx="61">
                  <c:v>0.62</c:v>
                </c:pt>
                <c:pt idx="62">
                  <c:v>0.63</c:v>
                </c:pt>
                <c:pt idx="63">
                  <c:v>0.64</c:v>
                </c:pt>
                <c:pt idx="64">
                  <c:v>0.65</c:v>
                </c:pt>
                <c:pt idx="65">
                  <c:v>0.66</c:v>
                </c:pt>
                <c:pt idx="66">
                  <c:v>0.67</c:v>
                </c:pt>
                <c:pt idx="67">
                  <c:v>0.68</c:v>
                </c:pt>
                <c:pt idx="68">
                  <c:v>0.69</c:v>
                </c:pt>
                <c:pt idx="69">
                  <c:v>0.7</c:v>
                </c:pt>
                <c:pt idx="70">
                  <c:v>0.71</c:v>
                </c:pt>
                <c:pt idx="71">
                  <c:v>0.72</c:v>
                </c:pt>
                <c:pt idx="72">
                  <c:v>0.73</c:v>
                </c:pt>
                <c:pt idx="73">
                  <c:v>0.74</c:v>
                </c:pt>
                <c:pt idx="74">
                  <c:v>0.75</c:v>
                </c:pt>
                <c:pt idx="75">
                  <c:v>0.76</c:v>
                </c:pt>
                <c:pt idx="76">
                  <c:v>0.77</c:v>
                </c:pt>
                <c:pt idx="77">
                  <c:v>0.78</c:v>
                </c:pt>
                <c:pt idx="78">
                  <c:v>0.79</c:v>
                </c:pt>
                <c:pt idx="79">
                  <c:v>0.8</c:v>
                </c:pt>
                <c:pt idx="80">
                  <c:v>0.81</c:v>
                </c:pt>
                <c:pt idx="81">
                  <c:v>0.82</c:v>
                </c:pt>
                <c:pt idx="82">
                  <c:v>0.83</c:v>
                </c:pt>
                <c:pt idx="83">
                  <c:v>0.84</c:v>
                </c:pt>
                <c:pt idx="84">
                  <c:v>0.85</c:v>
                </c:pt>
                <c:pt idx="85">
                  <c:v>0.86</c:v>
                </c:pt>
                <c:pt idx="86">
                  <c:v>0.87</c:v>
                </c:pt>
                <c:pt idx="87">
                  <c:v>0.88</c:v>
                </c:pt>
                <c:pt idx="88">
                  <c:v>0.89</c:v>
                </c:pt>
                <c:pt idx="89">
                  <c:v>0.9</c:v>
                </c:pt>
                <c:pt idx="90">
                  <c:v>0.91</c:v>
                </c:pt>
                <c:pt idx="91">
                  <c:v>0.92</c:v>
                </c:pt>
                <c:pt idx="92">
                  <c:v>0.93</c:v>
                </c:pt>
                <c:pt idx="93">
                  <c:v>0.94</c:v>
                </c:pt>
                <c:pt idx="94">
                  <c:v>0.95</c:v>
                </c:pt>
                <c:pt idx="95">
                  <c:v>0.96</c:v>
                </c:pt>
                <c:pt idx="96">
                  <c:v>0.97</c:v>
                </c:pt>
                <c:pt idx="97">
                  <c:v>0.98</c:v>
                </c:pt>
                <c:pt idx="98">
                  <c:v>0.99</c:v>
                </c:pt>
                <c:pt idx="99">
                  <c:v>1</c:v>
                </c:pt>
              </c:numCache>
            </c:numRef>
          </c:cat>
          <c:val>
            <c:numRef>
              <c:f>ccgg_Gene!$B$6:$CW$6</c:f>
              <c:numCache>
                <c:formatCode>General</c:formatCode>
                <c:ptCount val="100"/>
                <c:pt idx="0">
                  <c:v>1019.23</c:v>
                </c:pt>
                <c:pt idx="1">
                  <c:v>1499.59</c:v>
                </c:pt>
                <c:pt idx="2">
                  <c:v>1215.49</c:v>
                </c:pt>
                <c:pt idx="3">
                  <c:v>1344.4</c:v>
                </c:pt>
                <c:pt idx="4">
                  <c:v>1673.63</c:v>
                </c:pt>
                <c:pt idx="5">
                  <c:v>1370.47</c:v>
                </c:pt>
                <c:pt idx="6">
                  <c:v>1359.99</c:v>
                </c:pt>
                <c:pt idx="7">
                  <c:v>1604.35</c:v>
                </c:pt>
                <c:pt idx="8">
                  <c:v>1154.72</c:v>
                </c:pt>
                <c:pt idx="9">
                  <c:v>1886.75</c:v>
                </c:pt>
                <c:pt idx="10">
                  <c:v>1570.61</c:v>
                </c:pt>
                <c:pt idx="11">
                  <c:v>1600.14</c:v>
                </c:pt>
                <c:pt idx="12">
                  <c:v>2169.5</c:v>
                </c:pt>
                <c:pt idx="13">
                  <c:v>2080.92</c:v>
                </c:pt>
                <c:pt idx="14">
                  <c:v>2036.61</c:v>
                </c:pt>
                <c:pt idx="15">
                  <c:v>2069.4899999999998</c:v>
                </c:pt>
                <c:pt idx="16">
                  <c:v>2109.1999999999998</c:v>
                </c:pt>
                <c:pt idx="17">
                  <c:v>2127.8000000000002</c:v>
                </c:pt>
                <c:pt idx="18">
                  <c:v>2154.35</c:v>
                </c:pt>
                <c:pt idx="19">
                  <c:v>2432.98</c:v>
                </c:pt>
                <c:pt idx="20">
                  <c:v>1978.78</c:v>
                </c:pt>
                <c:pt idx="21">
                  <c:v>2358.61</c:v>
                </c:pt>
                <c:pt idx="22">
                  <c:v>2698.89</c:v>
                </c:pt>
                <c:pt idx="23">
                  <c:v>2368.8200000000002</c:v>
                </c:pt>
                <c:pt idx="24">
                  <c:v>2234.9499999999998</c:v>
                </c:pt>
                <c:pt idx="25">
                  <c:v>2228.2600000000002</c:v>
                </c:pt>
                <c:pt idx="26">
                  <c:v>2444.73</c:v>
                </c:pt>
                <c:pt idx="27">
                  <c:v>2406.79</c:v>
                </c:pt>
                <c:pt idx="28">
                  <c:v>2312.1799999999998</c:v>
                </c:pt>
                <c:pt idx="29">
                  <c:v>5945.3100000000104</c:v>
                </c:pt>
                <c:pt idx="30">
                  <c:v>2640.18</c:v>
                </c:pt>
                <c:pt idx="31">
                  <c:v>2231.5300000000002</c:v>
                </c:pt>
                <c:pt idx="32">
                  <c:v>2611.46</c:v>
                </c:pt>
                <c:pt idx="33">
                  <c:v>3293.65</c:v>
                </c:pt>
                <c:pt idx="34">
                  <c:v>2868.1300000000101</c:v>
                </c:pt>
                <c:pt idx="35">
                  <c:v>2748.15</c:v>
                </c:pt>
                <c:pt idx="36">
                  <c:v>2332.84</c:v>
                </c:pt>
                <c:pt idx="37">
                  <c:v>2712.35</c:v>
                </c:pt>
                <c:pt idx="38">
                  <c:v>3034.05</c:v>
                </c:pt>
                <c:pt idx="39">
                  <c:v>2441.79</c:v>
                </c:pt>
                <c:pt idx="40">
                  <c:v>2510.5500000000002</c:v>
                </c:pt>
                <c:pt idx="41">
                  <c:v>2477.73</c:v>
                </c:pt>
                <c:pt idx="42">
                  <c:v>2592.4499999999998</c:v>
                </c:pt>
                <c:pt idx="43">
                  <c:v>2731.01</c:v>
                </c:pt>
                <c:pt idx="44">
                  <c:v>2428.3200000000002</c:v>
                </c:pt>
                <c:pt idx="45">
                  <c:v>2928.59</c:v>
                </c:pt>
                <c:pt idx="46">
                  <c:v>3005.71</c:v>
                </c:pt>
                <c:pt idx="47">
                  <c:v>2919.66</c:v>
                </c:pt>
                <c:pt idx="48">
                  <c:v>2667.99</c:v>
                </c:pt>
                <c:pt idx="49">
                  <c:v>2719.7</c:v>
                </c:pt>
                <c:pt idx="50">
                  <c:v>2855.04</c:v>
                </c:pt>
                <c:pt idx="51">
                  <c:v>2817.92</c:v>
                </c:pt>
                <c:pt idx="52">
                  <c:v>3094.81</c:v>
                </c:pt>
                <c:pt idx="53">
                  <c:v>2956.35</c:v>
                </c:pt>
                <c:pt idx="54">
                  <c:v>2927.28</c:v>
                </c:pt>
                <c:pt idx="55">
                  <c:v>3048.6500000000101</c:v>
                </c:pt>
                <c:pt idx="56">
                  <c:v>2587.04</c:v>
                </c:pt>
                <c:pt idx="57">
                  <c:v>2733.51</c:v>
                </c:pt>
                <c:pt idx="58">
                  <c:v>2678.23</c:v>
                </c:pt>
                <c:pt idx="59">
                  <c:v>2923.87</c:v>
                </c:pt>
                <c:pt idx="60">
                  <c:v>2945.01</c:v>
                </c:pt>
                <c:pt idx="61">
                  <c:v>3011.01</c:v>
                </c:pt>
                <c:pt idx="62">
                  <c:v>2988.83</c:v>
                </c:pt>
                <c:pt idx="63">
                  <c:v>2979.14</c:v>
                </c:pt>
                <c:pt idx="64">
                  <c:v>2474.84</c:v>
                </c:pt>
                <c:pt idx="65">
                  <c:v>3111.72</c:v>
                </c:pt>
                <c:pt idx="66">
                  <c:v>2874.47</c:v>
                </c:pt>
                <c:pt idx="67">
                  <c:v>2920.63</c:v>
                </c:pt>
                <c:pt idx="68">
                  <c:v>3183.85</c:v>
                </c:pt>
                <c:pt idx="69">
                  <c:v>2914.47</c:v>
                </c:pt>
                <c:pt idx="70">
                  <c:v>3212.21</c:v>
                </c:pt>
                <c:pt idx="71">
                  <c:v>2818.27</c:v>
                </c:pt>
                <c:pt idx="72">
                  <c:v>2961.31</c:v>
                </c:pt>
                <c:pt idx="73">
                  <c:v>3546.09</c:v>
                </c:pt>
                <c:pt idx="74">
                  <c:v>2864.74</c:v>
                </c:pt>
                <c:pt idx="75">
                  <c:v>3255.62</c:v>
                </c:pt>
                <c:pt idx="76">
                  <c:v>3492.9200000000101</c:v>
                </c:pt>
                <c:pt idx="77">
                  <c:v>3158.95</c:v>
                </c:pt>
                <c:pt idx="78">
                  <c:v>3481.47</c:v>
                </c:pt>
                <c:pt idx="79">
                  <c:v>3069.79</c:v>
                </c:pt>
                <c:pt idx="80">
                  <c:v>3280.1500000000101</c:v>
                </c:pt>
                <c:pt idx="81">
                  <c:v>3602.94</c:v>
                </c:pt>
                <c:pt idx="82">
                  <c:v>3016.21</c:v>
                </c:pt>
                <c:pt idx="83">
                  <c:v>3207.88</c:v>
                </c:pt>
                <c:pt idx="84">
                  <c:v>3229.94</c:v>
                </c:pt>
                <c:pt idx="85">
                  <c:v>3131.22</c:v>
                </c:pt>
                <c:pt idx="86">
                  <c:v>3295.34</c:v>
                </c:pt>
                <c:pt idx="87">
                  <c:v>2649.07</c:v>
                </c:pt>
                <c:pt idx="88">
                  <c:v>3054.75</c:v>
                </c:pt>
                <c:pt idx="89">
                  <c:v>3130.76</c:v>
                </c:pt>
                <c:pt idx="90">
                  <c:v>4364.13</c:v>
                </c:pt>
                <c:pt idx="91">
                  <c:v>3217.3400000000101</c:v>
                </c:pt>
                <c:pt idx="92">
                  <c:v>2696.7</c:v>
                </c:pt>
                <c:pt idx="93">
                  <c:v>2519.38</c:v>
                </c:pt>
                <c:pt idx="94">
                  <c:v>2597.9699999999998</c:v>
                </c:pt>
                <c:pt idx="95">
                  <c:v>2270.04</c:v>
                </c:pt>
                <c:pt idx="96">
                  <c:v>1990.16</c:v>
                </c:pt>
                <c:pt idx="97">
                  <c:v>1790.09</c:v>
                </c:pt>
                <c:pt idx="98">
                  <c:v>1641.89</c:v>
                </c:pt>
                <c:pt idx="99">
                  <c:v>1364.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C50-4C61-8056-37160AAF09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34487504"/>
        <c:axId val="634488160"/>
      </c:lineChart>
      <c:catAx>
        <c:axId val="634487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34488160"/>
        <c:crosses val="autoZero"/>
        <c:auto val="1"/>
        <c:lblAlgn val="ctr"/>
        <c:lblOffset val="100"/>
        <c:noMultiLvlLbl val="0"/>
      </c:catAx>
      <c:valAx>
        <c:axId val="63448816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34487504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57142237122287254"/>
          <c:y val="0.19486111111111112"/>
          <c:w val="0.38128855422652347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GG-TSS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gg_TSS!$A$5</c:f>
              <c:strCache>
                <c:ptCount val="1"/>
                <c:pt idx="0">
                  <c:v>E26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gg_TSS!$B$4:$CW$4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SS!$B$5:$CW$5</c:f>
              <c:numCache>
                <c:formatCode>General</c:formatCode>
                <c:ptCount val="100"/>
                <c:pt idx="0">
                  <c:v>755.11000000000104</c:v>
                </c:pt>
                <c:pt idx="1">
                  <c:v>1698.75</c:v>
                </c:pt>
                <c:pt idx="2">
                  <c:v>1503.96</c:v>
                </c:pt>
                <c:pt idx="3">
                  <c:v>1670.23</c:v>
                </c:pt>
                <c:pt idx="4">
                  <c:v>1939.51</c:v>
                </c:pt>
                <c:pt idx="5">
                  <c:v>1672.36</c:v>
                </c:pt>
                <c:pt idx="6">
                  <c:v>1849.52</c:v>
                </c:pt>
                <c:pt idx="7">
                  <c:v>1579.37</c:v>
                </c:pt>
                <c:pt idx="8">
                  <c:v>1661.38</c:v>
                </c:pt>
                <c:pt idx="9">
                  <c:v>1307.3800000000001</c:v>
                </c:pt>
                <c:pt idx="10">
                  <c:v>1188.55</c:v>
                </c:pt>
                <c:pt idx="11">
                  <c:v>3067.92</c:v>
                </c:pt>
                <c:pt idx="12">
                  <c:v>1532.98</c:v>
                </c:pt>
                <c:pt idx="13">
                  <c:v>1613.81</c:v>
                </c:pt>
                <c:pt idx="14">
                  <c:v>1511</c:v>
                </c:pt>
                <c:pt idx="15">
                  <c:v>1406.7</c:v>
                </c:pt>
                <c:pt idx="16">
                  <c:v>1495.94</c:v>
                </c:pt>
                <c:pt idx="17">
                  <c:v>1489.77</c:v>
                </c:pt>
                <c:pt idx="18">
                  <c:v>1747.36</c:v>
                </c:pt>
                <c:pt idx="19">
                  <c:v>1784.03</c:v>
                </c:pt>
                <c:pt idx="20">
                  <c:v>1491.62</c:v>
                </c:pt>
                <c:pt idx="21">
                  <c:v>1385.68</c:v>
                </c:pt>
                <c:pt idx="22">
                  <c:v>1460.83</c:v>
                </c:pt>
                <c:pt idx="23">
                  <c:v>1633.1</c:v>
                </c:pt>
                <c:pt idx="24">
                  <c:v>1856.11</c:v>
                </c:pt>
                <c:pt idx="25">
                  <c:v>1353.2</c:v>
                </c:pt>
                <c:pt idx="26">
                  <c:v>1940.69</c:v>
                </c:pt>
                <c:pt idx="27">
                  <c:v>1295.8</c:v>
                </c:pt>
                <c:pt idx="28">
                  <c:v>1350.73</c:v>
                </c:pt>
                <c:pt idx="29">
                  <c:v>2014.25</c:v>
                </c:pt>
                <c:pt idx="30">
                  <c:v>1334.5</c:v>
                </c:pt>
                <c:pt idx="31">
                  <c:v>1491.62</c:v>
                </c:pt>
                <c:pt idx="32">
                  <c:v>1515.24</c:v>
                </c:pt>
                <c:pt idx="33">
                  <c:v>1995.44</c:v>
                </c:pt>
                <c:pt idx="34">
                  <c:v>1521.64</c:v>
                </c:pt>
                <c:pt idx="35">
                  <c:v>1350.67</c:v>
                </c:pt>
                <c:pt idx="36">
                  <c:v>1458.58</c:v>
                </c:pt>
                <c:pt idx="37">
                  <c:v>1511.33</c:v>
                </c:pt>
                <c:pt idx="38">
                  <c:v>1203.95</c:v>
                </c:pt>
                <c:pt idx="39">
                  <c:v>1431.5</c:v>
                </c:pt>
                <c:pt idx="40">
                  <c:v>1266.8800000000001</c:v>
                </c:pt>
                <c:pt idx="41">
                  <c:v>1455.97</c:v>
                </c:pt>
                <c:pt idx="42">
                  <c:v>1368.66</c:v>
                </c:pt>
                <c:pt idx="43">
                  <c:v>1668.39</c:v>
                </c:pt>
                <c:pt idx="44">
                  <c:v>1422.76</c:v>
                </c:pt>
                <c:pt idx="45">
                  <c:v>1296.05</c:v>
                </c:pt>
                <c:pt idx="46">
                  <c:v>1442.94</c:v>
                </c:pt>
                <c:pt idx="47">
                  <c:v>1099</c:v>
                </c:pt>
                <c:pt idx="48">
                  <c:v>1040.7</c:v>
                </c:pt>
                <c:pt idx="49">
                  <c:v>1239.3800000000001</c:v>
                </c:pt>
                <c:pt idx="50">
                  <c:v>1569.21</c:v>
                </c:pt>
                <c:pt idx="51">
                  <c:v>2883.1799999999898</c:v>
                </c:pt>
                <c:pt idx="52">
                  <c:v>2408.4</c:v>
                </c:pt>
                <c:pt idx="53">
                  <c:v>3114.78999999999</c:v>
                </c:pt>
                <c:pt idx="54">
                  <c:v>2625.5599999999899</c:v>
                </c:pt>
                <c:pt idx="55">
                  <c:v>3210.8099999999899</c:v>
                </c:pt>
                <c:pt idx="56">
                  <c:v>3029.3599999999901</c:v>
                </c:pt>
                <c:pt idx="57">
                  <c:v>3159.51999999999</c:v>
                </c:pt>
                <c:pt idx="58">
                  <c:v>5601.5999999999904</c:v>
                </c:pt>
                <c:pt idx="59">
                  <c:v>3258.4099999999899</c:v>
                </c:pt>
                <c:pt idx="60">
                  <c:v>2480.6299999999901</c:v>
                </c:pt>
                <c:pt idx="61">
                  <c:v>2573.8499999999899</c:v>
                </c:pt>
                <c:pt idx="62">
                  <c:v>2581.61</c:v>
                </c:pt>
                <c:pt idx="63">
                  <c:v>2060.0100000000002</c:v>
                </c:pt>
                <c:pt idx="64">
                  <c:v>2272.9899999999998</c:v>
                </c:pt>
                <c:pt idx="65">
                  <c:v>2332.3399999999901</c:v>
                </c:pt>
                <c:pt idx="66">
                  <c:v>2730.1899999999901</c:v>
                </c:pt>
                <c:pt idx="67">
                  <c:v>2288.0100000000002</c:v>
                </c:pt>
                <c:pt idx="68">
                  <c:v>2373.1999999999998</c:v>
                </c:pt>
                <c:pt idx="69">
                  <c:v>2902.8499999999899</c:v>
                </c:pt>
                <c:pt idx="70">
                  <c:v>2834.1599999999899</c:v>
                </c:pt>
                <c:pt idx="71">
                  <c:v>2461.78999999999</c:v>
                </c:pt>
                <c:pt idx="72">
                  <c:v>2659.85</c:v>
                </c:pt>
                <c:pt idx="73">
                  <c:v>2833.37</c:v>
                </c:pt>
                <c:pt idx="74">
                  <c:v>3351.4099999999899</c:v>
                </c:pt>
                <c:pt idx="75">
                  <c:v>3058.8799999999901</c:v>
                </c:pt>
                <c:pt idx="76">
                  <c:v>3211.49</c:v>
                </c:pt>
                <c:pt idx="77">
                  <c:v>3582.99999999999</c:v>
                </c:pt>
                <c:pt idx="78">
                  <c:v>3218.3799999999901</c:v>
                </c:pt>
                <c:pt idx="79">
                  <c:v>3048.4699999999898</c:v>
                </c:pt>
                <c:pt idx="80">
                  <c:v>2914.6099999999901</c:v>
                </c:pt>
                <c:pt idx="81">
                  <c:v>3331.5599999999899</c:v>
                </c:pt>
                <c:pt idx="82">
                  <c:v>2986.74</c:v>
                </c:pt>
                <c:pt idx="83">
                  <c:v>3409.70999999999</c:v>
                </c:pt>
                <c:pt idx="84">
                  <c:v>3353.4199999999901</c:v>
                </c:pt>
                <c:pt idx="85">
                  <c:v>3331.95999999999</c:v>
                </c:pt>
                <c:pt idx="86">
                  <c:v>3215.1399999999899</c:v>
                </c:pt>
                <c:pt idx="87">
                  <c:v>3368.8799999999901</c:v>
                </c:pt>
                <c:pt idx="88">
                  <c:v>3415.34</c:v>
                </c:pt>
                <c:pt idx="89">
                  <c:v>3201.97999999999</c:v>
                </c:pt>
                <c:pt idx="90">
                  <c:v>3570.5799999999899</c:v>
                </c:pt>
                <c:pt idx="91">
                  <c:v>2861.5499999999902</c:v>
                </c:pt>
                <c:pt idx="92">
                  <c:v>3134.23</c:v>
                </c:pt>
                <c:pt idx="93">
                  <c:v>3164.19</c:v>
                </c:pt>
                <c:pt idx="94">
                  <c:v>3193.7799999999902</c:v>
                </c:pt>
                <c:pt idx="95">
                  <c:v>2985.9699999999898</c:v>
                </c:pt>
                <c:pt idx="96">
                  <c:v>3459.6899999999901</c:v>
                </c:pt>
                <c:pt idx="97">
                  <c:v>3238.9399999999901</c:v>
                </c:pt>
                <c:pt idx="98">
                  <c:v>3080.0999999999899</c:v>
                </c:pt>
                <c:pt idx="99">
                  <c:v>3488.53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239-4B21-AD3C-338437351F0F}"/>
            </c:ext>
          </c:extLst>
        </c:ser>
        <c:ser>
          <c:idx val="1"/>
          <c:order val="1"/>
          <c:tx>
            <c:strRef>
              <c:f>ccgg_TSS!$A$6</c:f>
              <c:strCache>
                <c:ptCount val="1"/>
                <c:pt idx="0">
                  <c:v>E26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gg_TSS!$B$4:$CW$4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SS!$B$6:$CW$6</c:f>
              <c:numCache>
                <c:formatCode>General</c:formatCode>
                <c:ptCount val="100"/>
                <c:pt idx="0">
                  <c:v>730.61</c:v>
                </c:pt>
                <c:pt idx="1">
                  <c:v>1705.62</c:v>
                </c:pt>
                <c:pt idx="2">
                  <c:v>1481.1</c:v>
                </c:pt>
                <c:pt idx="3">
                  <c:v>1625.01</c:v>
                </c:pt>
                <c:pt idx="4">
                  <c:v>1913.32</c:v>
                </c:pt>
                <c:pt idx="5">
                  <c:v>1581.96</c:v>
                </c:pt>
                <c:pt idx="6">
                  <c:v>1717.84</c:v>
                </c:pt>
                <c:pt idx="7">
                  <c:v>1486.59</c:v>
                </c:pt>
                <c:pt idx="8">
                  <c:v>1563.41</c:v>
                </c:pt>
                <c:pt idx="9">
                  <c:v>1272.56</c:v>
                </c:pt>
                <c:pt idx="10">
                  <c:v>1152.28</c:v>
                </c:pt>
                <c:pt idx="11">
                  <c:v>2323.1</c:v>
                </c:pt>
                <c:pt idx="12">
                  <c:v>1523.73</c:v>
                </c:pt>
                <c:pt idx="13">
                  <c:v>1591.7</c:v>
                </c:pt>
                <c:pt idx="14">
                  <c:v>1535.93</c:v>
                </c:pt>
                <c:pt idx="15">
                  <c:v>1444.36</c:v>
                </c:pt>
                <c:pt idx="16">
                  <c:v>1446.45</c:v>
                </c:pt>
                <c:pt idx="17">
                  <c:v>1402.09</c:v>
                </c:pt>
                <c:pt idx="18">
                  <c:v>1689.13</c:v>
                </c:pt>
                <c:pt idx="19">
                  <c:v>1736.07</c:v>
                </c:pt>
                <c:pt idx="20">
                  <c:v>1546.9</c:v>
                </c:pt>
                <c:pt idx="21">
                  <c:v>1395.35</c:v>
                </c:pt>
                <c:pt idx="22">
                  <c:v>1476.45</c:v>
                </c:pt>
                <c:pt idx="23">
                  <c:v>1674.36</c:v>
                </c:pt>
                <c:pt idx="24">
                  <c:v>1827.28</c:v>
                </c:pt>
                <c:pt idx="25">
                  <c:v>1321.07</c:v>
                </c:pt>
                <c:pt idx="26">
                  <c:v>1948.35</c:v>
                </c:pt>
                <c:pt idx="27">
                  <c:v>1333.75</c:v>
                </c:pt>
                <c:pt idx="28">
                  <c:v>1368.29</c:v>
                </c:pt>
                <c:pt idx="29">
                  <c:v>2363.6799999999998</c:v>
                </c:pt>
                <c:pt idx="30">
                  <c:v>1359.77</c:v>
                </c:pt>
                <c:pt idx="31">
                  <c:v>1475.61</c:v>
                </c:pt>
                <c:pt idx="32">
                  <c:v>1443.98</c:v>
                </c:pt>
                <c:pt idx="33">
                  <c:v>1933.59</c:v>
                </c:pt>
                <c:pt idx="34">
                  <c:v>1465.92</c:v>
                </c:pt>
                <c:pt idx="35">
                  <c:v>1269.19</c:v>
                </c:pt>
                <c:pt idx="36">
                  <c:v>1413.99</c:v>
                </c:pt>
                <c:pt idx="37">
                  <c:v>1525</c:v>
                </c:pt>
                <c:pt idx="38">
                  <c:v>1099.08</c:v>
                </c:pt>
                <c:pt idx="39">
                  <c:v>1325.71</c:v>
                </c:pt>
                <c:pt idx="40">
                  <c:v>1214.74</c:v>
                </c:pt>
                <c:pt idx="41">
                  <c:v>1471.37</c:v>
                </c:pt>
                <c:pt idx="42">
                  <c:v>1291.54</c:v>
                </c:pt>
                <c:pt idx="43">
                  <c:v>1654.49</c:v>
                </c:pt>
                <c:pt idx="44">
                  <c:v>1389.86</c:v>
                </c:pt>
                <c:pt idx="45">
                  <c:v>1251.4100000000001</c:v>
                </c:pt>
                <c:pt idx="46">
                  <c:v>1390.77</c:v>
                </c:pt>
                <c:pt idx="47">
                  <c:v>1085.6199999999999</c:v>
                </c:pt>
                <c:pt idx="48">
                  <c:v>1004.9</c:v>
                </c:pt>
                <c:pt idx="49">
                  <c:v>1255.21</c:v>
                </c:pt>
                <c:pt idx="50">
                  <c:v>1593.33</c:v>
                </c:pt>
                <c:pt idx="51">
                  <c:v>2920.78</c:v>
                </c:pt>
                <c:pt idx="52">
                  <c:v>2412.5100000000002</c:v>
                </c:pt>
                <c:pt idx="53">
                  <c:v>3211.2400000000098</c:v>
                </c:pt>
                <c:pt idx="54">
                  <c:v>2657.75000000001</c:v>
                </c:pt>
                <c:pt idx="55">
                  <c:v>3188.9300000000098</c:v>
                </c:pt>
                <c:pt idx="56">
                  <c:v>3051.54</c:v>
                </c:pt>
                <c:pt idx="57">
                  <c:v>3213.7400000000098</c:v>
                </c:pt>
                <c:pt idx="58">
                  <c:v>7691.63</c:v>
                </c:pt>
                <c:pt idx="59">
                  <c:v>3190.96</c:v>
                </c:pt>
                <c:pt idx="60">
                  <c:v>2436.62</c:v>
                </c:pt>
                <c:pt idx="61">
                  <c:v>2517.35</c:v>
                </c:pt>
                <c:pt idx="62">
                  <c:v>2521.1</c:v>
                </c:pt>
                <c:pt idx="63">
                  <c:v>2088.89</c:v>
                </c:pt>
                <c:pt idx="64">
                  <c:v>2241.2399999999998</c:v>
                </c:pt>
                <c:pt idx="65">
                  <c:v>2240.7199999999998</c:v>
                </c:pt>
                <c:pt idx="66">
                  <c:v>2760.88</c:v>
                </c:pt>
                <c:pt idx="67">
                  <c:v>2259.46</c:v>
                </c:pt>
                <c:pt idx="68">
                  <c:v>2300.0100000000002</c:v>
                </c:pt>
                <c:pt idx="69">
                  <c:v>2873.22</c:v>
                </c:pt>
                <c:pt idx="70">
                  <c:v>2703.4200000000101</c:v>
                </c:pt>
                <c:pt idx="71">
                  <c:v>2472.52</c:v>
                </c:pt>
                <c:pt idx="72">
                  <c:v>2629.15</c:v>
                </c:pt>
                <c:pt idx="73">
                  <c:v>2695.83</c:v>
                </c:pt>
                <c:pt idx="74">
                  <c:v>3200.25000000001</c:v>
                </c:pt>
                <c:pt idx="75">
                  <c:v>2987.1100000000101</c:v>
                </c:pt>
                <c:pt idx="76">
                  <c:v>3230.22</c:v>
                </c:pt>
                <c:pt idx="77">
                  <c:v>3367.42</c:v>
                </c:pt>
                <c:pt idx="78">
                  <c:v>3169.02</c:v>
                </c:pt>
                <c:pt idx="79">
                  <c:v>2973.22</c:v>
                </c:pt>
                <c:pt idx="80">
                  <c:v>2845.78</c:v>
                </c:pt>
                <c:pt idx="81">
                  <c:v>3313.43</c:v>
                </c:pt>
                <c:pt idx="82">
                  <c:v>2961.3700000000099</c:v>
                </c:pt>
                <c:pt idx="83">
                  <c:v>3422.86</c:v>
                </c:pt>
                <c:pt idx="84">
                  <c:v>3412.6200000000099</c:v>
                </c:pt>
                <c:pt idx="85">
                  <c:v>3268.1800000000098</c:v>
                </c:pt>
                <c:pt idx="86">
                  <c:v>3151.8</c:v>
                </c:pt>
                <c:pt idx="87">
                  <c:v>3322.2600000000102</c:v>
                </c:pt>
                <c:pt idx="88">
                  <c:v>3371.3100000000099</c:v>
                </c:pt>
                <c:pt idx="89">
                  <c:v>3202.01</c:v>
                </c:pt>
                <c:pt idx="90">
                  <c:v>3476.79</c:v>
                </c:pt>
                <c:pt idx="91">
                  <c:v>2816.6100000000101</c:v>
                </c:pt>
                <c:pt idx="92">
                  <c:v>3063.22</c:v>
                </c:pt>
                <c:pt idx="93">
                  <c:v>3078.7</c:v>
                </c:pt>
                <c:pt idx="94">
                  <c:v>3144.21</c:v>
                </c:pt>
                <c:pt idx="95">
                  <c:v>2792.99</c:v>
                </c:pt>
                <c:pt idx="96">
                  <c:v>3437.1800000000098</c:v>
                </c:pt>
                <c:pt idx="97">
                  <c:v>3088.79</c:v>
                </c:pt>
                <c:pt idx="98">
                  <c:v>3014.46</c:v>
                </c:pt>
                <c:pt idx="99">
                  <c:v>3495.30000000001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239-4B21-AD3C-338437351F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1370280"/>
        <c:axId val="641374872"/>
      </c:lineChart>
      <c:catAx>
        <c:axId val="641370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41374872"/>
        <c:crosses val="autoZero"/>
        <c:auto val="1"/>
        <c:lblAlgn val="ctr"/>
        <c:lblOffset val="100"/>
        <c:noMultiLvlLbl val="0"/>
      </c:catAx>
      <c:valAx>
        <c:axId val="6413748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41370280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60863737973670617"/>
          <c:y val="0.19401429993664585"/>
          <c:w val="0.3316028058112454"/>
          <c:h val="7.7801374413260599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chemeClr val="tx1"/>
                </a:solidFill>
              </a:rPr>
              <a:t>CCGG-TTS</a:t>
            </a:r>
            <a:endParaRPr lang="zh-CN" alt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cgg_TTS!$A$5</c:f>
              <c:strCache>
                <c:ptCount val="1"/>
                <c:pt idx="0">
                  <c:v>E26CK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ccgg_TTS!$B$4:$CW$4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TS!$B$5:$CW$5</c:f>
              <c:numCache>
                <c:formatCode>General</c:formatCode>
                <c:ptCount val="100"/>
                <c:pt idx="0">
                  <c:v>1250.68</c:v>
                </c:pt>
                <c:pt idx="1">
                  <c:v>3150.4099999999899</c:v>
                </c:pt>
                <c:pt idx="2">
                  <c:v>4353.78999999999</c:v>
                </c:pt>
                <c:pt idx="3">
                  <c:v>2489.3099999999899</c:v>
                </c:pt>
                <c:pt idx="4">
                  <c:v>3187.6699999999901</c:v>
                </c:pt>
                <c:pt idx="5">
                  <c:v>2866.4199999999901</c:v>
                </c:pt>
                <c:pt idx="6">
                  <c:v>2958.47999999999</c:v>
                </c:pt>
                <c:pt idx="7">
                  <c:v>2785.03999999999</c:v>
                </c:pt>
                <c:pt idx="8">
                  <c:v>2320.61</c:v>
                </c:pt>
                <c:pt idx="9">
                  <c:v>2816.5299999999902</c:v>
                </c:pt>
                <c:pt idx="10">
                  <c:v>2899.1499999999901</c:v>
                </c:pt>
                <c:pt idx="11">
                  <c:v>3048.24999999999</c:v>
                </c:pt>
                <c:pt idx="12">
                  <c:v>2595.8299999999899</c:v>
                </c:pt>
                <c:pt idx="13">
                  <c:v>2987.42</c:v>
                </c:pt>
                <c:pt idx="14">
                  <c:v>3296.7199999999898</c:v>
                </c:pt>
                <c:pt idx="15">
                  <c:v>2844.3299999999899</c:v>
                </c:pt>
                <c:pt idx="16">
                  <c:v>2811.7599999999902</c:v>
                </c:pt>
                <c:pt idx="17">
                  <c:v>3131.57</c:v>
                </c:pt>
                <c:pt idx="18">
                  <c:v>3245.47999999999</c:v>
                </c:pt>
                <c:pt idx="19">
                  <c:v>2410.61</c:v>
                </c:pt>
                <c:pt idx="20">
                  <c:v>3526.1899999999901</c:v>
                </c:pt>
                <c:pt idx="21">
                  <c:v>3146.26</c:v>
                </c:pt>
                <c:pt idx="22">
                  <c:v>2947.5599999999899</c:v>
                </c:pt>
                <c:pt idx="23">
                  <c:v>3049.7199999999898</c:v>
                </c:pt>
                <c:pt idx="24">
                  <c:v>2742.53999999999</c:v>
                </c:pt>
                <c:pt idx="25">
                  <c:v>2924.78</c:v>
                </c:pt>
                <c:pt idx="26">
                  <c:v>3097.5799999999899</c:v>
                </c:pt>
                <c:pt idx="27">
                  <c:v>3072.46</c:v>
                </c:pt>
                <c:pt idx="28">
                  <c:v>2827.6099999999901</c:v>
                </c:pt>
                <c:pt idx="29">
                  <c:v>3098.9099999999899</c:v>
                </c:pt>
                <c:pt idx="30">
                  <c:v>2934.8499999999899</c:v>
                </c:pt>
                <c:pt idx="31">
                  <c:v>3468.3799999999901</c:v>
                </c:pt>
                <c:pt idx="32">
                  <c:v>3542.78999999999</c:v>
                </c:pt>
                <c:pt idx="33">
                  <c:v>3638.65</c:v>
                </c:pt>
                <c:pt idx="34">
                  <c:v>3332.9499999999898</c:v>
                </c:pt>
                <c:pt idx="35">
                  <c:v>4633.3699999999899</c:v>
                </c:pt>
                <c:pt idx="36">
                  <c:v>3684.9099999999798</c:v>
                </c:pt>
                <c:pt idx="37">
                  <c:v>3349.4099999999899</c:v>
                </c:pt>
                <c:pt idx="38">
                  <c:v>3680.3499999999899</c:v>
                </c:pt>
                <c:pt idx="39">
                  <c:v>3553.6699999999901</c:v>
                </c:pt>
                <c:pt idx="40">
                  <c:v>3121.8899999999899</c:v>
                </c:pt>
                <c:pt idx="41">
                  <c:v>3639.0299999999902</c:v>
                </c:pt>
                <c:pt idx="42">
                  <c:v>3640.8299999999899</c:v>
                </c:pt>
                <c:pt idx="43">
                  <c:v>3622.8399999999901</c:v>
                </c:pt>
                <c:pt idx="44">
                  <c:v>3107.5799999999899</c:v>
                </c:pt>
                <c:pt idx="45">
                  <c:v>2867.0499999999902</c:v>
                </c:pt>
                <c:pt idx="46">
                  <c:v>2422.3499999999899</c:v>
                </c:pt>
                <c:pt idx="47">
                  <c:v>2313.64</c:v>
                </c:pt>
                <c:pt idx="48">
                  <c:v>2558.9699999999898</c:v>
                </c:pt>
                <c:pt idx="49">
                  <c:v>2666.7599999999902</c:v>
                </c:pt>
                <c:pt idx="50">
                  <c:v>2465.5500000000002</c:v>
                </c:pt>
                <c:pt idx="51">
                  <c:v>1142.0899999999999</c:v>
                </c:pt>
                <c:pt idx="52">
                  <c:v>1458.27</c:v>
                </c:pt>
                <c:pt idx="53">
                  <c:v>1193.6099999999999</c:v>
                </c:pt>
                <c:pt idx="54">
                  <c:v>1554.95</c:v>
                </c:pt>
                <c:pt idx="55">
                  <c:v>1271.8499999999999</c:v>
                </c:pt>
                <c:pt idx="56">
                  <c:v>1410.64</c:v>
                </c:pt>
                <c:pt idx="57">
                  <c:v>1283.7</c:v>
                </c:pt>
                <c:pt idx="58">
                  <c:v>1313.63</c:v>
                </c:pt>
                <c:pt idx="59">
                  <c:v>1510.95</c:v>
                </c:pt>
                <c:pt idx="60">
                  <c:v>1648.6</c:v>
                </c:pt>
                <c:pt idx="61">
                  <c:v>1213.3499999999999</c:v>
                </c:pt>
                <c:pt idx="62">
                  <c:v>1350.3</c:v>
                </c:pt>
                <c:pt idx="63">
                  <c:v>1131.83</c:v>
                </c:pt>
                <c:pt idx="64">
                  <c:v>1622.52</c:v>
                </c:pt>
                <c:pt idx="65">
                  <c:v>1744.45</c:v>
                </c:pt>
                <c:pt idx="66">
                  <c:v>1393.06</c:v>
                </c:pt>
                <c:pt idx="67">
                  <c:v>1630.67</c:v>
                </c:pt>
                <c:pt idx="68">
                  <c:v>1444.41</c:v>
                </c:pt>
                <c:pt idx="69">
                  <c:v>1588.45</c:v>
                </c:pt>
                <c:pt idx="70">
                  <c:v>1305.97</c:v>
                </c:pt>
                <c:pt idx="71">
                  <c:v>1497.67</c:v>
                </c:pt>
                <c:pt idx="72">
                  <c:v>1433.68</c:v>
                </c:pt>
                <c:pt idx="73">
                  <c:v>1724.36</c:v>
                </c:pt>
                <c:pt idx="74">
                  <c:v>1460.05</c:v>
                </c:pt>
                <c:pt idx="75">
                  <c:v>1341.45</c:v>
                </c:pt>
                <c:pt idx="76">
                  <c:v>1822.81</c:v>
                </c:pt>
                <c:pt idx="77">
                  <c:v>1846.22</c:v>
                </c:pt>
                <c:pt idx="78">
                  <c:v>1901.86</c:v>
                </c:pt>
                <c:pt idx="79">
                  <c:v>1749.54</c:v>
                </c:pt>
                <c:pt idx="80">
                  <c:v>1513.08</c:v>
                </c:pt>
                <c:pt idx="81">
                  <c:v>1667.96</c:v>
                </c:pt>
                <c:pt idx="82">
                  <c:v>1887.87</c:v>
                </c:pt>
                <c:pt idx="83">
                  <c:v>1321.35</c:v>
                </c:pt>
                <c:pt idx="84">
                  <c:v>1744.48</c:v>
                </c:pt>
                <c:pt idx="85">
                  <c:v>1455.37</c:v>
                </c:pt>
                <c:pt idx="86">
                  <c:v>1476.61</c:v>
                </c:pt>
                <c:pt idx="87">
                  <c:v>1706.33</c:v>
                </c:pt>
                <c:pt idx="88">
                  <c:v>1546.04</c:v>
                </c:pt>
                <c:pt idx="89">
                  <c:v>1281.8</c:v>
                </c:pt>
                <c:pt idx="90">
                  <c:v>1808.77</c:v>
                </c:pt>
                <c:pt idx="91">
                  <c:v>1767.58</c:v>
                </c:pt>
                <c:pt idx="92">
                  <c:v>1603.25</c:v>
                </c:pt>
                <c:pt idx="93">
                  <c:v>1907.73</c:v>
                </c:pt>
                <c:pt idx="94">
                  <c:v>1726.87</c:v>
                </c:pt>
                <c:pt idx="95">
                  <c:v>1672.05</c:v>
                </c:pt>
                <c:pt idx="96">
                  <c:v>1632.11</c:v>
                </c:pt>
                <c:pt idx="97">
                  <c:v>1776.27</c:v>
                </c:pt>
                <c:pt idx="98">
                  <c:v>3904.3499999999899</c:v>
                </c:pt>
                <c:pt idx="99">
                  <c:v>2068.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4A3-4225-8E2D-40C3B0305AAA}"/>
            </c:ext>
          </c:extLst>
        </c:ser>
        <c:ser>
          <c:idx val="1"/>
          <c:order val="1"/>
          <c:tx>
            <c:strRef>
              <c:f>ccgg_TTS!$A$6</c:f>
              <c:strCache>
                <c:ptCount val="1"/>
                <c:pt idx="0">
                  <c:v>E26SD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ccgg_TTS!$B$4:$CW$4</c:f>
              <c:numCache>
                <c:formatCode>General</c:formatCode>
                <c:ptCount val="100"/>
                <c:pt idx="0">
                  <c:v>-1980</c:v>
                </c:pt>
                <c:pt idx="1">
                  <c:v>-1940</c:v>
                </c:pt>
                <c:pt idx="2">
                  <c:v>-1900</c:v>
                </c:pt>
                <c:pt idx="3">
                  <c:v>-1860</c:v>
                </c:pt>
                <c:pt idx="4">
                  <c:v>-1820</c:v>
                </c:pt>
                <c:pt idx="5">
                  <c:v>-1780</c:v>
                </c:pt>
                <c:pt idx="6">
                  <c:v>-1740</c:v>
                </c:pt>
                <c:pt idx="7">
                  <c:v>-1700</c:v>
                </c:pt>
                <c:pt idx="8">
                  <c:v>-1660</c:v>
                </c:pt>
                <c:pt idx="9">
                  <c:v>-1620</c:v>
                </c:pt>
                <c:pt idx="10">
                  <c:v>-1580</c:v>
                </c:pt>
                <c:pt idx="11">
                  <c:v>-1540</c:v>
                </c:pt>
                <c:pt idx="12">
                  <c:v>-1500</c:v>
                </c:pt>
                <c:pt idx="13">
                  <c:v>-1460</c:v>
                </c:pt>
                <c:pt idx="14">
                  <c:v>-1420</c:v>
                </c:pt>
                <c:pt idx="15">
                  <c:v>-1380</c:v>
                </c:pt>
                <c:pt idx="16">
                  <c:v>-1340</c:v>
                </c:pt>
                <c:pt idx="17">
                  <c:v>-1300</c:v>
                </c:pt>
                <c:pt idx="18">
                  <c:v>-1260</c:v>
                </c:pt>
                <c:pt idx="19">
                  <c:v>-1220</c:v>
                </c:pt>
                <c:pt idx="20">
                  <c:v>-1180</c:v>
                </c:pt>
                <c:pt idx="21">
                  <c:v>-1140</c:v>
                </c:pt>
                <c:pt idx="22">
                  <c:v>-1100</c:v>
                </c:pt>
                <c:pt idx="23">
                  <c:v>-1060</c:v>
                </c:pt>
                <c:pt idx="24">
                  <c:v>-1020</c:v>
                </c:pt>
                <c:pt idx="25">
                  <c:v>-980</c:v>
                </c:pt>
                <c:pt idx="26">
                  <c:v>-940</c:v>
                </c:pt>
                <c:pt idx="27">
                  <c:v>-900</c:v>
                </c:pt>
                <c:pt idx="28">
                  <c:v>-860</c:v>
                </c:pt>
                <c:pt idx="29">
                  <c:v>-820</c:v>
                </c:pt>
                <c:pt idx="30">
                  <c:v>-780</c:v>
                </c:pt>
                <c:pt idx="31">
                  <c:v>-740</c:v>
                </c:pt>
                <c:pt idx="32">
                  <c:v>-700</c:v>
                </c:pt>
                <c:pt idx="33">
                  <c:v>-660</c:v>
                </c:pt>
                <c:pt idx="34">
                  <c:v>-620</c:v>
                </c:pt>
                <c:pt idx="35">
                  <c:v>-580</c:v>
                </c:pt>
                <c:pt idx="36">
                  <c:v>-540</c:v>
                </c:pt>
                <c:pt idx="37">
                  <c:v>-500</c:v>
                </c:pt>
                <c:pt idx="38">
                  <c:v>-460</c:v>
                </c:pt>
                <c:pt idx="39">
                  <c:v>-420</c:v>
                </c:pt>
                <c:pt idx="40">
                  <c:v>-380</c:v>
                </c:pt>
                <c:pt idx="41">
                  <c:v>-340</c:v>
                </c:pt>
                <c:pt idx="42">
                  <c:v>-300</c:v>
                </c:pt>
                <c:pt idx="43">
                  <c:v>-260</c:v>
                </c:pt>
                <c:pt idx="44">
                  <c:v>-220</c:v>
                </c:pt>
                <c:pt idx="45">
                  <c:v>-180</c:v>
                </c:pt>
                <c:pt idx="46">
                  <c:v>-140</c:v>
                </c:pt>
                <c:pt idx="47">
                  <c:v>-100</c:v>
                </c:pt>
                <c:pt idx="48">
                  <c:v>-60</c:v>
                </c:pt>
                <c:pt idx="49">
                  <c:v>-20</c:v>
                </c:pt>
                <c:pt idx="50">
                  <c:v>20</c:v>
                </c:pt>
                <c:pt idx="51">
                  <c:v>60</c:v>
                </c:pt>
                <c:pt idx="52">
                  <c:v>100</c:v>
                </c:pt>
                <c:pt idx="53">
                  <c:v>140</c:v>
                </c:pt>
                <c:pt idx="54">
                  <c:v>180</c:v>
                </c:pt>
                <c:pt idx="55">
                  <c:v>220</c:v>
                </c:pt>
                <c:pt idx="56">
                  <c:v>260</c:v>
                </c:pt>
                <c:pt idx="57">
                  <c:v>300</c:v>
                </c:pt>
                <c:pt idx="58">
                  <c:v>340</c:v>
                </c:pt>
                <c:pt idx="59">
                  <c:v>380</c:v>
                </c:pt>
                <c:pt idx="60">
                  <c:v>420</c:v>
                </c:pt>
                <c:pt idx="61">
                  <c:v>460</c:v>
                </c:pt>
                <c:pt idx="62">
                  <c:v>500</c:v>
                </c:pt>
                <c:pt idx="63">
                  <c:v>540</c:v>
                </c:pt>
                <c:pt idx="64">
                  <c:v>580</c:v>
                </c:pt>
                <c:pt idx="65">
                  <c:v>620</c:v>
                </c:pt>
                <c:pt idx="66">
                  <c:v>660</c:v>
                </c:pt>
                <c:pt idx="67">
                  <c:v>700</c:v>
                </c:pt>
                <c:pt idx="68">
                  <c:v>740</c:v>
                </c:pt>
                <c:pt idx="69">
                  <c:v>780</c:v>
                </c:pt>
                <c:pt idx="70">
                  <c:v>820</c:v>
                </c:pt>
                <c:pt idx="71">
                  <c:v>860</c:v>
                </c:pt>
                <c:pt idx="72">
                  <c:v>900</c:v>
                </c:pt>
                <c:pt idx="73">
                  <c:v>940</c:v>
                </c:pt>
                <c:pt idx="74">
                  <c:v>980</c:v>
                </c:pt>
                <c:pt idx="75">
                  <c:v>1020</c:v>
                </c:pt>
                <c:pt idx="76">
                  <c:v>1060</c:v>
                </c:pt>
                <c:pt idx="77">
                  <c:v>1100</c:v>
                </c:pt>
                <c:pt idx="78">
                  <c:v>1140</c:v>
                </c:pt>
                <c:pt idx="79">
                  <c:v>1180</c:v>
                </c:pt>
                <c:pt idx="80">
                  <c:v>1220</c:v>
                </c:pt>
                <c:pt idx="81">
                  <c:v>1260</c:v>
                </c:pt>
                <c:pt idx="82">
                  <c:v>1300</c:v>
                </c:pt>
                <c:pt idx="83">
                  <c:v>1340</c:v>
                </c:pt>
                <c:pt idx="84">
                  <c:v>1380</c:v>
                </c:pt>
                <c:pt idx="85">
                  <c:v>1420</c:v>
                </c:pt>
                <c:pt idx="86">
                  <c:v>1460</c:v>
                </c:pt>
                <c:pt idx="87">
                  <c:v>1500</c:v>
                </c:pt>
                <c:pt idx="88">
                  <c:v>1540</c:v>
                </c:pt>
                <c:pt idx="89">
                  <c:v>1580</c:v>
                </c:pt>
                <c:pt idx="90">
                  <c:v>1620</c:v>
                </c:pt>
                <c:pt idx="91">
                  <c:v>1660</c:v>
                </c:pt>
                <c:pt idx="92">
                  <c:v>1700</c:v>
                </c:pt>
                <c:pt idx="93">
                  <c:v>1740</c:v>
                </c:pt>
                <c:pt idx="94">
                  <c:v>1780</c:v>
                </c:pt>
                <c:pt idx="95">
                  <c:v>1820</c:v>
                </c:pt>
                <c:pt idx="96">
                  <c:v>1860</c:v>
                </c:pt>
                <c:pt idx="97">
                  <c:v>1900</c:v>
                </c:pt>
                <c:pt idx="98">
                  <c:v>1940</c:v>
                </c:pt>
                <c:pt idx="99">
                  <c:v>1980</c:v>
                </c:pt>
              </c:numCache>
            </c:numRef>
          </c:cat>
          <c:val>
            <c:numRef>
              <c:f>ccgg_TTS!$B$6:$CW$6</c:f>
              <c:numCache>
                <c:formatCode>General</c:formatCode>
                <c:ptCount val="100"/>
                <c:pt idx="0">
                  <c:v>1202.5899999999999</c:v>
                </c:pt>
                <c:pt idx="1">
                  <c:v>3133.23</c:v>
                </c:pt>
                <c:pt idx="2">
                  <c:v>3543.11</c:v>
                </c:pt>
                <c:pt idx="3">
                  <c:v>2371.7800000000002</c:v>
                </c:pt>
                <c:pt idx="4">
                  <c:v>3127.83</c:v>
                </c:pt>
                <c:pt idx="5">
                  <c:v>2787.93</c:v>
                </c:pt>
                <c:pt idx="6">
                  <c:v>2926.37</c:v>
                </c:pt>
                <c:pt idx="7">
                  <c:v>2782.76</c:v>
                </c:pt>
                <c:pt idx="8">
                  <c:v>2349.77</c:v>
                </c:pt>
                <c:pt idx="9">
                  <c:v>2768.44</c:v>
                </c:pt>
                <c:pt idx="10">
                  <c:v>2930.9900000000098</c:v>
                </c:pt>
                <c:pt idx="11">
                  <c:v>2926.75</c:v>
                </c:pt>
                <c:pt idx="12">
                  <c:v>2476.79</c:v>
                </c:pt>
                <c:pt idx="13">
                  <c:v>2904.8800000000101</c:v>
                </c:pt>
                <c:pt idx="14">
                  <c:v>3222.29</c:v>
                </c:pt>
                <c:pt idx="15">
                  <c:v>2857.13</c:v>
                </c:pt>
                <c:pt idx="16">
                  <c:v>2730.52</c:v>
                </c:pt>
                <c:pt idx="17">
                  <c:v>3102.85</c:v>
                </c:pt>
                <c:pt idx="18">
                  <c:v>3190.5300000000102</c:v>
                </c:pt>
                <c:pt idx="19">
                  <c:v>2417.2800000000002</c:v>
                </c:pt>
                <c:pt idx="20">
                  <c:v>3903.5700000000102</c:v>
                </c:pt>
                <c:pt idx="21">
                  <c:v>3063.1600000000099</c:v>
                </c:pt>
                <c:pt idx="22">
                  <c:v>2803.52</c:v>
                </c:pt>
                <c:pt idx="23">
                  <c:v>3099.91</c:v>
                </c:pt>
                <c:pt idx="24">
                  <c:v>2658.3</c:v>
                </c:pt>
                <c:pt idx="25">
                  <c:v>2849.1</c:v>
                </c:pt>
                <c:pt idx="26">
                  <c:v>3081.72</c:v>
                </c:pt>
                <c:pt idx="27">
                  <c:v>3012.35</c:v>
                </c:pt>
                <c:pt idx="28">
                  <c:v>2820.82</c:v>
                </c:pt>
                <c:pt idx="29">
                  <c:v>3169.03</c:v>
                </c:pt>
                <c:pt idx="30">
                  <c:v>2922.94</c:v>
                </c:pt>
                <c:pt idx="31">
                  <c:v>3416.9</c:v>
                </c:pt>
                <c:pt idx="32">
                  <c:v>3455.7000000000098</c:v>
                </c:pt>
                <c:pt idx="33">
                  <c:v>3540.94</c:v>
                </c:pt>
                <c:pt idx="34">
                  <c:v>3321.5100000000102</c:v>
                </c:pt>
                <c:pt idx="35">
                  <c:v>4608.1000000000104</c:v>
                </c:pt>
                <c:pt idx="36">
                  <c:v>3526.91</c:v>
                </c:pt>
                <c:pt idx="37">
                  <c:v>3457.7000000000098</c:v>
                </c:pt>
                <c:pt idx="38">
                  <c:v>3609.1100000000101</c:v>
                </c:pt>
                <c:pt idx="39">
                  <c:v>3569.0800000000099</c:v>
                </c:pt>
                <c:pt idx="40">
                  <c:v>3110.50000000001</c:v>
                </c:pt>
                <c:pt idx="41">
                  <c:v>3654.9300000000098</c:v>
                </c:pt>
                <c:pt idx="42">
                  <c:v>3616.8500000000099</c:v>
                </c:pt>
                <c:pt idx="43">
                  <c:v>3595.7200000000098</c:v>
                </c:pt>
                <c:pt idx="44">
                  <c:v>3060.9900000000098</c:v>
                </c:pt>
                <c:pt idx="45">
                  <c:v>2938.0300000000102</c:v>
                </c:pt>
                <c:pt idx="46">
                  <c:v>2420.44</c:v>
                </c:pt>
                <c:pt idx="47">
                  <c:v>2238.3200000000002</c:v>
                </c:pt>
                <c:pt idx="48">
                  <c:v>2629.08</c:v>
                </c:pt>
                <c:pt idx="49">
                  <c:v>2553.52</c:v>
                </c:pt>
                <c:pt idx="50">
                  <c:v>3429.09</c:v>
                </c:pt>
                <c:pt idx="51">
                  <c:v>1167.02</c:v>
                </c:pt>
                <c:pt idx="52">
                  <c:v>1395.85</c:v>
                </c:pt>
                <c:pt idx="53">
                  <c:v>1158.08</c:v>
                </c:pt>
                <c:pt idx="54">
                  <c:v>1579.04</c:v>
                </c:pt>
                <c:pt idx="55">
                  <c:v>1293.23</c:v>
                </c:pt>
                <c:pt idx="56">
                  <c:v>1440.11</c:v>
                </c:pt>
                <c:pt idx="57">
                  <c:v>1235.3800000000001</c:v>
                </c:pt>
                <c:pt idx="58">
                  <c:v>1343.06</c:v>
                </c:pt>
                <c:pt idx="59">
                  <c:v>1413.52</c:v>
                </c:pt>
                <c:pt idx="60">
                  <c:v>1593.33</c:v>
                </c:pt>
                <c:pt idx="61">
                  <c:v>1178.8900000000001</c:v>
                </c:pt>
                <c:pt idx="62">
                  <c:v>1325.27</c:v>
                </c:pt>
                <c:pt idx="63">
                  <c:v>1082.19</c:v>
                </c:pt>
                <c:pt idx="64">
                  <c:v>1576.06</c:v>
                </c:pt>
                <c:pt idx="65">
                  <c:v>1682.8</c:v>
                </c:pt>
                <c:pt idx="66">
                  <c:v>1344.3</c:v>
                </c:pt>
                <c:pt idx="67">
                  <c:v>1523.75</c:v>
                </c:pt>
                <c:pt idx="68">
                  <c:v>1492.05</c:v>
                </c:pt>
                <c:pt idx="69">
                  <c:v>1475.48</c:v>
                </c:pt>
                <c:pt idx="70">
                  <c:v>1276.75</c:v>
                </c:pt>
                <c:pt idx="71">
                  <c:v>1513.92</c:v>
                </c:pt>
                <c:pt idx="72">
                  <c:v>1389.55</c:v>
                </c:pt>
                <c:pt idx="73">
                  <c:v>1616.16</c:v>
                </c:pt>
                <c:pt idx="74">
                  <c:v>1411.1</c:v>
                </c:pt>
                <c:pt idx="75">
                  <c:v>1375.14</c:v>
                </c:pt>
                <c:pt idx="76">
                  <c:v>1806.12</c:v>
                </c:pt>
                <c:pt idx="77">
                  <c:v>1767.31</c:v>
                </c:pt>
                <c:pt idx="78">
                  <c:v>1848.29</c:v>
                </c:pt>
                <c:pt idx="79">
                  <c:v>1813.33</c:v>
                </c:pt>
                <c:pt idx="80">
                  <c:v>1429.63</c:v>
                </c:pt>
                <c:pt idx="81">
                  <c:v>1554.51</c:v>
                </c:pt>
                <c:pt idx="82">
                  <c:v>1857.71</c:v>
                </c:pt>
                <c:pt idx="83">
                  <c:v>1353.26</c:v>
                </c:pt>
                <c:pt idx="84">
                  <c:v>1823.02</c:v>
                </c:pt>
                <c:pt idx="85">
                  <c:v>1380.52</c:v>
                </c:pt>
                <c:pt idx="86">
                  <c:v>1452.81</c:v>
                </c:pt>
                <c:pt idx="87">
                  <c:v>1634.69</c:v>
                </c:pt>
                <c:pt idx="88">
                  <c:v>1429.98</c:v>
                </c:pt>
                <c:pt idx="89">
                  <c:v>1235.9000000000001</c:v>
                </c:pt>
                <c:pt idx="90">
                  <c:v>1674.43</c:v>
                </c:pt>
                <c:pt idx="91">
                  <c:v>1717.89</c:v>
                </c:pt>
                <c:pt idx="92">
                  <c:v>1596.76</c:v>
                </c:pt>
                <c:pt idx="93">
                  <c:v>1918.77</c:v>
                </c:pt>
                <c:pt idx="94">
                  <c:v>1759.67</c:v>
                </c:pt>
                <c:pt idx="95">
                  <c:v>1643.63</c:v>
                </c:pt>
                <c:pt idx="96">
                  <c:v>1583.59</c:v>
                </c:pt>
                <c:pt idx="97">
                  <c:v>1842.8</c:v>
                </c:pt>
                <c:pt idx="98">
                  <c:v>4926.87</c:v>
                </c:pt>
                <c:pt idx="99">
                  <c:v>2053.44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4A3-4225-8E2D-40C3B0305A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1376184"/>
        <c:axId val="641366016"/>
      </c:lineChart>
      <c:catAx>
        <c:axId val="641376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41366016"/>
        <c:crosses val="autoZero"/>
        <c:auto val="1"/>
        <c:lblAlgn val="ctr"/>
        <c:lblOffset val="100"/>
        <c:noMultiLvlLbl val="0"/>
      </c:catAx>
      <c:valAx>
        <c:axId val="641366016"/>
        <c:scaling>
          <c:orientation val="minMax"/>
          <c:max val="1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41376184"/>
        <c:crosses val="autoZero"/>
        <c:crossBetween val="between"/>
      </c:valAx>
      <c:spPr>
        <a:noFill/>
        <a:ln w="19050"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62158728436450794"/>
          <c:y val="0.18432183908045977"/>
          <c:w val="0.33218764321126526"/>
          <c:h val="7.7586749932120558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A16785-0088-4C44-A7FA-71A25D7826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DC2AEA3-8D29-4C94-8DEC-3DF12FA2DA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27A902-E77D-4F22-8C58-33B627C3B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63F79FD-7788-4F8A-970E-212CB7F3A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62E999-76C1-4398-9F61-5C46EAEA2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9846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6A391B-A5BE-4DDA-8C7F-CA7307247E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14B87E2-A7B2-46E9-A1D6-2A5617F449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9CD84-1322-42EA-B738-42D565D2F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18F9369-CF67-4052-9D5F-C8DC53E736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BCA3221-139B-4EBE-B28F-418538DEF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5054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B8A7987-2E0B-4045-89BD-F03F41F15D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DC57174-9A0E-4B71-9AC1-36926C34F7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86AE11-9CF7-42EA-91B6-B73876804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F4877B-2650-474F-A70B-BD698C8823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DB5DAAF-0892-43C1-ABD7-CD9D5119D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4541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3DB28D-0546-4DDE-A24E-7F6D7568DF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5B664C1-4787-41BA-8EA2-DE0C3FB06C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6F6305-17B5-40AF-88B6-A7DA9AD03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532F957-437A-4D5F-8EE8-98CA83A99B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5CFB08-CBA0-4ED9-9441-3000C3F9AE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0846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A29F23-8942-4565-8505-0C89AE6047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65E1567-54AA-4191-BC3A-1B07777B48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666FC2-29C6-4745-9133-AD64A68B8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54BAE7-C097-4CAA-B55B-350697590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8B6058-22DE-425F-9A8A-C380369D7D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050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270D0E-85AA-4454-B44A-BD2CF2357B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AA47D2-5B44-4F8B-9DA1-23C4AC28A83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851CBEC-0A94-4C06-960D-291A531CE1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490D51A-2C6A-44FA-B385-2AA27C61A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8C42734-D2C4-4BAD-B6B5-6178297E5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CB9A3FF-B71E-478F-96ED-1A0463487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7874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2CF5CE-52EE-4241-88DE-17FCD25CAE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659ABCB-B1E5-467E-B28A-77A131E884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FD34584-4C9C-4773-9F57-80D739CC39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40D63CF-944F-4FF8-A375-20BE126BC4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487D654-23BB-470B-A38B-8F4B421318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0D42B80-F057-436A-B2BC-3B32B0AC5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5541595-05A8-45A2-90BC-DB9E7FDA2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3030AEF-8B4A-4FDB-BEF8-130A3B4BC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4638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3C5D93-E43E-43D6-8FB6-B5507CC523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6F83861-D8D8-4B68-92B7-A64D80B62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0A2CF07-0C07-4B18-AEF8-6F32EDB93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445D836-7B98-4BBE-BF1F-1239A694A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91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C79B241-ECE0-4601-8295-08ADEBC6E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B185AEB-5367-407C-836C-1EF2B44DB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1F2512E-5154-4386-9E0C-41023E81B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002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F0A70E-1984-4FD6-B5A0-AB88BB0F78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37ABFEA-4804-4C94-8AFC-A4CC9C6A5F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948C91A-44E1-4BE3-B04C-011B1F1790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FEBE70A-EC38-4FC8-9924-4320F271A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38D4B36-9F84-40C6-9AF6-DDEF38608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4D316A1-32EC-4726-9085-1EEBB6EC1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878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DD0162-960E-449F-BAC5-DEEDE8179A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1922DE9-9282-43AD-AA9A-3FE148DBD9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D9C1FB4-F229-487C-98FC-E289451AEE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191B7D-D1FE-4EFF-9121-FA1122FA76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8F81E67-5B9C-469F-A35B-AC8A64872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42DE63C-9EE9-421D-A802-4D7FAD012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7817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DDFB806-7FD7-4555-9812-F681DB9741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9DA9E0-ECB1-4E54-9157-1403F7C23A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F6A2F9-0EEB-4875-9643-DF16364173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BA75D0-3A2C-44DD-B54A-304B52C9479C}" type="datetimeFigureOut">
              <a:rPr lang="zh-CN" altLang="en-US" smtClean="0"/>
              <a:t>2020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77D743E-CAEC-4AA1-B580-16296AD641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38D2BF-1E6E-4514-B148-05C9B56DF0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231888-8941-4AF9-9460-8E2334597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8088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7" Type="http://schemas.openxmlformats.org/officeDocument/2006/relationships/chart" Target="../charts/chart18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EBD20F-9153-4EC8-A22E-2CF14D8C4B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341128"/>
            <a:ext cx="9144000" cy="2387600"/>
          </a:xfrm>
        </p:spPr>
        <p:txBody>
          <a:bodyPr>
            <a:normAutofit/>
          </a:bodyPr>
          <a:lstStyle/>
          <a:p>
            <a:r>
              <a:rPr lang="en-US" altLang="zh-CN" sz="5400" b="1" dirty="0"/>
              <a:t>Supplementary Figures S1-S6</a:t>
            </a:r>
            <a:endParaRPr lang="zh-CN" altLang="en-US" sz="5400" b="1" dirty="0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B631C90-6DFD-4EFE-8142-A9AF4DF6C9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23278" y="3053917"/>
            <a:ext cx="10324730" cy="2823099"/>
          </a:xfrm>
        </p:spPr>
        <p:txBody>
          <a:bodyPr>
            <a:normAutofit/>
          </a:bodyPr>
          <a:lstStyle/>
          <a:p>
            <a:pPr algn="l"/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ticle title: 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Methylation affects photoperiodic-tuberization in potato (</a:t>
            </a:r>
            <a:r>
              <a:rPr lang="en-US" altLang="zh-CN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anum tuberosum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.) by mediating the expression of the genes related to photoperiod and GA pathway</a:t>
            </a:r>
            <a:endParaRPr lang="zh-CN" altLang="zh-CN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ournal name: 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rticulture Research</a:t>
            </a:r>
            <a:endParaRPr lang="zh-CN" altLang="zh-CN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 names: </a:t>
            </a:r>
            <a:r>
              <a:rPr lang="en-US" altLang="zh-CN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njun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i et al. </a:t>
            </a:r>
            <a:endParaRPr lang="zh-CN" altLang="zh-CN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 to 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un Zhou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-mail: zhoujun820830@163.com); </a:t>
            </a:r>
          </a:p>
          <a:p>
            <a:pPr algn="l"/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Jun Liu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-mail: liujun@mail.hzau.edu.cn)</a:t>
            </a:r>
            <a:endParaRPr lang="zh-CN" altLang="zh-CN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74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5E9B8A68-809C-40FB-9E86-8A570BF1AA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9401846"/>
              </p:ext>
            </p:extLst>
          </p:nvPr>
        </p:nvGraphicFramePr>
        <p:xfrm>
          <a:off x="4102873" y="0"/>
          <a:ext cx="3967701" cy="26836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图表 4">
            <a:extLst>
              <a:ext uri="{FF2B5EF4-FFF2-40B4-BE49-F238E27FC236}">
                <a16:creationId xmlns:a16="http://schemas.microsoft.com/office/drawing/2014/main" id="{10C7DFF0-07D2-494B-93CE-4539F50DD6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5273217"/>
              </p:ext>
            </p:extLst>
          </p:nvPr>
        </p:nvGraphicFramePr>
        <p:xfrm>
          <a:off x="135172" y="15240"/>
          <a:ext cx="3967701" cy="27470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图表 5">
            <a:extLst>
              <a:ext uri="{FF2B5EF4-FFF2-40B4-BE49-F238E27FC236}">
                <a16:creationId xmlns:a16="http://schemas.microsoft.com/office/drawing/2014/main" id="{E2E9994D-2BA5-4DF0-B205-9C575B10A1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4049116"/>
              </p:ext>
            </p:extLst>
          </p:nvPr>
        </p:nvGraphicFramePr>
        <p:xfrm>
          <a:off x="7935402" y="0"/>
          <a:ext cx="3967701" cy="2762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图表 6">
            <a:extLst>
              <a:ext uri="{FF2B5EF4-FFF2-40B4-BE49-F238E27FC236}">
                <a16:creationId xmlns:a16="http://schemas.microsoft.com/office/drawing/2014/main" id="{1C9106A5-8600-4B56-A046-37E0EF29F9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7140245"/>
              </p:ext>
            </p:extLst>
          </p:nvPr>
        </p:nvGraphicFramePr>
        <p:xfrm>
          <a:off x="159026" y="2715682"/>
          <a:ext cx="3921981" cy="2762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图表 7">
            <a:extLst>
              <a:ext uri="{FF2B5EF4-FFF2-40B4-BE49-F238E27FC236}">
                <a16:creationId xmlns:a16="http://schemas.microsoft.com/office/drawing/2014/main" id="{69D796F9-E169-49BF-A411-364382F868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5471593"/>
              </p:ext>
            </p:extLst>
          </p:nvPr>
        </p:nvGraphicFramePr>
        <p:xfrm>
          <a:off x="4102873" y="2709615"/>
          <a:ext cx="3921981" cy="26836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图表 8">
            <a:extLst>
              <a:ext uri="{FF2B5EF4-FFF2-40B4-BE49-F238E27FC236}">
                <a16:creationId xmlns:a16="http://schemas.microsoft.com/office/drawing/2014/main" id="{05F5A501-494C-41D2-BAAF-B140FC0A28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363093"/>
              </p:ext>
            </p:extLst>
          </p:nvPr>
        </p:nvGraphicFramePr>
        <p:xfrm>
          <a:off x="7981122" y="2709615"/>
          <a:ext cx="396770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文本框 9">
            <a:extLst>
              <a:ext uri="{FF2B5EF4-FFF2-40B4-BE49-F238E27FC236}">
                <a16:creationId xmlns:a16="http://schemas.microsoft.com/office/drawing/2014/main" id="{F9A55822-D1CD-499F-9153-9EC17E7C3D52}"/>
              </a:ext>
            </a:extLst>
          </p:cNvPr>
          <p:cNvSpPr txBox="1"/>
          <p:nvPr/>
        </p:nvSpPr>
        <p:spPr>
          <a:xfrm>
            <a:off x="341906" y="5701085"/>
            <a:ext cx="1143397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methylation levels at the CCGG and CCWGG sites in different regions of genes in E20.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showed the ±2000 bp of transcription start site (TSS), the relative position of gene body and the ±2000 bp of transcription termination site (TTS), respectively.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showed the relative DNA methylation level.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29044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6FA5B2F5-901D-4A99-B503-953867161B5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6170081"/>
              </p:ext>
            </p:extLst>
          </p:nvPr>
        </p:nvGraphicFramePr>
        <p:xfrm>
          <a:off x="4068417" y="121755"/>
          <a:ext cx="405516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图表 2">
            <a:extLst>
              <a:ext uri="{FF2B5EF4-FFF2-40B4-BE49-F238E27FC236}">
                <a16:creationId xmlns:a16="http://schemas.microsoft.com/office/drawing/2014/main" id="{43443F2F-87B5-412A-94BF-92A58213607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3533691"/>
              </p:ext>
            </p:extLst>
          </p:nvPr>
        </p:nvGraphicFramePr>
        <p:xfrm>
          <a:off x="123241" y="164990"/>
          <a:ext cx="4055165" cy="2762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1E3E644D-23C4-47CC-A6AA-BFEB1BD38B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0442318"/>
              </p:ext>
            </p:extLst>
          </p:nvPr>
        </p:nvGraphicFramePr>
        <p:xfrm>
          <a:off x="8013593" y="102705"/>
          <a:ext cx="4055165" cy="2762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图表 4">
            <a:extLst>
              <a:ext uri="{FF2B5EF4-FFF2-40B4-BE49-F238E27FC236}">
                <a16:creationId xmlns:a16="http://schemas.microsoft.com/office/drawing/2014/main" id="{79480FEC-5E10-4A86-B9CB-A8DD3AD8140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4272746"/>
              </p:ext>
            </p:extLst>
          </p:nvPr>
        </p:nvGraphicFramePr>
        <p:xfrm>
          <a:off x="123241" y="2870919"/>
          <a:ext cx="405516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图表 5">
            <a:extLst>
              <a:ext uri="{FF2B5EF4-FFF2-40B4-BE49-F238E27FC236}">
                <a16:creationId xmlns:a16="http://schemas.microsoft.com/office/drawing/2014/main" id="{B38C13AE-3EE4-42C9-95ED-4202074E2C2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7614903"/>
              </p:ext>
            </p:extLst>
          </p:nvPr>
        </p:nvGraphicFramePr>
        <p:xfrm>
          <a:off x="4068417" y="2879699"/>
          <a:ext cx="4055165" cy="2724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图表 6">
            <a:extLst>
              <a:ext uri="{FF2B5EF4-FFF2-40B4-BE49-F238E27FC236}">
                <a16:creationId xmlns:a16="http://schemas.microsoft.com/office/drawing/2014/main" id="{1DB74176-F286-40BF-B0EC-2B0D39C1E93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7504767"/>
              </p:ext>
            </p:extLst>
          </p:nvPr>
        </p:nvGraphicFramePr>
        <p:xfrm>
          <a:off x="8013593" y="2860649"/>
          <a:ext cx="405516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" name="文本框 7">
            <a:extLst>
              <a:ext uri="{FF2B5EF4-FFF2-40B4-BE49-F238E27FC236}">
                <a16:creationId xmlns:a16="http://schemas.microsoft.com/office/drawing/2014/main" id="{3B689639-6DEC-4A1C-9A43-884FC5B4D1B9}"/>
              </a:ext>
            </a:extLst>
          </p:cNvPr>
          <p:cNvSpPr txBox="1"/>
          <p:nvPr/>
        </p:nvSpPr>
        <p:spPr>
          <a:xfrm>
            <a:off x="341906" y="5701085"/>
            <a:ext cx="1143397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methylation levels at the CCGG and CCWGG sites in different regions of genes in E26.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showed the ±2000 bp of transcription start site (TSS), the relative position of gene body and the ±2000 bp of transcription termination site (TTS), respectively.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showed the relative DNA methylation level.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54072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75B9F5E2-E9E0-44B4-AB1C-E009CCA564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1809049"/>
              </p:ext>
            </p:extLst>
          </p:nvPr>
        </p:nvGraphicFramePr>
        <p:xfrm>
          <a:off x="4240530" y="145751"/>
          <a:ext cx="371094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图表 2">
            <a:extLst>
              <a:ext uri="{FF2B5EF4-FFF2-40B4-BE49-F238E27FC236}">
                <a16:creationId xmlns:a16="http://schemas.microsoft.com/office/drawing/2014/main" id="{103C0BF2-4A1F-4CEE-8786-9FEA94907E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6873534"/>
              </p:ext>
            </p:extLst>
          </p:nvPr>
        </p:nvGraphicFramePr>
        <p:xfrm>
          <a:off x="144932" y="134321"/>
          <a:ext cx="3990435" cy="27546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06A1C2C9-2645-448B-B5FD-53A741B6249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4513623"/>
              </p:ext>
            </p:extLst>
          </p:nvPr>
        </p:nvGraphicFramePr>
        <p:xfrm>
          <a:off x="8056633" y="136226"/>
          <a:ext cx="3990435" cy="2762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图表 4">
            <a:extLst>
              <a:ext uri="{FF2B5EF4-FFF2-40B4-BE49-F238E27FC236}">
                <a16:creationId xmlns:a16="http://schemas.microsoft.com/office/drawing/2014/main" id="{486B2992-5DD3-434D-BDA5-0AA4B41513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2730759"/>
              </p:ext>
            </p:extLst>
          </p:nvPr>
        </p:nvGraphicFramePr>
        <p:xfrm>
          <a:off x="101349" y="2822286"/>
          <a:ext cx="399043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图表 5">
            <a:extLst>
              <a:ext uri="{FF2B5EF4-FFF2-40B4-BE49-F238E27FC236}">
                <a16:creationId xmlns:a16="http://schemas.microsoft.com/office/drawing/2014/main" id="{A32D5AFE-94BF-462E-8D47-8219CF6762B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0095924"/>
              </p:ext>
            </p:extLst>
          </p:nvPr>
        </p:nvGraphicFramePr>
        <p:xfrm>
          <a:off x="4109781" y="2822286"/>
          <a:ext cx="399043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图表 6">
            <a:extLst>
              <a:ext uri="{FF2B5EF4-FFF2-40B4-BE49-F238E27FC236}">
                <a16:creationId xmlns:a16="http://schemas.microsoft.com/office/drawing/2014/main" id="{0BDEBF04-B9A3-4476-A90D-C11BD71437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7502870"/>
              </p:ext>
            </p:extLst>
          </p:nvPr>
        </p:nvGraphicFramePr>
        <p:xfrm>
          <a:off x="8118213" y="2826642"/>
          <a:ext cx="399043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" name="文本框 7">
            <a:extLst>
              <a:ext uri="{FF2B5EF4-FFF2-40B4-BE49-F238E27FC236}">
                <a16:creationId xmlns:a16="http://schemas.microsoft.com/office/drawing/2014/main" id="{822DE499-555F-470F-95E5-53932AED24FA}"/>
              </a:ext>
            </a:extLst>
          </p:cNvPr>
          <p:cNvSpPr txBox="1"/>
          <p:nvPr/>
        </p:nvSpPr>
        <p:spPr>
          <a:xfrm>
            <a:off x="341906" y="5701085"/>
            <a:ext cx="1143397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methylation levels at the CCGG and CCWGG sites in different regions of genes in E108.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showed the ±2000 bp of transcription start site (TSS), the relative position of gene body and the ±2000 bp of transcription termination site (TTS), respectively.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showed the relative DNA methylation level.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66074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EF1C11D-145E-44C4-A37B-DC75E0DB452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97"/>
          <a:stretch/>
        </p:blipFill>
        <p:spPr>
          <a:xfrm>
            <a:off x="5962664" y="779201"/>
            <a:ext cx="6184946" cy="476046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0E3E0F1-C11B-4174-8640-AF1DF39237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27" y="878686"/>
            <a:ext cx="5859603" cy="455444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4186E68-3162-4C3D-852D-ADB604175EA3}"/>
              </a:ext>
            </a:extLst>
          </p:cNvPr>
          <p:cNvSpPr txBox="1"/>
          <p:nvPr/>
        </p:nvSpPr>
        <p:spPr>
          <a:xfrm>
            <a:off x="341906" y="5701085"/>
            <a:ext cx="1143397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ontology classification and KEGG pathway enrichment of DMGs in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2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 GO classification,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is -log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 value), larger value represents a higher significance of the enrichment.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is GO terms, including biological process, cellular component, and molecular function. In KEGG pathway enrichment,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-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xis “rich factor” is an enrichment score, the bigger the bubble is, the more genes they contain. The color of bubbles changed from green to red, indicated the increasing of -log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 value), and the concentration indicated by the -log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 value) and the enrichment score.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showed the cell signal pathways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34435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9ED3AAB-9FEE-4A65-BD9E-68AA52B332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6465"/>
            <a:ext cx="5975202" cy="462350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79057BA-2460-4422-B1A1-560884D0A1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5202" y="629728"/>
            <a:ext cx="6128573" cy="471697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B4807FA-75DA-4748-BE62-B47E16AD376E}"/>
              </a:ext>
            </a:extLst>
          </p:cNvPr>
          <p:cNvSpPr txBox="1"/>
          <p:nvPr/>
        </p:nvSpPr>
        <p:spPr>
          <a:xfrm>
            <a:off x="379012" y="5647819"/>
            <a:ext cx="1143397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ontology classification and KEGG pathway enrichment of DMGs in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26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 GO classification,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is -log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 value), larger value represents a higher significance of the enrichment.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is GO terms, including biological process, cellular component, and molecular function. In KEGG pathway enrichment,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-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xis “rich factor” is an enrichment score, the bigger the bubble is, the more genes they contain. The color of bubbles changed from green to red, indicated the increasing of -log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 value), and the concentration indicated by the -log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 value) and the enrichment score.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showed the cell signal pathways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38521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596AB88-72C0-485F-80F6-ECE6EAE1BE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90110"/>
            <a:ext cx="6030305" cy="465789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9D82A39-5855-4C03-A789-986AD2238C7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0305" y="745722"/>
            <a:ext cx="6160722" cy="474666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3024D7A2-C55D-4528-A691-169108443461}"/>
              </a:ext>
            </a:extLst>
          </p:cNvPr>
          <p:cNvSpPr txBox="1"/>
          <p:nvPr/>
        </p:nvSpPr>
        <p:spPr>
          <a:xfrm>
            <a:off x="341906" y="5701085"/>
            <a:ext cx="1143397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ontology classification and KEGG pathway enrichment of DMGs in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108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 GO classification,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is -log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 value), larger value represents a higher significance of the enrichment.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is GO terms, including biological process, cellular component, and molecular function. In KEGG pathway enrichment,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-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xis “rich factor” is an enrichment score, the bigger the bubble is, the more genes they contain. The color of bubbles changed from green to red, indicated the increasing of -log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 value), and the concentration indicated by the -log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 value) and the enrichment score.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showed the cell signal pathways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3860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655</Words>
  <Application>Microsoft Office PowerPoint</Application>
  <PresentationFormat>宽屏</PresentationFormat>
  <Paragraphs>30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Arial</vt:lpstr>
      <vt:lpstr>Times New Roman</vt:lpstr>
      <vt:lpstr>Office 主题​​</vt:lpstr>
      <vt:lpstr>Supplementary Figures S1-S6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ou Jun</dc:creator>
  <cp:lastModifiedBy>Zhou Jun</cp:lastModifiedBy>
  <cp:revision>25</cp:revision>
  <dcterms:created xsi:type="dcterms:W3CDTF">2020-06-12T08:25:38Z</dcterms:created>
  <dcterms:modified xsi:type="dcterms:W3CDTF">2020-06-22T05:25:46Z</dcterms:modified>
</cp:coreProperties>
</file>